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365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1!$F$1</c:f>
              <c:strCache>
                <c:ptCount val="1"/>
                <c:pt idx="0">
                  <c:v>Microfluidized GLA-AF Lot #1</c:v>
                </c:pt>
              </c:strCache>
            </c:strRef>
          </c:tx>
          <c:spPr>
            <a:ln w="19050"/>
          </c:spPr>
          <c:marker>
            <c:symbol val="none"/>
          </c:marker>
          <c:xVal>
            <c:numRef>
              <c:f>Sheet1!$A$2:$A$394</c:f>
              <c:numCache>
                <c:formatCode>General</c:formatCode>
                <c:ptCount val="393"/>
                <c:pt idx="0">
                  <c:v>7.6610899999999997</c:v>
                </c:pt>
                <c:pt idx="1">
                  <c:v>7.7944199999999997</c:v>
                </c:pt>
                <c:pt idx="2">
                  <c:v>7.9281800000000002</c:v>
                </c:pt>
                <c:pt idx="3">
                  <c:v>8.0620200000000004</c:v>
                </c:pt>
                <c:pt idx="4">
                  <c:v>8.1950699999999994</c:v>
                </c:pt>
                <c:pt idx="5">
                  <c:v>8.3279800000000002</c:v>
                </c:pt>
                <c:pt idx="6">
                  <c:v>8.4612999999999996</c:v>
                </c:pt>
                <c:pt idx="7">
                  <c:v>8.5946899999999999</c:v>
                </c:pt>
                <c:pt idx="8">
                  <c:v>8.72898</c:v>
                </c:pt>
                <c:pt idx="9">
                  <c:v>8.8628300000000007</c:v>
                </c:pt>
                <c:pt idx="10">
                  <c:v>8.9957399999999996</c:v>
                </c:pt>
                <c:pt idx="11">
                  <c:v>9.1294500000000003</c:v>
                </c:pt>
                <c:pt idx="12">
                  <c:v>9.26342</c:v>
                </c:pt>
                <c:pt idx="13">
                  <c:v>9.3959799999999998</c:v>
                </c:pt>
                <c:pt idx="14">
                  <c:v>9.5299999999999994</c:v>
                </c:pt>
                <c:pt idx="15">
                  <c:v>9.6634600000000006</c:v>
                </c:pt>
                <c:pt idx="16">
                  <c:v>9.7977399999999992</c:v>
                </c:pt>
                <c:pt idx="17">
                  <c:v>9.9310799999999997</c:v>
                </c:pt>
                <c:pt idx="18">
                  <c:v>10.0641</c:v>
                </c:pt>
                <c:pt idx="19">
                  <c:v>10.197480000000001</c:v>
                </c:pt>
                <c:pt idx="20">
                  <c:v>10.33029</c:v>
                </c:pt>
                <c:pt idx="21">
                  <c:v>10.463100000000001</c:v>
                </c:pt>
                <c:pt idx="22">
                  <c:v>10.596769999999999</c:v>
                </c:pt>
                <c:pt idx="23">
                  <c:v>10.7296</c:v>
                </c:pt>
                <c:pt idx="24">
                  <c:v>10.861359999999999</c:v>
                </c:pt>
                <c:pt idx="25">
                  <c:v>10.994440000000001</c:v>
                </c:pt>
                <c:pt idx="26">
                  <c:v>11.127420000000001</c:v>
                </c:pt>
                <c:pt idx="27">
                  <c:v>11.261060000000001</c:v>
                </c:pt>
                <c:pt idx="28">
                  <c:v>11.39434</c:v>
                </c:pt>
                <c:pt idx="29">
                  <c:v>11.527659999999999</c:v>
                </c:pt>
                <c:pt idx="30">
                  <c:v>11.66004</c:v>
                </c:pt>
                <c:pt idx="31">
                  <c:v>11.79407</c:v>
                </c:pt>
                <c:pt idx="32">
                  <c:v>11.92831</c:v>
                </c:pt>
                <c:pt idx="33">
                  <c:v>12.061909999999999</c:v>
                </c:pt>
                <c:pt idx="34">
                  <c:v>12.19483</c:v>
                </c:pt>
                <c:pt idx="35">
                  <c:v>12.32816</c:v>
                </c:pt>
                <c:pt idx="36">
                  <c:v>12.461869999999999</c:v>
                </c:pt>
                <c:pt idx="37">
                  <c:v>12.59474</c:v>
                </c:pt>
                <c:pt idx="38">
                  <c:v>12.72813</c:v>
                </c:pt>
                <c:pt idx="39">
                  <c:v>12.86239</c:v>
                </c:pt>
                <c:pt idx="40">
                  <c:v>12.996219999999999</c:v>
                </c:pt>
                <c:pt idx="41">
                  <c:v>13.12875</c:v>
                </c:pt>
                <c:pt idx="42">
                  <c:v>13.261150000000001</c:v>
                </c:pt>
                <c:pt idx="43">
                  <c:v>13.396179999999999</c:v>
                </c:pt>
                <c:pt idx="44">
                  <c:v>13.52951</c:v>
                </c:pt>
                <c:pt idx="45">
                  <c:v>13.66248</c:v>
                </c:pt>
                <c:pt idx="46">
                  <c:v>13.797040000000001</c:v>
                </c:pt>
                <c:pt idx="47">
                  <c:v>13.929959999999999</c:v>
                </c:pt>
                <c:pt idx="48">
                  <c:v>14.063739999999999</c:v>
                </c:pt>
                <c:pt idx="49">
                  <c:v>14.197419999999999</c:v>
                </c:pt>
                <c:pt idx="50">
                  <c:v>14.330069999999999</c:v>
                </c:pt>
                <c:pt idx="51">
                  <c:v>14.463710000000001</c:v>
                </c:pt>
                <c:pt idx="52">
                  <c:v>14.59592</c:v>
                </c:pt>
                <c:pt idx="53">
                  <c:v>14.72569</c:v>
                </c:pt>
                <c:pt idx="54">
                  <c:v>14.85899</c:v>
                </c:pt>
                <c:pt idx="55">
                  <c:v>14.99072</c:v>
                </c:pt>
                <c:pt idx="56">
                  <c:v>15.12476</c:v>
                </c:pt>
                <c:pt idx="57">
                  <c:v>15.259180000000001</c:v>
                </c:pt>
                <c:pt idx="58">
                  <c:v>15.39245</c:v>
                </c:pt>
                <c:pt idx="59">
                  <c:v>15.5259</c:v>
                </c:pt>
                <c:pt idx="60">
                  <c:v>15.660069999999999</c:v>
                </c:pt>
                <c:pt idx="61">
                  <c:v>15.79339</c:v>
                </c:pt>
                <c:pt idx="62">
                  <c:v>15.925890000000001</c:v>
                </c:pt>
                <c:pt idx="63">
                  <c:v>16.059449999999998</c:v>
                </c:pt>
                <c:pt idx="64">
                  <c:v>16.19295</c:v>
                </c:pt>
                <c:pt idx="65">
                  <c:v>16.32657</c:v>
                </c:pt>
                <c:pt idx="66">
                  <c:v>16.46087</c:v>
                </c:pt>
                <c:pt idx="67">
                  <c:v>16.593990000000002</c:v>
                </c:pt>
                <c:pt idx="68">
                  <c:v>16.727270000000001</c:v>
                </c:pt>
                <c:pt idx="69">
                  <c:v>16.861149999999999</c:v>
                </c:pt>
                <c:pt idx="70">
                  <c:v>16.99465</c:v>
                </c:pt>
                <c:pt idx="71">
                  <c:v>17.126930000000002</c:v>
                </c:pt>
                <c:pt idx="72">
                  <c:v>17.260819999999999</c:v>
                </c:pt>
                <c:pt idx="73">
                  <c:v>17.394780000000001</c:v>
                </c:pt>
                <c:pt idx="74">
                  <c:v>17.52871</c:v>
                </c:pt>
                <c:pt idx="75">
                  <c:v>17.663740000000001</c:v>
                </c:pt>
                <c:pt idx="76">
                  <c:v>17.795480000000001</c:v>
                </c:pt>
                <c:pt idx="77">
                  <c:v>17.928370000000001</c:v>
                </c:pt>
                <c:pt idx="78">
                  <c:v>18.060700000000001</c:v>
                </c:pt>
                <c:pt idx="79">
                  <c:v>18.196020000000001</c:v>
                </c:pt>
                <c:pt idx="80">
                  <c:v>18.328579999999999</c:v>
                </c:pt>
                <c:pt idx="81">
                  <c:v>18.459879999999998</c:v>
                </c:pt>
                <c:pt idx="82">
                  <c:v>18.591989999999999</c:v>
                </c:pt>
                <c:pt idx="83">
                  <c:v>18.726469999999999</c:v>
                </c:pt>
                <c:pt idx="84">
                  <c:v>18.859529999999999</c:v>
                </c:pt>
                <c:pt idx="85">
                  <c:v>18.99193</c:v>
                </c:pt>
                <c:pt idx="86">
                  <c:v>19.125610000000002</c:v>
                </c:pt>
                <c:pt idx="87">
                  <c:v>19.25929</c:v>
                </c:pt>
                <c:pt idx="88">
                  <c:v>19.392389999999999</c:v>
                </c:pt>
                <c:pt idx="89">
                  <c:v>19.526540000000001</c:v>
                </c:pt>
                <c:pt idx="90">
                  <c:v>19.658989999999999</c:v>
                </c:pt>
                <c:pt idx="91">
                  <c:v>19.79243</c:v>
                </c:pt>
                <c:pt idx="92">
                  <c:v>19.92576</c:v>
                </c:pt>
                <c:pt idx="93">
                  <c:v>20.05932</c:v>
                </c:pt>
                <c:pt idx="94">
                  <c:v>20.19265</c:v>
                </c:pt>
                <c:pt idx="95">
                  <c:v>20.325199999999999</c:v>
                </c:pt>
                <c:pt idx="96">
                  <c:v>20.45909</c:v>
                </c:pt>
                <c:pt idx="97">
                  <c:v>20.59299</c:v>
                </c:pt>
                <c:pt idx="98">
                  <c:v>20.72635</c:v>
                </c:pt>
                <c:pt idx="99">
                  <c:v>20.859960000000001</c:v>
                </c:pt>
                <c:pt idx="100">
                  <c:v>20.993829999999999</c:v>
                </c:pt>
                <c:pt idx="101">
                  <c:v>21.126619999999999</c:v>
                </c:pt>
                <c:pt idx="102">
                  <c:v>21.260899999999999</c:v>
                </c:pt>
                <c:pt idx="103">
                  <c:v>21.394770000000001</c:v>
                </c:pt>
                <c:pt idx="104">
                  <c:v>21.52769</c:v>
                </c:pt>
                <c:pt idx="105">
                  <c:v>21.661290000000001</c:v>
                </c:pt>
                <c:pt idx="106">
                  <c:v>21.794360000000001</c:v>
                </c:pt>
                <c:pt idx="107">
                  <c:v>21.928180000000001</c:v>
                </c:pt>
                <c:pt idx="108">
                  <c:v>22.061260000000001</c:v>
                </c:pt>
                <c:pt idx="109">
                  <c:v>22.191469999999999</c:v>
                </c:pt>
                <c:pt idx="110">
                  <c:v>22.320640000000001</c:v>
                </c:pt>
                <c:pt idx="111">
                  <c:v>22.454719999999998</c:v>
                </c:pt>
                <c:pt idx="112">
                  <c:v>22.587669999999999</c:v>
                </c:pt>
                <c:pt idx="113">
                  <c:v>22.720600000000001</c:v>
                </c:pt>
                <c:pt idx="114">
                  <c:v>22.853860000000001</c:v>
                </c:pt>
                <c:pt idx="115">
                  <c:v>22.986440000000002</c:v>
                </c:pt>
                <c:pt idx="116">
                  <c:v>23.12058</c:v>
                </c:pt>
                <c:pt idx="117">
                  <c:v>23.254940000000001</c:v>
                </c:pt>
                <c:pt idx="118">
                  <c:v>23.389489999999999</c:v>
                </c:pt>
                <c:pt idx="119">
                  <c:v>23.522670000000002</c:v>
                </c:pt>
                <c:pt idx="120">
                  <c:v>23.656030000000001</c:v>
                </c:pt>
                <c:pt idx="121">
                  <c:v>23.787790000000001</c:v>
                </c:pt>
                <c:pt idx="122">
                  <c:v>23.92173</c:v>
                </c:pt>
                <c:pt idx="123">
                  <c:v>24.05518</c:v>
                </c:pt>
                <c:pt idx="124">
                  <c:v>24.18938</c:v>
                </c:pt>
                <c:pt idx="125">
                  <c:v>24.32283</c:v>
                </c:pt>
                <c:pt idx="126">
                  <c:v>24.45712</c:v>
                </c:pt>
                <c:pt idx="127">
                  <c:v>24.589400000000001</c:v>
                </c:pt>
                <c:pt idx="128">
                  <c:v>24.721360000000001</c:v>
                </c:pt>
                <c:pt idx="129">
                  <c:v>24.855039999999999</c:v>
                </c:pt>
                <c:pt idx="130">
                  <c:v>24.98884</c:v>
                </c:pt>
                <c:pt idx="131">
                  <c:v>25.121690000000001</c:v>
                </c:pt>
                <c:pt idx="132">
                  <c:v>25.25637</c:v>
                </c:pt>
                <c:pt idx="133">
                  <c:v>25.39021</c:v>
                </c:pt>
                <c:pt idx="134">
                  <c:v>25.523109999999999</c:v>
                </c:pt>
                <c:pt idx="135">
                  <c:v>25.655909999999999</c:v>
                </c:pt>
                <c:pt idx="136">
                  <c:v>25.788930000000001</c:v>
                </c:pt>
                <c:pt idx="137">
                  <c:v>25.92334</c:v>
                </c:pt>
                <c:pt idx="138">
                  <c:v>26.05452</c:v>
                </c:pt>
                <c:pt idx="139">
                  <c:v>26.185829999999999</c:v>
                </c:pt>
                <c:pt idx="140">
                  <c:v>26.320309999999999</c:v>
                </c:pt>
                <c:pt idx="141">
                  <c:v>26.45336</c:v>
                </c:pt>
                <c:pt idx="142">
                  <c:v>26.586790000000001</c:v>
                </c:pt>
                <c:pt idx="143">
                  <c:v>26.719899999999999</c:v>
                </c:pt>
                <c:pt idx="144">
                  <c:v>26.853819999999999</c:v>
                </c:pt>
                <c:pt idx="145">
                  <c:v>26.986499999999999</c:v>
                </c:pt>
                <c:pt idx="146">
                  <c:v>27.121220000000001</c:v>
                </c:pt>
                <c:pt idx="147">
                  <c:v>27.255179999999999</c:v>
                </c:pt>
                <c:pt idx="148">
                  <c:v>27.389220000000002</c:v>
                </c:pt>
                <c:pt idx="149">
                  <c:v>27.52272</c:v>
                </c:pt>
                <c:pt idx="150">
                  <c:v>27.65579</c:v>
                </c:pt>
                <c:pt idx="151">
                  <c:v>27.78838</c:v>
                </c:pt>
                <c:pt idx="152">
                  <c:v>27.921939999999999</c:v>
                </c:pt>
                <c:pt idx="153">
                  <c:v>28.055299999999999</c:v>
                </c:pt>
                <c:pt idx="154">
                  <c:v>28.18927</c:v>
                </c:pt>
                <c:pt idx="155">
                  <c:v>28.32255</c:v>
                </c:pt>
                <c:pt idx="156">
                  <c:v>28.457350000000002</c:v>
                </c:pt>
                <c:pt idx="157">
                  <c:v>28.5899</c:v>
                </c:pt>
                <c:pt idx="158">
                  <c:v>28.7224</c:v>
                </c:pt>
                <c:pt idx="159">
                  <c:v>28.856829999999999</c:v>
                </c:pt>
                <c:pt idx="160">
                  <c:v>28.989519999999999</c:v>
                </c:pt>
                <c:pt idx="161">
                  <c:v>29.122039999999998</c:v>
                </c:pt>
                <c:pt idx="162">
                  <c:v>29.2563</c:v>
                </c:pt>
                <c:pt idx="163">
                  <c:v>29.391159999999999</c:v>
                </c:pt>
                <c:pt idx="164">
                  <c:v>29.52478</c:v>
                </c:pt>
                <c:pt idx="165">
                  <c:v>29.65634</c:v>
                </c:pt>
                <c:pt idx="166">
                  <c:v>29.788869999999999</c:v>
                </c:pt>
                <c:pt idx="167">
                  <c:v>29.915369999999999</c:v>
                </c:pt>
                <c:pt idx="168">
                  <c:v>30.04833</c:v>
                </c:pt>
                <c:pt idx="169">
                  <c:v>30.181640000000002</c:v>
                </c:pt>
                <c:pt idx="170">
                  <c:v>30.313939999999999</c:v>
                </c:pt>
                <c:pt idx="171">
                  <c:v>30.447590000000002</c:v>
                </c:pt>
                <c:pt idx="172">
                  <c:v>30.580939999999998</c:v>
                </c:pt>
                <c:pt idx="173">
                  <c:v>30.714320000000001</c:v>
                </c:pt>
                <c:pt idx="174">
                  <c:v>30.847059999999999</c:v>
                </c:pt>
                <c:pt idx="175">
                  <c:v>30.981780000000001</c:v>
                </c:pt>
                <c:pt idx="176">
                  <c:v>31.115020000000001</c:v>
                </c:pt>
                <c:pt idx="177">
                  <c:v>31.248529999999999</c:v>
                </c:pt>
                <c:pt idx="178">
                  <c:v>31.382840000000002</c:v>
                </c:pt>
                <c:pt idx="179">
                  <c:v>31.515640000000001</c:v>
                </c:pt>
                <c:pt idx="180">
                  <c:v>31.64884</c:v>
                </c:pt>
                <c:pt idx="181">
                  <c:v>31.78172</c:v>
                </c:pt>
                <c:pt idx="182">
                  <c:v>31.917359999999999</c:v>
                </c:pt>
                <c:pt idx="183">
                  <c:v>32.048540000000003</c:v>
                </c:pt>
                <c:pt idx="184">
                  <c:v>32.181980000000003</c:v>
                </c:pt>
                <c:pt idx="185">
                  <c:v>32.316429999999997</c:v>
                </c:pt>
                <c:pt idx="186">
                  <c:v>32.44961</c:v>
                </c:pt>
                <c:pt idx="187">
                  <c:v>32.582369999999997</c:v>
                </c:pt>
                <c:pt idx="188">
                  <c:v>32.716009999999997</c:v>
                </c:pt>
                <c:pt idx="189">
                  <c:v>32.849240000000002</c:v>
                </c:pt>
                <c:pt idx="190">
                  <c:v>32.982439999999997</c:v>
                </c:pt>
                <c:pt idx="191">
                  <c:v>33.114980000000003</c:v>
                </c:pt>
                <c:pt idx="192">
                  <c:v>33.248730000000002</c:v>
                </c:pt>
                <c:pt idx="193">
                  <c:v>33.382390000000001</c:v>
                </c:pt>
                <c:pt idx="194">
                  <c:v>33.51567</c:v>
                </c:pt>
                <c:pt idx="195">
                  <c:v>33.646599999999999</c:v>
                </c:pt>
                <c:pt idx="196">
                  <c:v>33.777650000000001</c:v>
                </c:pt>
                <c:pt idx="197">
                  <c:v>33.91169</c:v>
                </c:pt>
                <c:pt idx="198">
                  <c:v>34.044379999999997</c:v>
                </c:pt>
                <c:pt idx="199">
                  <c:v>34.179299999999998</c:v>
                </c:pt>
                <c:pt idx="200">
                  <c:v>34.313870000000001</c:v>
                </c:pt>
                <c:pt idx="201">
                  <c:v>34.447580000000002</c:v>
                </c:pt>
                <c:pt idx="202">
                  <c:v>34.580329999999996</c:v>
                </c:pt>
                <c:pt idx="203">
                  <c:v>34.71358</c:v>
                </c:pt>
                <c:pt idx="204">
                  <c:v>34.846820000000001</c:v>
                </c:pt>
                <c:pt idx="205">
                  <c:v>34.978879999999997</c:v>
                </c:pt>
                <c:pt idx="206">
                  <c:v>35.113500000000002</c:v>
                </c:pt>
                <c:pt idx="207">
                  <c:v>35.247390000000003</c:v>
                </c:pt>
                <c:pt idx="208">
                  <c:v>35.379800000000003</c:v>
                </c:pt>
                <c:pt idx="209">
                  <c:v>35.513480000000001</c:v>
                </c:pt>
                <c:pt idx="210">
                  <c:v>35.647779999999997</c:v>
                </c:pt>
                <c:pt idx="211">
                  <c:v>35.780880000000003</c:v>
                </c:pt>
                <c:pt idx="212">
                  <c:v>35.915129999999998</c:v>
                </c:pt>
                <c:pt idx="213">
                  <c:v>36.048169999999999</c:v>
                </c:pt>
                <c:pt idx="214">
                  <c:v>36.181229999999999</c:v>
                </c:pt>
                <c:pt idx="215">
                  <c:v>36.314830000000001</c:v>
                </c:pt>
                <c:pt idx="216">
                  <c:v>36.449300000000001</c:v>
                </c:pt>
                <c:pt idx="217">
                  <c:v>36.582990000000002</c:v>
                </c:pt>
                <c:pt idx="218">
                  <c:v>36.715519999999998</c:v>
                </c:pt>
                <c:pt idx="219">
                  <c:v>36.84966</c:v>
                </c:pt>
                <c:pt idx="220">
                  <c:v>36.982860000000002</c:v>
                </c:pt>
                <c:pt idx="221">
                  <c:v>37.116770000000002</c:v>
                </c:pt>
                <c:pt idx="222">
                  <c:v>37.250010000000003</c:v>
                </c:pt>
                <c:pt idx="223">
                  <c:v>37.383299999999998</c:v>
                </c:pt>
                <c:pt idx="224">
                  <c:v>37.510719999999999</c:v>
                </c:pt>
                <c:pt idx="225">
                  <c:v>37.642420000000001</c:v>
                </c:pt>
                <c:pt idx="226">
                  <c:v>37.775410000000001</c:v>
                </c:pt>
                <c:pt idx="227">
                  <c:v>37.910130000000002</c:v>
                </c:pt>
                <c:pt idx="228">
                  <c:v>38.043340000000001</c:v>
                </c:pt>
                <c:pt idx="229">
                  <c:v>38.17633</c:v>
                </c:pt>
                <c:pt idx="230">
                  <c:v>38.310580000000002</c:v>
                </c:pt>
                <c:pt idx="231">
                  <c:v>38.4435</c:v>
                </c:pt>
                <c:pt idx="232">
                  <c:v>38.576999999999998</c:v>
                </c:pt>
                <c:pt idx="233">
                  <c:v>38.708979999999997</c:v>
                </c:pt>
                <c:pt idx="234">
                  <c:v>38.841929999999998</c:v>
                </c:pt>
                <c:pt idx="235">
                  <c:v>38.975290000000001</c:v>
                </c:pt>
                <c:pt idx="236">
                  <c:v>39.10951</c:v>
                </c:pt>
                <c:pt idx="237">
                  <c:v>39.242600000000003</c:v>
                </c:pt>
                <c:pt idx="238">
                  <c:v>39.377070000000003</c:v>
                </c:pt>
                <c:pt idx="239">
                  <c:v>39.509659999999997</c:v>
                </c:pt>
                <c:pt idx="240">
                  <c:v>39.642530000000001</c:v>
                </c:pt>
                <c:pt idx="241">
                  <c:v>39.776719999999997</c:v>
                </c:pt>
                <c:pt idx="242">
                  <c:v>39.911279999999998</c:v>
                </c:pt>
                <c:pt idx="243">
                  <c:v>40.044359999999998</c:v>
                </c:pt>
                <c:pt idx="244">
                  <c:v>40.17709</c:v>
                </c:pt>
                <c:pt idx="245">
                  <c:v>40.310130000000001</c:v>
                </c:pt>
                <c:pt idx="246">
                  <c:v>40.443199999999997</c:v>
                </c:pt>
                <c:pt idx="247">
                  <c:v>40.578429999999997</c:v>
                </c:pt>
                <c:pt idx="248">
                  <c:v>40.710810000000002</c:v>
                </c:pt>
                <c:pt idx="249">
                  <c:v>40.843899999999998</c:v>
                </c:pt>
                <c:pt idx="250">
                  <c:v>40.977400000000003</c:v>
                </c:pt>
                <c:pt idx="251">
                  <c:v>41.110999999999997</c:v>
                </c:pt>
                <c:pt idx="252">
                  <c:v>41.241930000000004</c:v>
                </c:pt>
                <c:pt idx="253">
                  <c:v>41.372929999999997</c:v>
                </c:pt>
                <c:pt idx="254">
                  <c:v>41.50712</c:v>
                </c:pt>
                <c:pt idx="255">
                  <c:v>41.642200000000003</c:v>
                </c:pt>
                <c:pt idx="256">
                  <c:v>41.774389999999997</c:v>
                </c:pt>
                <c:pt idx="257">
                  <c:v>41.908000000000001</c:v>
                </c:pt>
                <c:pt idx="258">
                  <c:v>42.042079999999999</c:v>
                </c:pt>
                <c:pt idx="259">
                  <c:v>42.173920000000003</c:v>
                </c:pt>
                <c:pt idx="260">
                  <c:v>42.306950000000001</c:v>
                </c:pt>
                <c:pt idx="261">
                  <c:v>42.44191</c:v>
                </c:pt>
                <c:pt idx="262">
                  <c:v>42.575130000000001</c:v>
                </c:pt>
                <c:pt idx="263">
                  <c:v>42.708179999999999</c:v>
                </c:pt>
                <c:pt idx="264">
                  <c:v>42.840719999999997</c:v>
                </c:pt>
                <c:pt idx="265">
                  <c:v>42.974229999999999</c:v>
                </c:pt>
                <c:pt idx="266">
                  <c:v>43.108269999999997</c:v>
                </c:pt>
                <c:pt idx="267">
                  <c:v>43.241439999999997</c:v>
                </c:pt>
                <c:pt idx="268">
                  <c:v>43.376240000000003</c:v>
                </c:pt>
                <c:pt idx="269">
                  <c:v>43.510350000000003</c:v>
                </c:pt>
                <c:pt idx="270">
                  <c:v>43.641970000000001</c:v>
                </c:pt>
                <c:pt idx="271">
                  <c:v>43.77581</c:v>
                </c:pt>
                <c:pt idx="272">
                  <c:v>43.909050000000001</c:v>
                </c:pt>
                <c:pt idx="273">
                  <c:v>44.042479999999998</c:v>
                </c:pt>
                <c:pt idx="274">
                  <c:v>44.17548</c:v>
                </c:pt>
                <c:pt idx="275">
                  <c:v>44.310279999999999</c:v>
                </c:pt>
                <c:pt idx="276">
                  <c:v>44.443040000000003</c:v>
                </c:pt>
                <c:pt idx="277">
                  <c:v>44.575319999999998</c:v>
                </c:pt>
                <c:pt idx="278">
                  <c:v>44.710059999999999</c:v>
                </c:pt>
                <c:pt idx="279">
                  <c:v>44.843089999999997</c:v>
                </c:pt>
                <c:pt idx="280">
                  <c:v>44.975499999999997</c:v>
                </c:pt>
                <c:pt idx="281">
                  <c:v>45.107779999999998</c:v>
                </c:pt>
                <c:pt idx="282">
                  <c:v>45.23762</c:v>
                </c:pt>
                <c:pt idx="283">
                  <c:v>45.371380000000002</c:v>
                </c:pt>
                <c:pt idx="284">
                  <c:v>45.505220000000001</c:v>
                </c:pt>
                <c:pt idx="285">
                  <c:v>45.638910000000003</c:v>
                </c:pt>
                <c:pt idx="286">
                  <c:v>45.77084</c:v>
                </c:pt>
                <c:pt idx="287">
                  <c:v>45.903359999999999</c:v>
                </c:pt>
                <c:pt idx="288">
                  <c:v>46.038670000000003</c:v>
                </c:pt>
                <c:pt idx="289">
                  <c:v>46.170560000000002</c:v>
                </c:pt>
                <c:pt idx="290">
                  <c:v>46.304250000000003</c:v>
                </c:pt>
                <c:pt idx="291">
                  <c:v>46.438029999999998</c:v>
                </c:pt>
                <c:pt idx="292">
                  <c:v>46.572139999999997</c:v>
                </c:pt>
                <c:pt idx="293">
                  <c:v>46.706130000000002</c:v>
                </c:pt>
                <c:pt idx="294">
                  <c:v>46.839500000000001</c:v>
                </c:pt>
                <c:pt idx="295">
                  <c:v>46.97184</c:v>
                </c:pt>
                <c:pt idx="296">
                  <c:v>47.105699999999999</c:v>
                </c:pt>
                <c:pt idx="297">
                  <c:v>47.239620000000002</c:v>
                </c:pt>
                <c:pt idx="298">
                  <c:v>47.372729999999997</c:v>
                </c:pt>
                <c:pt idx="299">
                  <c:v>47.50723</c:v>
                </c:pt>
                <c:pt idx="300">
                  <c:v>47.63908</c:v>
                </c:pt>
                <c:pt idx="301">
                  <c:v>47.772930000000002</c:v>
                </c:pt>
                <c:pt idx="302">
                  <c:v>47.90605</c:v>
                </c:pt>
                <c:pt idx="303">
                  <c:v>48.038809999999998</c:v>
                </c:pt>
                <c:pt idx="304">
                  <c:v>48.17304</c:v>
                </c:pt>
                <c:pt idx="305">
                  <c:v>48.305799999999998</c:v>
                </c:pt>
                <c:pt idx="306">
                  <c:v>48.439909999999998</c:v>
                </c:pt>
                <c:pt idx="307">
                  <c:v>48.572789999999998</c:v>
                </c:pt>
                <c:pt idx="308">
                  <c:v>48.707450000000001</c:v>
                </c:pt>
                <c:pt idx="309">
                  <c:v>48.84102</c:v>
                </c:pt>
                <c:pt idx="310">
                  <c:v>48.97343</c:v>
                </c:pt>
                <c:pt idx="311">
                  <c:v>49.104700000000001</c:v>
                </c:pt>
                <c:pt idx="312">
                  <c:v>49.236800000000002</c:v>
                </c:pt>
                <c:pt idx="313">
                  <c:v>49.370629999999998</c:v>
                </c:pt>
                <c:pt idx="314">
                  <c:v>49.503660000000004</c:v>
                </c:pt>
                <c:pt idx="315">
                  <c:v>49.636029999999998</c:v>
                </c:pt>
                <c:pt idx="316">
                  <c:v>49.7712</c:v>
                </c:pt>
                <c:pt idx="317">
                  <c:v>49.904710000000001</c:v>
                </c:pt>
                <c:pt idx="318">
                  <c:v>50.036909999999999</c:v>
                </c:pt>
                <c:pt idx="319">
                  <c:v>50.170780000000001</c:v>
                </c:pt>
                <c:pt idx="320">
                  <c:v>50.305239999999998</c:v>
                </c:pt>
                <c:pt idx="321">
                  <c:v>50.437220000000003</c:v>
                </c:pt>
                <c:pt idx="322">
                  <c:v>50.570990000000002</c:v>
                </c:pt>
                <c:pt idx="323">
                  <c:v>50.70429</c:v>
                </c:pt>
                <c:pt idx="324">
                  <c:v>50.838230000000003</c:v>
                </c:pt>
                <c:pt idx="325">
                  <c:v>50.97137</c:v>
                </c:pt>
                <c:pt idx="326">
                  <c:v>51.105339999999998</c:v>
                </c:pt>
                <c:pt idx="327">
                  <c:v>51.238079999999997</c:v>
                </c:pt>
                <c:pt idx="328">
                  <c:v>51.371079999999999</c:v>
                </c:pt>
                <c:pt idx="329">
                  <c:v>51.504219999999997</c:v>
                </c:pt>
                <c:pt idx="330">
                  <c:v>51.637140000000002</c:v>
                </c:pt>
                <c:pt idx="331">
                  <c:v>51.770310000000002</c:v>
                </c:pt>
                <c:pt idx="332">
                  <c:v>51.90372</c:v>
                </c:pt>
                <c:pt idx="333">
                  <c:v>52.03745</c:v>
                </c:pt>
                <c:pt idx="334">
                  <c:v>52.17154</c:v>
                </c:pt>
                <c:pt idx="335">
                  <c:v>52.304499999999997</c:v>
                </c:pt>
                <c:pt idx="336">
                  <c:v>52.438809999999997</c:v>
                </c:pt>
                <c:pt idx="337">
                  <c:v>52.572380000000003</c:v>
                </c:pt>
                <c:pt idx="338">
                  <c:v>52.705219999999997</c:v>
                </c:pt>
                <c:pt idx="339">
                  <c:v>52.835790000000003</c:v>
                </c:pt>
                <c:pt idx="340">
                  <c:v>52.96631</c:v>
                </c:pt>
                <c:pt idx="341">
                  <c:v>53.09881</c:v>
                </c:pt>
                <c:pt idx="342">
                  <c:v>53.231670000000001</c:v>
                </c:pt>
                <c:pt idx="343">
                  <c:v>53.36739</c:v>
                </c:pt>
                <c:pt idx="344">
                  <c:v>53.49944</c:v>
                </c:pt>
                <c:pt idx="345">
                  <c:v>53.633949999999999</c:v>
                </c:pt>
                <c:pt idx="346">
                  <c:v>53.766570000000002</c:v>
                </c:pt>
                <c:pt idx="347">
                  <c:v>53.898260000000001</c:v>
                </c:pt>
                <c:pt idx="348">
                  <c:v>54.031019999999998</c:v>
                </c:pt>
                <c:pt idx="349">
                  <c:v>54.165559999999999</c:v>
                </c:pt>
                <c:pt idx="350">
                  <c:v>54.299169999999997</c:v>
                </c:pt>
                <c:pt idx="351">
                  <c:v>54.431710000000002</c:v>
                </c:pt>
                <c:pt idx="352">
                  <c:v>54.564869999999999</c:v>
                </c:pt>
                <c:pt idx="353">
                  <c:v>54.698399999999999</c:v>
                </c:pt>
                <c:pt idx="354">
                  <c:v>54.831940000000003</c:v>
                </c:pt>
                <c:pt idx="355">
                  <c:v>54.96611</c:v>
                </c:pt>
                <c:pt idx="356">
                  <c:v>55.099600000000002</c:v>
                </c:pt>
                <c:pt idx="357">
                  <c:v>55.232300000000002</c:v>
                </c:pt>
                <c:pt idx="358">
                  <c:v>55.365310000000001</c:v>
                </c:pt>
                <c:pt idx="359">
                  <c:v>55.498309999999996</c:v>
                </c:pt>
                <c:pt idx="360">
                  <c:v>55.631030000000003</c:v>
                </c:pt>
                <c:pt idx="361">
                  <c:v>55.765039999999999</c:v>
                </c:pt>
                <c:pt idx="362">
                  <c:v>55.898919999999997</c:v>
                </c:pt>
                <c:pt idx="363">
                  <c:v>56.031750000000002</c:v>
                </c:pt>
                <c:pt idx="364">
                  <c:v>56.165999999999997</c:v>
                </c:pt>
                <c:pt idx="365">
                  <c:v>56.299120000000002</c:v>
                </c:pt>
                <c:pt idx="366">
                  <c:v>56.431809999999999</c:v>
                </c:pt>
                <c:pt idx="367">
                  <c:v>56.566450000000003</c:v>
                </c:pt>
                <c:pt idx="368">
                  <c:v>56.697690000000001</c:v>
                </c:pt>
                <c:pt idx="369">
                  <c:v>56.830930000000002</c:v>
                </c:pt>
                <c:pt idx="370">
                  <c:v>56.963659999999997</c:v>
                </c:pt>
                <c:pt idx="371">
                  <c:v>57.0974</c:v>
                </c:pt>
                <c:pt idx="372">
                  <c:v>57.230730000000001</c:v>
                </c:pt>
                <c:pt idx="373">
                  <c:v>57.364260000000002</c:v>
                </c:pt>
                <c:pt idx="374">
                  <c:v>57.49774</c:v>
                </c:pt>
                <c:pt idx="375">
                  <c:v>57.630189999999999</c:v>
                </c:pt>
                <c:pt idx="376">
                  <c:v>57.762779999999999</c:v>
                </c:pt>
                <c:pt idx="377">
                  <c:v>57.89564</c:v>
                </c:pt>
                <c:pt idx="378">
                  <c:v>58.029670000000003</c:v>
                </c:pt>
                <c:pt idx="379">
                  <c:v>58.16234</c:v>
                </c:pt>
                <c:pt idx="380">
                  <c:v>58.294339999999998</c:v>
                </c:pt>
                <c:pt idx="381">
                  <c:v>58.428959999999996</c:v>
                </c:pt>
                <c:pt idx="382">
                  <c:v>58.561669999999999</c:v>
                </c:pt>
                <c:pt idx="383">
                  <c:v>58.695700000000002</c:v>
                </c:pt>
                <c:pt idx="384">
                  <c:v>58.830869999999997</c:v>
                </c:pt>
                <c:pt idx="385">
                  <c:v>58.963230000000003</c:v>
                </c:pt>
                <c:pt idx="386">
                  <c:v>59.095849999999999</c:v>
                </c:pt>
                <c:pt idx="387">
                  <c:v>59.229750000000003</c:v>
                </c:pt>
                <c:pt idx="388">
                  <c:v>59.362540000000003</c:v>
                </c:pt>
                <c:pt idx="389">
                  <c:v>59.496220000000001</c:v>
                </c:pt>
                <c:pt idx="390">
                  <c:v>59.628959999999999</c:v>
                </c:pt>
                <c:pt idx="391">
                  <c:v>59.762250000000002</c:v>
                </c:pt>
              </c:numCache>
            </c:numRef>
          </c:xVal>
          <c:yVal>
            <c:numRef>
              <c:f>Sheet1!$F$2:$F$394</c:f>
              <c:numCache>
                <c:formatCode>General</c:formatCode>
                <c:ptCount val="393"/>
                <c:pt idx="14" formatCode="0.00E+00">
                  <c:v>2.76276E-3</c:v>
                </c:pt>
                <c:pt idx="15" formatCode="0.00E+00">
                  <c:v>1.37447E-3</c:v>
                </c:pt>
                <c:pt idx="16" formatCode="0.00E+00">
                  <c:v>1.28578E-3</c:v>
                </c:pt>
                <c:pt idx="17" formatCode="0.00E+00">
                  <c:v>3.7290000000000001E-3</c:v>
                </c:pt>
                <c:pt idx="18" formatCode="0.00E+00">
                  <c:v>3.99548E-3</c:v>
                </c:pt>
                <c:pt idx="19" formatCode="0.00E+00">
                  <c:v>1.5053299999999998E-3</c:v>
                </c:pt>
                <c:pt idx="20" formatCode="0.00E+00">
                  <c:v>2.7474599999999997E-3</c:v>
                </c:pt>
                <c:pt idx="21" formatCode="0.00E+00">
                  <c:v>2.2929199999999999E-3</c:v>
                </c:pt>
                <c:pt idx="22" formatCode="0.00E+00">
                  <c:v>2.4200900000000002E-3</c:v>
                </c:pt>
                <c:pt idx="23" formatCode="0.00E+00">
                  <c:v>3.7298100000000001E-3</c:v>
                </c:pt>
                <c:pt idx="24" formatCode="0.00E+00">
                  <c:v>2.9722500000000001E-3</c:v>
                </c:pt>
                <c:pt idx="25" formatCode="0.00E+00">
                  <c:v>4.9392299999999995E-4</c:v>
                </c:pt>
                <c:pt idx="26" formatCode="0.00E+00">
                  <c:v>-2.5071099999999999E-3</c:v>
                </c:pt>
                <c:pt idx="27" formatCode="0.00E+00">
                  <c:v>-1.72977E-3</c:v>
                </c:pt>
                <c:pt idx="28" formatCode="0.00E+00">
                  <c:v>-2.5036900000000003E-3</c:v>
                </c:pt>
                <c:pt idx="29" formatCode="0.00E+00">
                  <c:v>-3.7940500000000002E-3</c:v>
                </c:pt>
                <c:pt idx="30" formatCode="0.00E+00">
                  <c:v>-2.3343600000000002E-3</c:v>
                </c:pt>
                <c:pt idx="31" formatCode="0.00E+00">
                  <c:v>-2.6896100000000003E-3</c:v>
                </c:pt>
                <c:pt idx="32" formatCode="0.00E+00">
                  <c:v>-3.6367500000000002E-3</c:v>
                </c:pt>
                <c:pt idx="33" formatCode="0.00E+00">
                  <c:v>-2.5724699999999999E-3</c:v>
                </c:pt>
                <c:pt idx="34" formatCode="0.00E+00">
                  <c:v>-2.5547499999999997E-3</c:v>
                </c:pt>
                <c:pt idx="35" formatCode="0.00E+00">
                  <c:v>-4.38734E-3</c:v>
                </c:pt>
                <c:pt idx="36" formatCode="0.00E+00">
                  <c:v>-2.6797700000000002E-3</c:v>
                </c:pt>
                <c:pt idx="37" formatCode="0.00E+00">
                  <c:v>-2.5255500000000001E-3</c:v>
                </c:pt>
                <c:pt idx="38" formatCode="0.00E+00">
                  <c:v>-3.2886E-3</c:v>
                </c:pt>
                <c:pt idx="39" formatCode="0.00E+00">
                  <c:v>-1.1147399999999999E-3</c:v>
                </c:pt>
                <c:pt idx="40" formatCode="0.00E+00">
                  <c:v>-8.6096900000000006E-4</c:v>
                </c:pt>
                <c:pt idx="41" formatCode="0.00E+00">
                  <c:v>-2.1412699999999998E-3</c:v>
                </c:pt>
                <c:pt idx="42" formatCode="0.00E+00">
                  <c:v>-3.2059100000000002E-3</c:v>
                </c:pt>
                <c:pt idx="43" formatCode="0.00E+00">
                  <c:v>-3.2262099999999998E-3</c:v>
                </c:pt>
                <c:pt idx="44" formatCode="0.00E+00">
                  <c:v>-2.2670799999999999E-3</c:v>
                </c:pt>
                <c:pt idx="45" formatCode="0.00E+00">
                  <c:v>-1.9665899999999998E-3</c:v>
                </c:pt>
                <c:pt idx="46" formatCode="0.00E+00">
                  <c:v>-1.5033099999999999E-3</c:v>
                </c:pt>
                <c:pt idx="47" formatCode="0.00E+00">
                  <c:v>-1.9877499999999999E-3</c:v>
                </c:pt>
                <c:pt idx="48" formatCode="0.00E+00">
                  <c:v>4.51963E-4</c:v>
                </c:pt>
                <c:pt idx="49" formatCode="0.00E+00">
                  <c:v>1.4784100000000001E-3</c:v>
                </c:pt>
                <c:pt idx="50" formatCode="0.00E+00">
                  <c:v>2.0191599999999999E-3</c:v>
                </c:pt>
                <c:pt idx="51" formatCode="0.00E+00">
                  <c:v>5.4598600000000004E-4</c:v>
                </c:pt>
                <c:pt idx="52" formatCode="0.00E+00">
                  <c:v>8.4597999999999997E-4</c:v>
                </c:pt>
                <c:pt idx="53" formatCode="0.00E+00">
                  <c:v>1.5204800000000001E-3</c:v>
                </c:pt>
                <c:pt idx="54" formatCode="0.00E+00">
                  <c:v>2.11977E-3</c:v>
                </c:pt>
                <c:pt idx="55" formatCode="0.00E+00">
                  <c:v>3.01907E-3</c:v>
                </c:pt>
                <c:pt idx="56" formatCode="0.00E+00">
                  <c:v>4.1674499999999996E-3</c:v>
                </c:pt>
                <c:pt idx="57" formatCode="0.00E+00">
                  <c:v>4.5853500000000002E-3</c:v>
                </c:pt>
                <c:pt idx="58" formatCode="0.00E+00">
                  <c:v>5.5860899999999993E-3</c:v>
                </c:pt>
                <c:pt idx="59" formatCode="0.00E+00">
                  <c:v>6.8516699999999998E-3</c:v>
                </c:pt>
                <c:pt idx="60" formatCode="0.00E+00">
                  <c:v>7.7697199999999999E-3</c:v>
                </c:pt>
                <c:pt idx="61" formatCode="0.00E+00">
                  <c:v>8.4822700000000001E-3</c:v>
                </c:pt>
                <c:pt idx="62" formatCode="0.00E+00">
                  <c:v>9.886289999999999E-3</c:v>
                </c:pt>
                <c:pt idx="63" formatCode="0.00E+00">
                  <c:v>1.0519199999999999E-2</c:v>
                </c:pt>
                <c:pt idx="64" formatCode="0.00E+00">
                  <c:v>1.0568299999999999E-2</c:v>
                </c:pt>
                <c:pt idx="65" formatCode="0.00E+00">
                  <c:v>1.4138399999999999E-2</c:v>
                </c:pt>
                <c:pt idx="66" formatCode="0.00E+00">
                  <c:v>1.5566499999999999E-2</c:v>
                </c:pt>
                <c:pt idx="67" formatCode="0.00E+00">
                  <c:v>1.5109800000000001E-2</c:v>
                </c:pt>
                <c:pt idx="68" formatCode="0.00E+00">
                  <c:v>1.5632400000000001E-2</c:v>
                </c:pt>
                <c:pt idx="69" formatCode="0.00E+00">
                  <c:v>1.7868200000000001E-2</c:v>
                </c:pt>
                <c:pt idx="70" formatCode="0.00E+00">
                  <c:v>1.6559300000000002E-2</c:v>
                </c:pt>
                <c:pt idx="71" formatCode="0.00E+00">
                  <c:v>1.8218399999999999E-2</c:v>
                </c:pt>
                <c:pt idx="72" formatCode="0.00E+00">
                  <c:v>2.0614299999999999E-2</c:v>
                </c:pt>
                <c:pt idx="73" formatCode="0.00E+00">
                  <c:v>2.0427799999999999E-2</c:v>
                </c:pt>
                <c:pt idx="74" formatCode="0.00E+00">
                  <c:v>2.04523E-2</c:v>
                </c:pt>
                <c:pt idx="75" formatCode="0.00E+00">
                  <c:v>2.25577E-2</c:v>
                </c:pt>
                <c:pt idx="76" formatCode="0.00E+00">
                  <c:v>2.2345500000000001E-2</c:v>
                </c:pt>
                <c:pt idx="77" formatCode="0.00E+00">
                  <c:v>2.2091699999999999E-2</c:v>
                </c:pt>
                <c:pt idx="78" formatCode="0.00E+00">
                  <c:v>2.23842E-2</c:v>
                </c:pt>
                <c:pt idx="79" formatCode="0.00E+00">
                  <c:v>2.5975600000000001E-2</c:v>
                </c:pt>
                <c:pt idx="80" formatCode="0.00E+00">
                  <c:v>2.6388000000000002E-2</c:v>
                </c:pt>
                <c:pt idx="81" formatCode="0.00E+00">
                  <c:v>2.6309800000000001E-2</c:v>
                </c:pt>
                <c:pt idx="82" formatCode="0.00E+00">
                  <c:v>2.9609400000000001E-2</c:v>
                </c:pt>
                <c:pt idx="83" formatCode="0.00E+00">
                  <c:v>3.1328399999999999E-2</c:v>
                </c:pt>
                <c:pt idx="84" formatCode="0.00E+00">
                  <c:v>2.9434999999999999E-2</c:v>
                </c:pt>
                <c:pt idx="85" formatCode="0.00E+00">
                  <c:v>3.0884700000000001E-2</c:v>
                </c:pt>
                <c:pt idx="86" formatCode="0.00E+00">
                  <c:v>3.3824199999999999E-2</c:v>
                </c:pt>
                <c:pt idx="87" formatCode="0.00E+00">
                  <c:v>3.3192899999999997E-2</c:v>
                </c:pt>
                <c:pt idx="88" formatCode="0.00E+00">
                  <c:v>3.3570499999999996E-2</c:v>
                </c:pt>
                <c:pt idx="89" formatCode="0.00E+00">
                  <c:v>3.5136600000000004E-2</c:v>
                </c:pt>
                <c:pt idx="90" formatCode="0.00E+00">
                  <c:v>3.4327300000000005E-2</c:v>
                </c:pt>
                <c:pt idx="91" formatCode="0.00E+00">
                  <c:v>3.6465400000000002E-2</c:v>
                </c:pt>
                <c:pt idx="92" formatCode="0.00E+00">
                  <c:v>3.6599699999999999E-2</c:v>
                </c:pt>
                <c:pt idx="93" formatCode="0.00E+00">
                  <c:v>3.4943200000000001E-2</c:v>
                </c:pt>
                <c:pt idx="94" formatCode="0.00E+00">
                  <c:v>3.4274800000000001E-2</c:v>
                </c:pt>
                <c:pt idx="95" formatCode="0.00E+00">
                  <c:v>3.4205300000000001E-2</c:v>
                </c:pt>
                <c:pt idx="96" formatCode="0.00E+00">
                  <c:v>3.5802E-2</c:v>
                </c:pt>
                <c:pt idx="97" formatCode="0.00E+00">
                  <c:v>3.2846599999999997E-2</c:v>
                </c:pt>
                <c:pt idx="98" formatCode="0.00E+00">
                  <c:v>3.2258599999999998E-2</c:v>
                </c:pt>
                <c:pt idx="99" formatCode="0.00E+00">
                  <c:v>3.3278499999999996E-2</c:v>
                </c:pt>
                <c:pt idx="100" formatCode="0.00E+00">
                  <c:v>3.1997600000000001E-2</c:v>
                </c:pt>
                <c:pt idx="101" formatCode="0.00E+00">
                  <c:v>3.1846399999999997E-2</c:v>
                </c:pt>
                <c:pt idx="102" formatCode="0.00E+00">
                  <c:v>3.32806E-2</c:v>
                </c:pt>
                <c:pt idx="103" formatCode="0.00E+00">
                  <c:v>3.5162699999999998E-2</c:v>
                </c:pt>
                <c:pt idx="104" formatCode="0.00E+00">
                  <c:v>3.8156999999999996E-2</c:v>
                </c:pt>
                <c:pt idx="105" formatCode="0.00E+00">
                  <c:v>3.86279E-2</c:v>
                </c:pt>
                <c:pt idx="106" formatCode="0.00E+00">
                  <c:v>3.9581899999999996E-2</c:v>
                </c:pt>
                <c:pt idx="107" formatCode="0.00E+00">
                  <c:v>4.2108600000000003E-2</c:v>
                </c:pt>
                <c:pt idx="108" formatCode="0.00E+00">
                  <c:v>4.1569199999999994E-2</c:v>
                </c:pt>
                <c:pt idx="109" formatCode="0.00E+00">
                  <c:v>3.9387199999999997E-2</c:v>
                </c:pt>
                <c:pt idx="110" formatCode="0.00E+00">
                  <c:v>3.4501299999999999E-2</c:v>
                </c:pt>
                <c:pt idx="111" formatCode="0.00E+00">
                  <c:v>3.2390299999999997E-2</c:v>
                </c:pt>
                <c:pt idx="112" formatCode="0.00E+00">
                  <c:v>3.4121600000000002E-2</c:v>
                </c:pt>
                <c:pt idx="113" formatCode="0.00E+00">
                  <c:v>3.7804299999999999E-2</c:v>
                </c:pt>
                <c:pt idx="114" formatCode="0.00E+00">
                  <c:v>3.9021199999999999E-2</c:v>
                </c:pt>
                <c:pt idx="115" formatCode="0.00E+00">
                  <c:v>4.0775100000000002E-2</c:v>
                </c:pt>
                <c:pt idx="116" formatCode="0.00E+00">
                  <c:v>4.3010699999999999E-2</c:v>
                </c:pt>
                <c:pt idx="117" formatCode="0.00E+00">
                  <c:v>4.4176599999999996E-2</c:v>
                </c:pt>
                <c:pt idx="118" formatCode="0.00E+00">
                  <c:v>4.7134599999999999E-2</c:v>
                </c:pt>
                <c:pt idx="119" formatCode="0.00E+00">
                  <c:v>4.8806799999999997E-2</c:v>
                </c:pt>
                <c:pt idx="120" formatCode="0.00E+00">
                  <c:v>4.9341500000000003E-2</c:v>
                </c:pt>
                <c:pt idx="121" formatCode="0.00E+00">
                  <c:v>5.2658400000000001E-2</c:v>
                </c:pt>
                <c:pt idx="122" formatCode="0.00E+00">
                  <c:v>5.3828399999999998E-2</c:v>
                </c:pt>
                <c:pt idx="123" formatCode="0.00E+00">
                  <c:v>5.2608700000000001E-2</c:v>
                </c:pt>
                <c:pt idx="124" formatCode="0.00E+00">
                  <c:v>5.1726399999999999E-2</c:v>
                </c:pt>
                <c:pt idx="125" formatCode="0.00E+00">
                  <c:v>5.3527600000000002E-2</c:v>
                </c:pt>
                <c:pt idx="126" formatCode="0.00E+00">
                  <c:v>5.7167200000000001E-2</c:v>
                </c:pt>
                <c:pt idx="127" formatCode="0.00E+00">
                  <c:v>5.7863699999999997E-2</c:v>
                </c:pt>
                <c:pt idx="128" formatCode="0.00E+00">
                  <c:v>5.7619999999999998E-2</c:v>
                </c:pt>
                <c:pt idx="129" formatCode="0.00E+00">
                  <c:v>6.1139900000000004E-2</c:v>
                </c:pt>
                <c:pt idx="130" formatCode="0.00E+00">
                  <c:v>6.1380299999999999E-2</c:v>
                </c:pt>
                <c:pt idx="131" formatCode="0.00E+00">
                  <c:v>6.0945800000000001E-2</c:v>
                </c:pt>
                <c:pt idx="132" formatCode="0.00E+00">
                  <c:v>6.5686300000000003E-2</c:v>
                </c:pt>
                <c:pt idx="133" formatCode="0.00E+00">
                  <c:v>6.5724699999999997E-2</c:v>
                </c:pt>
                <c:pt idx="134" formatCode="0.00E+00">
                  <c:v>5.87588E-2</c:v>
                </c:pt>
                <c:pt idx="135" formatCode="0.00E+00">
                  <c:v>6.1946500000000002E-2</c:v>
                </c:pt>
                <c:pt idx="136" formatCode="0.00E+00">
                  <c:v>6.4752500000000004E-2</c:v>
                </c:pt>
                <c:pt idx="137" formatCode="0.00E+00">
                  <c:v>6.2745999999999996E-2</c:v>
                </c:pt>
                <c:pt idx="138" formatCode="0.00E+00">
                  <c:v>6.1054199999999996E-2</c:v>
                </c:pt>
                <c:pt idx="139" formatCode="0.00E+00">
                  <c:v>6.6023200000000004E-2</c:v>
                </c:pt>
                <c:pt idx="140" formatCode="0.00E+00">
                  <c:v>7.0144999999999999E-2</c:v>
                </c:pt>
                <c:pt idx="141" formatCode="0.00E+00">
                  <c:v>7.2077599999999992E-2</c:v>
                </c:pt>
                <c:pt idx="142" formatCode="0.00E+00">
                  <c:v>7.8946599999999992E-2</c:v>
                </c:pt>
                <c:pt idx="143" formatCode="0.00E+00">
                  <c:v>8.1388299999999997E-2</c:v>
                </c:pt>
                <c:pt idx="144" formatCode="0.00E+00">
                  <c:v>8.3819599999999994E-2</c:v>
                </c:pt>
                <c:pt idx="145" formatCode="0.00E+00">
                  <c:v>8.5807400000000006E-2</c:v>
                </c:pt>
                <c:pt idx="146" formatCode="0.00E+00">
                  <c:v>8.8774599999999995E-2</c:v>
                </c:pt>
                <c:pt idx="147" formatCode="0.00E+00">
                  <c:v>9.02646E-2</c:v>
                </c:pt>
                <c:pt idx="148" formatCode="0.00E+00">
                  <c:v>9.2572699999999994E-2</c:v>
                </c:pt>
                <c:pt idx="149" formatCode="0.00E+00">
                  <c:v>9.3399999999999997E-2</c:v>
                </c:pt>
                <c:pt idx="150" formatCode="0.00E+00">
                  <c:v>9.4211099999999992E-2</c:v>
                </c:pt>
                <c:pt idx="151" formatCode="0.00E+00">
                  <c:v>9.5211999999999991E-2</c:v>
                </c:pt>
                <c:pt idx="152" formatCode="0.00E+00">
                  <c:v>9.7300499999999998E-2</c:v>
                </c:pt>
                <c:pt idx="153" formatCode="0.00E+00">
                  <c:v>9.6837599999999996E-2</c:v>
                </c:pt>
                <c:pt idx="154" formatCode="0.00E+00">
                  <c:v>9.81823E-2</c:v>
                </c:pt>
                <c:pt idx="155" formatCode="0.00E+00">
                  <c:v>0.10110400000000001</c:v>
                </c:pt>
                <c:pt idx="156" formatCode="0.00E+00">
                  <c:v>0.10265299999999999</c:v>
                </c:pt>
                <c:pt idx="157" formatCode="0.00E+00">
                  <c:v>0.10338499999999999</c:v>
                </c:pt>
                <c:pt idx="158" formatCode="0.00E+00">
                  <c:v>0.105311</c:v>
                </c:pt>
                <c:pt idx="159" formatCode="0.00E+00">
                  <c:v>0.104212</c:v>
                </c:pt>
                <c:pt idx="160" formatCode="0.00E+00">
                  <c:v>0.103883</c:v>
                </c:pt>
                <c:pt idx="161" formatCode="0.00E+00">
                  <c:v>0.10732599999999999</c:v>
                </c:pt>
                <c:pt idx="162" formatCode="0.00E+00">
                  <c:v>0.111919</c:v>
                </c:pt>
                <c:pt idx="163" formatCode="0.00E+00">
                  <c:v>0.11246200000000001</c:v>
                </c:pt>
                <c:pt idx="164" formatCode="0.00E+00">
                  <c:v>0.111044</c:v>
                </c:pt>
                <c:pt idx="165" formatCode="0.00E+00">
                  <c:v>0.11107</c:v>
                </c:pt>
                <c:pt idx="166" formatCode="0.00E+00">
                  <c:v>0.10900199999999999</c:v>
                </c:pt>
                <c:pt idx="167" formatCode="0.00E+00">
                  <c:v>0.10485199999999999</c:v>
                </c:pt>
                <c:pt idx="168" formatCode="0.00E+00">
                  <c:v>0.10338900000000001</c:v>
                </c:pt>
                <c:pt idx="169" formatCode="0.00E+00">
                  <c:v>0.10469600000000001</c:v>
                </c:pt>
                <c:pt idx="170" formatCode="0.00E+00">
                  <c:v>0.10540000000000001</c:v>
                </c:pt>
                <c:pt idx="171" formatCode="0.00E+00">
                  <c:v>0.106465</c:v>
                </c:pt>
                <c:pt idx="172" formatCode="0.00E+00">
                  <c:v>0.105938</c:v>
                </c:pt>
                <c:pt idx="173" formatCode="0.00E+00">
                  <c:v>0.10807499999999999</c:v>
                </c:pt>
                <c:pt idx="174" formatCode="0.00E+00">
                  <c:v>0.107545</c:v>
                </c:pt>
                <c:pt idx="175" formatCode="0.00E+00">
                  <c:v>0.107497</c:v>
                </c:pt>
                <c:pt idx="176" formatCode="0.00E+00">
                  <c:v>0.107515</c:v>
                </c:pt>
                <c:pt idx="177" formatCode="0.00E+00">
                  <c:v>0.109746</c:v>
                </c:pt>
                <c:pt idx="178" formatCode="0.00E+00">
                  <c:v>0.11232399999999999</c:v>
                </c:pt>
                <c:pt idx="179" formatCode="0.00E+00">
                  <c:v>0.11189600000000001</c:v>
                </c:pt>
                <c:pt idx="180" formatCode="0.00E+00">
                  <c:v>0.112612</c:v>
                </c:pt>
                <c:pt idx="181" formatCode="0.00E+00">
                  <c:v>0.114855</c:v>
                </c:pt>
                <c:pt idx="182" formatCode="0.00E+00">
                  <c:v>0.116979</c:v>
                </c:pt>
                <c:pt idx="183" formatCode="0.00E+00">
                  <c:v>0.11911300000000001</c:v>
                </c:pt>
                <c:pt idx="184" formatCode="0.00E+00">
                  <c:v>0.119849</c:v>
                </c:pt>
                <c:pt idx="185" formatCode="0.00E+00">
                  <c:v>0.12222999999999999</c:v>
                </c:pt>
                <c:pt idx="186" formatCode="0.00E+00">
                  <c:v>0.123001</c:v>
                </c:pt>
                <c:pt idx="187" formatCode="0.00E+00">
                  <c:v>0.12690299999999999</c:v>
                </c:pt>
                <c:pt idx="188" formatCode="0.00E+00">
                  <c:v>0.12707100000000002</c:v>
                </c:pt>
                <c:pt idx="189" formatCode="0.00E+00">
                  <c:v>0.129159</c:v>
                </c:pt>
                <c:pt idx="190" formatCode="0.00E+00">
                  <c:v>0.130218</c:v>
                </c:pt>
                <c:pt idx="191" formatCode="0.00E+00">
                  <c:v>0.13222</c:v>
                </c:pt>
                <c:pt idx="192" formatCode="0.00E+00">
                  <c:v>0.134688</c:v>
                </c:pt>
                <c:pt idx="193" formatCode="0.00E+00">
                  <c:v>0.139796</c:v>
                </c:pt>
                <c:pt idx="194" formatCode="0.00E+00">
                  <c:v>0.145348</c:v>
                </c:pt>
                <c:pt idx="195" formatCode="0.00E+00">
                  <c:v>0.14560999999999999</c:v>
                </c:pt>
                <c:pt idx="196" formatCode="0.00E+00">
                  <c:v>0.145702</c:v>
                </c:pt>
                <c:pt idx="197" formatCode="0.00E+00">
                  <c:v>0.148281</c:v>
                </c:pt>
                <c:pt idx="198" formatCode="0.00E+00">
                  <c:v>0.14854999999999999</c:v>
                </c:pt>
                <c:pt idx="199" formatCode="0.00E+00">
                  <c:v>0.14826399999999998</c:v>
                </c:pt>
                <c:pt idx="200" formatCode="0.00E+00">
                  <c:v>0.15040200000000001</c:v>
                </c:pt>
                <c:pt idx="201" formatCode="0.00E+00">
                  <c:v>0.15305299999999999</c:v>
                </c:pt>
                <c:pt idx="202" formatCode="0.00E+00">
                  <c:v>0.15472999999999998</c:v>
                </c:pt>
                <c:pt idx="203" formatCode="0.00E+00">
                  <c:v>0.15850900000000001</c:v>
                </c:pt>
                <c:pt idx="204" formatCode="0.00E+00">
                  <c:v>0.16157299999999999</c:v>
                </c:pt>
                <c:pt idx="205" formatCode="0.00E+00">
                  <c:v>0.16255700000000001</c:v>
                </c:pt>
                <c:pt idx="206" formatCode="0.00E+00">
                  <c:v>0.16283700000000001</c:v>
                </c:pt>
                <c:pt idx="207" formatCode="0.00E+00">
                  <c:v>0.16516800000000001</c:v>
                </c:pt>
                <c:pt idx="208" formatCode="0.00E+00">
                  <c:v>0.16663800000000001</c:v>
                </c:pt>
                <c:pt idx="209" formatCode="0.00E+00">
                  <c:v>0.16910900000000001</c:v>
                </c:pt>
                <c:pt idx="210" formatCode="0.00E+00">
                  <c:v>0.170821</c:v>
                </c:pt>
                <c:pt idx="211" formatCode="0.00E+00">
                  <c:v>0.17205600000000001</c:v>
                </c:pt>
                <c:pt idx="212" formatCode="0.00E+00">
                  <c:v>0.17452599999999999</c:v>
                </c:pt>
                <c:pt idx="213" formatCode="0.00E+00">
                  <c:v>0.17654799999999998</c:v>
                </c:pt>
                <c:pt idx="214" formatCode="0.00E+00">
                  <c:v>0.17721800000000001</c:v>
                </c:pt>
                <c:pt idx="215" formatCode="0.00E+00">
                  <c:v>0.179677</c:v>
                </c:pt>
                <c:pt idx="216" formatCode="0.00E+00">
                  <c:v>0.18035299999999999</c:v>
                </c:pt>
                <c:pt idx="217" formatCode="0.00E+00">
                  <c:v>0.18285999999999999</c:v>
                </c:pt>
                <c:pt idx="218" formatCode="0.00E+00">
                  <c:v>0.18326100000000001</c:v>
                </c:pt>
                <c:pt idx="219" formatCode="0.00E+00">
                  <c:v>0.18514900000000001</c:v>
                </c:pt>
                <c:pt idx="220" formatCode="0.00E+00">
                  <c:v>0.188329</c:v>
                </c:pt>
                <c:pt idx="221" formatCode="0.00E+00">
                  <c:v>0.18985199999999999</c:v>
                </c:pt>
                <c:pt idx="222" formatCode="0.00E+00">
                  <c:v>0.189472</c:v>
                </c:pt>
                <c:pt idx="223" formatCode="0.00E+00">
                  <c:v>0.19168099999999999</c:v>
                </c:pt>
                <c:pt idx="224" formatCode="0.00E+00">
                  <c:v>0.19287799999999999</c:v>
                </c:pt>
                <c:pt idx="225" formatCode="0.00E+00">
                  <c:v>0.195494</c:v>
                </c:pt>
                <c:pt idx="226" formatCode="0.00E+00">
                  <c:v>0.195687</c:v>
                </c:pt>
                <c:pt idx="227" formatCode="0.00E+00">
                  <c:v>0.196468</c:v>
                </c:pt>
                <c:pt idx="228" formatCode="0.00E+00">
                  <c:v>0.196604</c:v>
                </c:pt>
                <c:pt idx="229" formatCode="0.00E+00">
                  <c:v>0.19804099999999999</c:v>
                </c:pt>
                <c:pt idx="230" formatCode="0.00E+00">
                  <c:v>0.20151300000000003</c:v>
                </c:pt>
                <c:pt idx="231" formatCode="0.00E+00">
                  <c:v>0.20186600000000002</c:v>
                </c:pt>
                <c:pt idx="232" formatCode="0.00E+00">
                  <c:v>0.20292499999999999</c:v>
                </c:pt>
                <c:pt idx="233" formatCode="0.00E+00">
                  <c:v>0.20355799999999999</c:v>
                </c:pt>
                <c:pt idx="234" formatCode="0.00E+00">
                  <c:v>0.20253000000000002</c:v>
                </c:pt>
                <c:pt idx="235" formatCode="0.00E+00">
                  <c:v>0.203518</c:v>
                </c:pt>
                <c:pt idx="236" formatCode="0.00E+00">
                  <c:v>0.203761</c:v>
                </c:pt>
                <c:pt idx="237" formatCode="0.00E+00">
                  <c:v>0.20338799999999999</c:v>
                </c:pt>
                <c:pt idx="238" formatCode="0.00E+00">
                  <c:v>0.20441600000000001</c:v>
                </c:pt>
                <c:pt idx="239" formatCode="0.00E+00">
                  <c:v>0.20519599999999999</c:v>
                </c:pt>
                <c:pt idx="240" formatCode="0.00E+00">
                  <c:v>0.205516</c:v>
                </c:pt>
                <c:pt idx="241" formatCode="0.00E+00">
                  <c:v>0.207486</c:v>
                </c:pt>
                <c:pt idx="242" formatCode="0.00E+00">
                  <c:v>0.20602999999999999</c:v>
                </c:pt>
                <c:pt idx="243" formatCode="0.00E+00">
                  <c:v>0.20576900000000001</c:v>
                </c:pt>
                <c:pt idx="244" formatCode="0.00E+00">
                  <c:v>0.20866200000000001</c:v>
                </c:pt>
                <c:pt idx="245" formatCode="0.00E+00">
                  <c:v>0.20835100000000001</c:v>
                </c:pt>
                <c:pt idx="246" formatCode="0.00E+00">
                  <c:v>0.20831399999999997</c:v>
                </c:pt>
                <c:pt idx="247" formatCode="0.00E+00">
                  <c:v>0.20879200000000001</c:v>
                </c:pt>
                <c:pt idx="248" formatCode="0.00E+00">
                  <c:v>0.20799299999999998</c:v>
                </c:pt>
                <c:pt idx="249" formatCode="0.00E+00">
                  <c:v>0.20661300000000002</c:v>
                </c:pt>
                <c:pt idx="250" formatCode="0.00E+00">
                  <c:v>0.20879399999999998</c:v>
                </c:pt>
                <c:pt idx="251" formatCode="0.00E+00">
                  <c:v>0.20810500000000001</c:v>
                </c:pt>
                <c:pt idx="252" formatCode="0.00E+00">
                  <c:v>0.207376</c:v>
                </c:pt>
                <c:pt idx="253" formatCode="0.00E+00">
                  <c:v>0.20564499999999999</c:v>
                </c:pt>
                <c:pt idx="254" formatCode="0.00E+00">
                  <c:v>0.20432</c:v>
                </c:pt>
                <c:pt idx="255" formatCode="0.00E+00">
                  <c:v>0.20294900000000002</c:v>
                </c:pt>
                <c:pt idx="256" formatCode="0.00E+00">
                  <c:v>0.202543</c:v>
                </c:pt>
                <c:pt idx="257" formatCode="0.00E+00">
                  <c:v>0.200459</c:v>
                </c:pt>
                <c:pt idx="258" formatCode="0.00E+00">
                  <c:v>0.19839999999999999</c:v>
                </c:pt>
                <c:pt idx="259" formatCode="0.00E+00">
                  <c:v>0.19614900000000002</c:v>
                </c:pt>
                <c:pt idx="260" formatCode="0.00E+00">
                  <c:v>0.19814400000000001</c:v>
                </c:pt>
                <c:pt idx="261" formatCode="0.00E+00">
                  <c:v>0.199465</c:v>
                </c:pt>
                <c:pt idx="262" formatCode="0.00E+00">
                  <c:v>0.19869300000000001</c:v>
                </c:pt>
                <c:pt idx="263" formatCode="0.00E+00">
                  <c:v>0.19489900000000002</c:v>
                </c:pt>
                <c:pt idx="264" formatCode="0.00E+00">
                  <c:v>0.19114200000000001</c:v>
                </c:pt>
                <c:pt idx="265" formatCode="0.00E+00">
                  <c:v>0.187889</c:v>
                </c:pt>
                <c:pt idx="266" formatCode="0.00E+00">
                  <c:v>0.18511900000000001</c:v>
                </c:pt>
                <c:pt idx="267" formatCode="0.00E+00">
                  <c:v>0.18316099999999999</c:v>
                </c:pt>
                <c:pt idx="268" formatCode="0.00E+00">
                  <c:v>0.17916199999999999</c:v>
                </c:pt>
                <c:pt idx="269" formatCode="0.00E+00">
                  <c:v>0.17543399999999998</c:v>
                </c:pt>
                <c:pt idx="270" formatCode="0.00E+00">
                  <c:v>0.16991699999999998</c:v>
                </c:pt>
                <c:pt idx="271" formatCode="0.00E+00">
                  <c:v>0.16528099999999998</c:v>
                </c:pt>
                <c:pt idx="272" formatCode="0.00E+00">
                  <c:v>0.163773</c:v>
                </c:pt>
                <c:pt idx="273" formatCode="0.00E+00">
                  <c:v>0.16208599999999998</c:v>
                </c:pt>
                <c:pt idx="274" formatCode="0.00E+00">
                  <c:v>0.15565499999999999</c:v>
                </c:pt>
                <c:pt idx="275" formatCode="0.00E+00">
                  <c:v>0.148309</c:v>
                </c:pt>
                <c:pt idx="276" formatCode="0.00E+00">
                  <c:v>0.14477999999999999</c:v>
                </c:pt>
                <c:pt idx="277" formatCode="0.00E+00">
                  <c:v>0.14158000000000001</c:v>
                </c:pt>
                <c:pt idx="278" formatCode="0.00E+00">
                  <c:v>0.13809199999999999</c:v>
                </c:pt>
                <c:pt idx="279" formatCode="0.00E+00">
                  <c:v>0.132628</c:v>
                </c:pt>
                <c:pt idx="280" formatCode="0.00E+00">
                  <c:v>0.12745099999999998</c:v>
                </c:pt>
                <c:pt idx="281" formatCode="0.00E+00">
                  <c:v>0.12328799999999999</c:v>
                </c:pt>
                <c:pt idx="282" formatCode="0.00E+00">
                  <c:v>0.11706699999999999</c:v>
                </c:pt>
                <c:pt idx="283" formatCode="0.00E+00">
                  <c:v>0.115007</c:v>
                </c:pt>
                <c:pt idx="284" formatCode="0.00E+00">
                  <c:v>0.111497</c:v>
                </c:pt>
                <c:pt idx="285" formatCode="0.00E+00">
                  <c:v>0.103988</c:v>
                </c:pt>
                <c:pt idx="286" formatCode="0.00E+00">
                  <c:v>0.10038899999999999</c:v>
                </c:pt>
                <c:pt idx="287" formatCode="0.00E+00">
                  <c:v>9.79854E-2</c:v>
                </c:pt>
                <c:pt idx="288" formatCode="0.00E+00">
                  <c:v>9.3231900000000006E-2</c:v>
                </c:pt>
                <c:pt idx="289" formatCode="0.00E+00">
                  <c:v>8.8222800000000004E-2</c:v>
                </c:pt>
                <c:pt idx="290" formatCode="0.00E+00">
                  <c:v>8.6242199999999991E-2</c:v>
                </c:pt>
                <c:pt idx="291" formatCode="0.00E+00">
                  <c:v>8.1876400000000002E-2</c:v>
                </c:pt>
                <c:pt idx="292" formatCode="0.00E+00">
                  <c:v>7.7470899999999995E-2</c:v>
                </c:pt>
                <c:pt idx="293" formatCode="0.00E+00">
                  <c:v>7.1915300000000001E-2</c:v>
                </c:pt>
                <c:pt idx="294" formatCode="0.00E+00">
                  <c:v>6.8528199999999997E-2</c:v>
                </c:pt>
                <c:pt idx="295" formatCode="0.00E+00">
                  <c:v>6.4467899999999995E-2</c:v>
                </c:pt>
                <c:pt idx="296" formatCode="0.00E+00">
                  <c:v>5.9179200000000001E-2</c:v>
                </c:pt>
                <c:pt idx="297" formatCode="0.00E+00">
                  <c:v>5.7240800000000001E-2</c:v>
                </c:pt>
                <c:pt idx="298" formatCode="0.00E+00">
                  <c:v>5.2401199999999995E-2</c:v>
                </c:pt>
                <c:pt idx="299" formatCode="0.00E+00">
                  <c:v>4.9012899999999998E-2</c:v>
                </c:pt>
                <c:pt idx="300" formatCode="0.00E+00">
                  <c:v>4.5192200000000002E-2</c:v>
                </c:pt>
                <c:pt idx="301" formatCode="0.00E+00">
                  <c:v>4.1194199999999993E-2</c:v>
                </c:pt>
                <c:pt idx="302" formatCode="0.00E+00">
                  <c:v>3.9491400000000003E-2</c:v>
                </c:pt>
                <c:pt idx="303" formatCode="0.00E+00">
                  <c:v>3.2511600000000002E-2</c:v>
                </c:pt>
                <c:pt idx="304" formatCode="0.00E+00">
                  <c:v>2.81894E-2</c:v>
                </c:pt>
                <c:pt idx="305" formatCode="0.00E+00">
                  <c:v>2.4474099999999999E-2</c:v>
                </c:pt>
                <c:pt idx="306" formatCode="0.00E+00">
                  <c:v>2.4818199999999999E-2</c:v>
                </c:pt>
                <c:pt idx="307" formatCode="0.00E+00">
                  <c:v>2.49635E-2</c:v>
                </c:pt>
                <c:pt idx="308" formatCode="0.00E+00">
                  <c:v>2.07899E-2</c:v>
                </c:pt>
                <c:pt idx="309" formatCode="0.00E+00">
                  <c:v>1.9365800000000002E-2</c:v>
                </c:pt>
                <c:pt idx="310" formatCode="0.00E+00">
                  <c:v>1.5666899999999997E-2</c:v>
                </c:pt>
                <c:pt idx="311" formatCode="0.00E+00">
                  <c:v>1.5326900000000001E-2</c:v>
                </c:pt>
                <c:pt idx="312" formatCode="0.00E+00">
                  <c:v>1.6405100000000002E-2</c:v>
                </c:pt>
                <c:pt idx="313" formatCode="0.00E+00">
                  <c:v>1.3707700000000001E-2</c:v>
                </c:pt>
                <c:pt idx="314" formatCode="0.00E+00">
                  <c:v>1.2170800000000001E-2</c:v>
                </c:pt>
                <c:pt idx="315" formatCode="0.00E+00">
                  <c:v>1.03185E-2</c:v>
                </c:pt>
                <c:pt idx="316" formatCode="0.00E+00">
                  <c:v>8.0644600000000007E-3</c:v>
                </c:pt>
                <c:pt idx="317" formatCode="0.00E+00">
                  <c:v>1.0293E-2</c:v>
                </c:pt>
                <c:pt idx="318" formatCode="0.00E+00">
                  <c:v>9.7865000000000001E-3</c:v>
                </c:pt>
                <c:pt idx="319" formatCode="0.00E+00">
                  <c:v>7.9588699999999998E-3</c:v>
                </c:pt>
                <c:pt idx="320" formatCode="0.00E+00">
                  <c:v>7.8035500000000002E-3</c:v>
                </c:pt>
                <c:pt idx="321" formatCode="0.00E+00">
                  <c:v>7.6851600000000008E-3</c:v>
                </c:pt>
                <c:pt idx="322" formatCode="0.00E+00">
                  <c:v>7.4690099999999999E-3</c:v>
                </c:pt>
                <c:pt idx="323" formatCode="0.00E+00">
                  <c:v>5.9967800000000002E-3</c:v>
                </c:pt>
                <c:pt idx="324" formatCode="0.00E+00">
                  <c:v>5.4961399999999992E-3</c:v>
                </c:pt>
                <c:pt idx="325" formatCode="0.00E+00">
                  <c:v>5.5779500000000008E-3</c:v>
                </c:pt>
                <c:pt idx="326" formatCode="0.00E+00">
                  <c:v>5.1038699999999999E-3</c:v>
                </c:pt>
                <c:pt idx="327" formatCode="0.00E+00">
                  <c:v>4.2883499999999998E-3</c:v>
                </c:pt>
                <c:pt idx="328" formatCode="0.00E+00">
                  <c:v>4.7400699999999999E-3</c:v>
                </c:pt>
                <c:pt idx="329" formatCode="0.00E+00">
                  <c:v>3.4836399999999997E-3</c:v>
                </c:pt>
                <c:pt idx="330" formatCode="0.00E+00">
                  <c:v>1.32749E-3</c:v>
                </c:pt>
                <c:pt idx="331" formatCode="0.00E+00">
                  <c:v>2.36914E-3</c:v>
                </c:pt>
                <c:pt idx="332" formatCode="0.00E+00">
                  <c:v>3.30832E-3</c:v>
                </c:pt>
                <c:pt idx="333" formatCode="0.00E+00">
                  <c:v>3.6007700000000001E-3</c:v>
                </c:pt>
                <c:pt idx="334" formatCode="0.00E+00">
                  <c:v>2.45217E-3</c:v>
                </c:pt>
                <c:pt idx="335" formatCode="0.00E+00">
                  <c:v>-1.4621600000000001E-4</c:v>
                </c:pt>
                <c:pt idx="336" formatCode="0.00E+00">
                  <c:v>-5.4307700000000002E-5</c:v>
                </c:pt>
                <c:pt idx="337" formatCode="0.00E+00">
                  <c:v>1.0675300000000001E-3</c:v>
                </c:pt>
                <c:pt idx="338" formatCode="0.00E+00">
                  <c:v>7.7578900000000004E-4</c:v>
                </c:pt>
                <c:pt idx="339" formatCode="0.00E+00">
                  <c:v>-8.5120499999999993E-6</c:v>
                </c:pt>
                <c:pt idx="340" formatCode="0.00E+00">
                  <c:v>1.8653999999999999E-4</c:v>
                </c:pt>
                <c:pt idx="341" formatCode="0.00E+00">
                  <c:v>1.1695399999999999E-3</c:v>
                </c:pt>
                <c:pt idx="342" formatCode="0.00E+00">
                  <c:v>1.9979099999999999E-3</c:v>
                </c:pt>
                <c:pt idx="343" formatCode="0.00E+00">
                  <c:v>1.9931999999999998E-4</c:v>
                </c:pt>
                <c:pt idx="344" formatCode="0.00E+00">
                  <c:v>4.4226200000000002E-4</c:v>
                </c:pt>
                <c:pt idx="345" formatCode="0.00E+00">
                  <c:v>8.0448499999999997E-4</c:v>
                </c:pt>
                <c:pt idx="346" formatCode="0.00E+00">
                  <c:v>-6.7903699999999996E-4</c:v>
                </c:pt>
                <c:pt idx="347" formatCode="0.00E+00">
                  <c:v>8.3188099999999992E-4</c:v>
                </c:pt>
                <c:pt idx="348" formatCode="0.00E+00">
                  <c:v>1.4003999999999999E-4</c:v>
                </c:pt>
                <c:pt idx="349" formatCode="0.00E+00">
                  <c:v>-2.2529199999999998E-3</c:v>
                </c:pt>
                <c:pt idx="350" formatCode="0.00E+00">
                  <c:v>-9.2224400000000002E-4</c:v>
                </c:pt>
                <c:pt idx="351" formatCode="0.00E+00">
                  <c:v>-1.4044400000000001E-3</c:v>
                </c:pt>
                <c:pt idx="352" formatCode="0.00E+00">
                  <c:v>-2.4755300000000001E-3</c:v>
                </c:pt>
                <c:pt idx="353" formatCode="0.00E+00">
                  <c:v>-2.21579E-3</c:v>
                </c:pt>
                <c:pt idx="354" formatCode="0.00E+00">
                  <c:v>-2.2929199999999999E-3</c:v>
                </c:pt>
                <c:pt idx="355" formatCode="0.00E+00">
                  <c:v>-2.5301899999999999E-3</c:v>
                </c:pt>
                <c:pt idx="356" formatCode="0.00E+00">
                  <c:v>-9.5641500000000006E-4</c:v>
                </c:pt>
                <c:pt idx="357" formatCode="0.00E+00">
                  <c:v>7.1314300000000007E-4</c:v>
                </c:pt>
                <c:pt idx="358" formatCode="0.00E+00">
                  <c:v>-2.2753900000000002E-4</c:v>
                </c:pt>
                <c:pt idx="359" formatCode="0.00E+00">
                  <c:v>-1.06821E-3</c:v>
                </c:pt>
                <c:pt idx="360" formatCode="0.00E+00">
                  <c:v>-2.9015500000000001E-3</c:v>
                </c:pt>
                <c:pt idx="361" formatCode="0.00E+00">
                  <c:v>-1.5140900000000001E-3</c:v>
                </c:pt>
                <c:pt idx="362" formatCode="0.00E+00">
                  <c:v>-1.4471500000000001E-3</c:v>
                </c:pt>
                <c:pt idx="363" formatCode="0.00E+00">
                  <c:v>-2.20317E-3</c:v>
                </c:pt>
                <c:pt idx="364" formatCode="0.00E+00">
                  <c:v>-2.0009400000000001E-3</c:v>
                </c:pt>
                <c:pt idx="365" formatCode="0.00E+00">
                  <c:v>-2.6513999999999999E-3</c:v>
                </c:pt>
                <c:pt idx="366" formatCode="0.00E+00">
                  <c:v>-1.17336E-3</c:v>
                </c:pt>
                <c:pt idx="367" formatCode="0.00E+00">
                  <c:v>-2.6629500000000003E-3</c:v>
                </c:pt>
                <c:pt idx="368" formatCode="0.00E+00">
                  <c:v>-9.7313100000000002E-4</c:v>
                </c:pt>
                <c:pt idx="369" formatCode="0.00E+00">
                  <c:v>7.6668099999999996E-4</c:v>
                </c:pt>
                <c:pt idx="370" formatCode="0.00E+00">
                  <c:v>4.4448399999999998E-4</c:v>
                </c:pt>
                <c:pt idx="371" formatCode="0.00E+00">
                  <c:v>-1.09132E-3</c:v>
                </c:pt>
                <c:pt idx="372" formatCode="0.00E+00">
                  <c:v>-9.042770000000001E-4</c:v>
                </c:pt>
                <c:pt idx="373" formatCode="0.00E+00">
                  <c:v>2.04849E-3</c:v>
                </c:pt>
                <c:pt idx="374" formatCode="0.00E+00">
                  <c:v>3.1815300000000001E-3</c:v>
                </c:pt>
                <c:pt idx="375" formatCode="0.00E+00">
                  <c:v>3.3629899999999997E-3</c:v>
                </c:pt>
                <c:pt idx="376" formatCode="0.00E+00">
                  <c:v>9.5201299999999993E-4</c:v>
                </c:pt>
                <c:pt idx="377" formatCode="0.00E+00">
                  <c:v>9.1150599999999997E-4</c:v>
                </c:pt>
                <c:pt idx="378" formatCode="0.00E+00">
                  <c:v>7.9105000000000006E-4</c:v>
                </c:pt>
                <c:pt idx="379" formatCode="0.00E+00">
                  <c:v>2.67538E-4</c:v>
                </c:pt>
                <c:pt idx="380" formatCode="0.00E+00">
                  <c:v>-9.6094500000000005E-4</c:v>
                </c:pt>
                <c:pt idx="381" formatCode="0.00E+00">
                  <c:v>-1.71295E-3</c:v>
                </c:pt>
                <c:pt idx="382" formatCode="0.00E+00">
                  <c:v>1.6473900000000001E-4</c:v>
                </c:pt>
                <c:pt idx="383" formatCode="0.00E+00">
                  <c:v>7.5893399999999995E-4</c:v>
                </c:pt>
                <c:pt idx="384" formatCode="0.00E+00">
                  <c:v>1.2190300000000001E-3</c:v>
                </c:pt>
                <c:pt idx="385" formatCode="0.00E+00">
                  <c:v>8.0488199999999993E-4</c:v>
                </c:pt>
                <c:pt idx="386" formatCode="0.00E+00">
                  <c:v>6.0316900000000008E-4</c:v>
                </c:pt>
                <c:pt idx="387" formatCode="0.00E+00">
                  <c:v>2.14576E-3</c:v>
                </c:pt>
                <c:pt idx="388" formatCode="0.00E+00">
                  <c:v>1.20827E-3</c:v>
                </c:pt>
                <c:pt idx="389" formatCode="0.00E+00">
                  <c:v>-3.1561799999999999E-4</c:v>
                </c:pt>
                <c:pt idx="390" formatCode="0.00E+00">
                  <c:v>6.4623299999999996E-4</c:v>
                </c:pt>
                <c:pt idx="391" formatCode="0.00E+00">
                  <c:v>1.69388E-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G$1</c:f>
              <c:strCache>
                <c:ptCount val="1"/>
                <c:pt idx="0">
                  <c:v>Microfluidized GLA-AF Lot #2</c:v>
                </c:pt>
              </c:strCache>
            </c:strRef>
          </c:tx>
          <c:spPr>
            <a:ln w="19050"/>
          </c:spPr>
          <c:marker>
            <c:symbol val="none"/>
          </c:marker>
          <c:xVal>
            <c:numRef>
              <c:f>Sheet1!$A$2:$A$394</c:f>
              <c:numCache>
                <c:formatCode>General</c:formatCode>
                <c:ptCount val="393"/>
                <c:pt idx="0">
                  <c:v>7.6610899999999997</c:v>
                </c:pt>
                <c:pt idx="1">
                  <c:v>7.7944199999999997</c:v>
                </c:pt>
                <c:pt idx="2">
                  <c:v>7.9281800000000002</c:v>
                </c:pt>
                <c:pt idx="3">
                  <c:v>8.0620200000000004</c:v>
                </c:pt>
                <c:pt idx="4">
                  <c:v>8.1950699999999994</c:v>
                </c:pt>
                <c:pt idx="5">
                  <c:v>8.3279800000000002</c:v>
                </c:pt>
                <c:pt idx="6">
                  <c:v>8.4612999999999996</c:v>
                </c:pt>
                <c:pt idx="7">
                  <c:v>8.5946899999999999</c:v>
                </c:pt>
                <c:pt idx="8">
                  <c:v>8.72898</c:v>
                </c:pt>
                <c:pt idx="9">
                  <c:v>8.8628300000000007</c:v>
                </c:pt>
                <c:pt idx="10">
                  <c:v>8.9957399999999996</c:v>
                </c:pt>
                <c:pt idx="11">
                  <c:v>9.1294500000000003</c:v>
                </c:pt>
                <c:pt idx="12">
                  <c:v>9.26342</c:v>
                </c:pt>
                <c:pt idx="13">
                  <c:v>9.3959799999999998</c:v>
                </c:pt>
                <c:pt idx="14">
                  <c:v>9.5299999999999994</c:v>
                </c:pt>
                <c:pt idx="15">
                  <c:v>9.6634600000000006</c:v>
                </c:pt>
                <c:pt idx="16">
                  <c:v>9.7977399999999992</c:v>
                </c:pt>
                <c:pt idx="17">
                  <c:v>9.9310799999999997</c:v>
                </c:pt>
                <c:pt idx="18">
                  <c:v>10.0641</c:v>
                </c:pt>
                <c:pt idx="19">
                  <c:v>10.197480000000001</c:v>
                </c:pt>
                <c:pt idx="20">
                  <c:v>10.33029</c:v>
                </c:pt>
                <c:pt idx="21">
                  <c:v>10.463100000000001</c:v>
                </c:pt>
                <c:pt idx="22">
                  <c:v>10.596769999999999</c:v>
                </c:pt>
                <c:pt idx="23">
                  <c:v>10.7296</c:v>
                </c:pt>
                <c:pt idx="24">
                  <c:v>10.861359999999999</c:v>
                </c:pt>
                <c:pt idx="25">
                  <c:v>10.994440000000001</c:v>
                </c:pt>
                <c:pt idx="26">
                  <c:v>11.127420000000001</c:v>
                </c:pt>
                <c:pt idx="27">
                  <c:v>11.261060000000001</c:v>
                </c:pt>
                <c:pt idx="28">
                  <c:v>11.39434</c:v>
                </c:pt>
                <c:pt idx="29">
                  <c:v>11.527659999999999</c:v>
                </c:pt>
                <c:pt idx="30">
                  <c:v>11.66004</c:v>
                </c:pt>
                <c:pt idx="31">
                  <c:v>11.79407</c:v>
                </c:pt>
                <c:pt idx="32">
                  <c:v>11.92831</c:v>
                </c:pt>
                <c:pt idx="33">
                  <c:v>12.061909999999999</c:v>
                </c:pt>
                <c:pt idx="34">
                  <c:v>12.19483</c:v>
                </c:pt>
                <c:pt idx="35">
                  <c:v>12.32816</c:v>
                </c:pt>
                <c:pt idx="36">
                  <c:v>12.461869999999999</c:v>
                </c:pt>
                <c:pt idx="37">
                  <c:v>12.59474</c:v>
                </c:pt>
                <c:pt idx="38">
                  <c:v>12.72813</c:v>
                </c:pt>
                <c:pt idx="39">
                  <c:v>12.86239</c:v>
                </c:pt>
                <c:pt idx="40">
                  <c:v>12.996219999999999</c:v>
                </c:pt>
                <c:pt idx="41">
                  <c:v>13.12875</c:v>
                </c:pt>
                <c:pt idx="42">
                  <c:v>13.261150000000001</c:v>
                </c:pt>
                <c:pt idx="43">
                  <c:v>13.396179999999999</c:v>
                </c:pt>
                <c:pt idx="44">
                  <c:v>13.52951</c:v>
                </c:pt>
                <c:pt idx="45">
                  <c:v>13.66248</c:v>
                </c:pt>
                <c:pt idx="46">
                  <c:v>13.797040000000001</c:v>
                </c:pt>
                <c:pt idx="47">
                  <c:v>13.929959999999999</c:v>
                </c:pt>
                <c:pt idx="48">
                  <c:v>14.063739999999999</c:v>
                </c:pt>
                <c:pt idx="49">
                  <c:v>14.197419999999999</c:v>
                </c:pt>
                <c:pt idx="50">
                  <c:v>14.330069999999999</c:v>
                </c:pt>
                <c:pt idx="51">
                  <c:v>14.463710000000001</c:v>
                </c:pt>
                <c:pt idx="52">
                  <c:v>14.59592</c:v>
                </c:pt>
                <c:pt idx="53">
                  <c:v>14.72569</c:v>
                </c:pt>
                <c:pt idx="54">
                  <c:v>14.85899</c:v>
                </c:pt>
                <c:pt idx="55">
                  <c:v>14.99072</c:v>
                </c:pt>
                <c:pt idx="56">
                  <c:v>15.12476</c:v>
                </c:pt>
                <c:pt idx="57">
                  <c:v>15.259180000000001</c:v>
                </c:pt>
                <c:pt idx="58">
                  <c:v>15.39245</c:v>
                </c:pt>
                <c:pt idx="59">
                  <c:v>15.5259</c:v>
                </c:pt>
                <c:pt idx="60">
                  <c:v>15.660069999999999</c:v>
                </c:pt>
                <c:pt idx="61">
                  <c:v>15.79339</c:v>
                </c:pt>
                <c:pt idx="62">
                  <c:v>15.925890000000001</c:v>
                </c:pt>
                <c:pt idx="63">
                  <c:v>16.059449999999998</c:v>
                </c:pt>
                <c:pt idx="64">
                  <c:v>16.19295</c:v>
                </c:pt>
                <c:pt idx="65">
                  <c:v>16.32657</c:v>
                </c:pt>
                <c:pt idx="66">
                  <c:v>16.46087</c:v>
                </c:pt>
                <c:pt idx="67">
                  <c:v>16.593990000000002</c:v>
                </c:pt>
                <c:pt idx="68">
                  <c:v>16.727270000000001</c:v>
                </c:pt>
                <c:pt idx="69">
                  <c:v>16.861149999999999</c:v>
                </c:pt>
                <c:pt idx="70">
                  <c:v>16.99465</c:v>
                </c:pt>
                <c:pt idx="71">
                  <c:v>17.126930000000002</c:v>
                </c:pt>
                <c:pt idx="72">
                  <c:v>17.260819999999999</c:v>
                </c:pt>
                <c:pt idx="73">
                  <c:v>17.394780000000001</c:v>
                </c:pt>
                <c:pt idx="74">
                  <c:v>17.52871</c:v>
                </c:pt>
                <c:pt idx="75">
                  <c:v>17.663740000000001</c:v>
                </c:pt>
                <c:pt idx="76">
                  <c:v>17.795480000000001</c:v>
                </c:pt>
                <c:pt idx="77">
                  <c:v>17.928370000000001</c:v>
                </c:pt>
                <c:pt idx="78">
                  <c:v>18.060700000000001</c:v>
                </c:pt>
                <c:pt idx="79">
                  <c:v>18.196020000000001</c:v>
                </c:pt>
                <c:pt idx="80">
                  <c:v>18.328579999999999</c:v>
                </c:pt>
                <c:pt idx="81">
                  <c:v>18.459879999999998</c:v>
                </c:pt>
                <c:pt idx="82">
                  <c:v>18.591989999999999</c:v>
                </c:pt>
                <c:pt idx="83">
                  <c:v>18.726469999999999</c:v>
                </c:pt>
                <c:pt idx="84">
                  <c:v>18.859529999999999</c:v>
                </c:pt>
                <c:pt idx="85">
                  <c:v>18.99193</c:v>
                </c:pt>
                <c:pt idx="86">
                  <c:v>19.125610000000002</c:v>
                </c:pt>
                <c:pt idx="87">
                  <c:v>19.25929</c:v>
                </c:pt>
                <c:pt idx="88">
                  <c:v>19.392389999999999</c:v>
                </c:pt>
                <c:pt idx="89">
                  <c:v>19.526540000000001</c:v>
                </c:pt>
                <c:pt idx="90">
                  <c:v>19.658989999999999</c:v>
                </c:pt>
                <c:pt idx="91">
                  <c:v>19.79243</c:v>
                </c:pt>
                <c:pt idx="92">
                  <c:v>19.92576</c:v>
                </c:pt>
                <c:pt idx="93">
                  <c:v>20.05932</c:v>
                </c:pt>
                <c:pt idx="94">
                  <c:v>20.19265</c:v>
                </c:pt>
                <c:pt idx="95">
                  <c:v>20.325199999999999</c:v>
                </c:pt>
                <c:pt idx="96">
                  <c:v>20.45909</c:v>
                </c:pt>
                <c:pt idx="97">
                  <c:v>20.59299</c:v>
                </c:pt>
                <c:pt idx="98">
                  <c:v>20.72635</c:v>
                </c:pt>
                <c:pt idx="99">
                  <c:v>20.859960000000001</c:v>
                </c:pt>
                <c:pt idx="100">
                  <c:v>20.993829999999999</c:v>
                </c:pt>
                <c:pt idx="101">
                  <c:v>21.126619999999999</c:v>
                </c:pt>
                <c:pt idx="102">
                  <c:v>21.260899999999999</c:v>
                </c:pt>
                <c:pt idx="103">
                  <c:v>21.394770000000001</c:v>
                </c:pt>
                <c:pt idx="104">
                  <c:v>21.52769</c:v>
                </c:pt>
                <c:pt idx="105">
                  <c:v>21.661290000000001</c:v>
                </c:pt>
                <c:pt idx="106">
                  <c:v>21.794360000000001</c:v>
                </c:pt>
                <c:pt idx="107">
                  <c:v>21.928180000000001</c:v>
                </c:pt>
                <c:pt idx="108">
                  <c:v>22.061260000000001</c:v>
                </c:pt>
                <c:pt idx="109">
                  <c:v>22.191469999999999</c:v>
                </c:pt>
                <c:pt idx="110">
                  <c:v>22.320640000000001</c:v>
                </c:pt>
                <c:pt idx="111">
                  <c:v>22.454719999999998</c:v>
                </c:pt>
                <c:pt idx="112">
                  <c:v>22.587669999999999</c:v>
                </c:pt>
                <c:pt idx="113">
                  <c:v>22.720600000000001</c:v>
                </c:pt>
                <c:pt idx="114">
                  <c:v>22.853860000000001</c:v>
                </c:pt>
                <c:pt idx="115">
                  <c:v>22.986440000000002</c:v>
                </c:pt>
                <c:pt idx="116">
                  <c:v>23.12058</c:v>
                </c:pt>
                <c:pt idx="117">
                  <c:v>23.254940000000001</c:v>
                </c:pt>
                <c:pt idx="118">
                  <c:v>23.389489999999999</c:v>
                </c:pt>
                <c:pt idx="119">
                  <c:v>23.522670000000002</c:v>
                </c:pt>
                <c:pt idx="120">
                  <c:v>23.656030000000001</c:v>
                </c:pt>
                <c:pt idx="121">
                  <c:v>23.787790000000001</c:v>
                </c:pt>
                <c:pt idx="122">
                  <c:v>23.92173</c:v>
                </c:pt>
                <c:pt idx="123">
                  <c:v>24.05518</c:v>
                </c:pt>
                <c:pt idx="124">
                  <c:v>24.18938</c:v>
                </c:pt>
                <c:pt idx="125">
                  <c:v>24.32283</c:v>
                </c:pt>
                <c:pt idx="126">
                  <c:v>24.45712</c:v>
                </c:pt>
                <c:pt idx="127">
                  <c:v>24.589400000000001</c:v>
                </c:pt>
                <c:pt idx="128">
                  <c:v>24.721360000000001</c:v>
                </c:pt>
                <c:pt idx="129">
                  <c:v>24.855039999999999</c:v>
                </c:pt>
                <c:pt idx="130">
                  <c:v>24.98884</c:v>
                </c:pt>
                <c:pt idx="131">
                  <c:v>25.121690000000001</c:v>
                </c:pt>
                <c:pt idx="132">
                  <c:v>25.25637</c:v>
                </c:pt>
                <c:pt idx="133">
                  <c:v>25.39021</c:v>
                </c:pt>
                <c:pt idx="134">
                  <c:v>25.523109999999999</c:v>
                </c:pt>
                <c:pt idx="135">
                  <c:v>25.655909999999999</c:v>
                </c:pt>
                <c:pt idx="136">
                  <c:v>25.788930000000001</c:v>
                </c:pt>
                <c:pt idx="137">
                  <c:v>25.92334</c:v>
                </c:pt>
                <c:pt idx="138">
                  <c:v>26.05452</c:v>
                </c:pt>
                <c:pt idx="139">
                  <c:v>26.185829999999999</c:v>
                </c:pt>
                <c:pt idx="140">
                  <c:v>26.320309999999999</c:v>
                </c:pt>
                <c:pt idx="141">
                  <c:v>26.45336</c:v>
                </c:pt>
                <c:pt idx="142">
                  <c:v>26.586790000000001</c:v>
                </c:pt>
                <c:pt idx="143">
                  <c:v>26.719899999999999</c:v>
                </c:pt>
                <c:pt idx="144">
                  <c:v>26.853819999999999</c:v>
                </c:pt>
                <c:pt idx="145">
                  <c:v>26.986499999999999</c:v>
                </c:pt>
                <c:pt idx="146">
                  <c:v>27.121220000000001</c:v>
                </c:pt>
                <c:pt idx="147">
                  <c:v>27.255179999999999</c:v>
                </c:pt>
                <c:pt idx="148">
                  <c:v>27.389220000000002</c:v>
                </c:pt>
                <c:pt idx="149">
                  <c:v>27.52272</c:v>
                </c:pt>
                <c:pt idx="150">
                  <c:v>27.65579</c:v>
                </c:pt>
                <c:pt idx="151">
                  <c:v>27.78838</c:v>
                </c:pt>
                <c:pt idx="152">
                  <c:v>27.921939999999999</c:v>
                </c:pt>
                <c:pt idx="153">
                  <c:v>28.055299999999999</c:v>
                </c:pt>
                <c:pt idx="154">
                  <c:v>28.18927</c:v>
                </c:pt>
                <c:pt idx="155">
                  <c:v>28.32255</c:v>
                </c:pt>
                <c:pt idx="156">
                  <c:v>28.457350000000002</c:v>
                </c:pt>
                <c:pt idx="157">
                  <c:v>28.5899</c:v>
                </c:pt>
                <c:pt idx="158">
                  <c:v>28.7224</c:v>
                </c:pt>
                <c:pt idx="159">
                  <c:v>28.856829999999999</c:v>
                </c:pt>
                <c:pt idx="160">
                  <c:v>28.989519999999999</c:v>
                </c:pt>
                <c:pt idx="161">
                  <c:v>29.122039999999998</c:v>
                </c:pt>
                <c:pt idx="162">
                  <c:v>29.2563</c:v>
                </c:pt>
                <c:pt idx="163">
                  <c:v>29.391159999999999</c:v>
                </c:pt>
                <c:pt idx="164">
                  <c:v>29.52478</c:v>
                </c:pt>
                <c:pt idx="165">
                  <c:v>29.65634</c:v>
                </c:pt>
                <c:pt idx="166">
                  <c:v>29.788869999999999</c:v>
                </c:pt>
                <c:pt idx="167">
                  <c:v>29.915369999999999</c:v>
                </c:pt>
                <c:pt idx="168">
                  <c:v>30.04833</c:v>
                </c:pt>
                <c:pt idx="169">
                  <c:v>30.181640000000002</c:v>
                </c:pt>
                <c:pt idx="170">
                  <c:v>30.313939999999999</c:v>
                </c:pt>
                <c:pt idx="171">
                  <c:v>30.447590000000002</c:v>
                </c:pt>
                <c:pt idx="172">
                  <c:v>30.580939999999998</c:v>
                </c:pt>
                <c:pt idx="173">
                  <c:v>30.714320000000001</c:v>
                </c:pt>
                <c:pt idx="174">
                  <c:v>30.847059999999999</c:v>
                </c:pt>
                <c:pt idx="175">
                  <c:v>30.981780000000001</c:v>
                </c:pt>
                <c:pt idx="176">
                  <c:v>31.115020000000001</c:v>
                </c:pt>
                <c:pt idx="177">
                  <c:v>31.248529999999999</c:v>
                </c:pt>
                <c:pt idx="178">
                  <c:v>31.382840000000002</c:v>
                </c:pt>
                <c:pt idx="179">
                  <c:v>31.515640000000001</c:v>
                </c:pt>
                <c:pt idx="180">
                  <c:v>31.64884</c:v>
                </c:pt>
                <c:pt idx="181">
                  <c:v>31.78172</c:v>
                </c:pt>
                <c:pt idx="182">
                  <c:v>31.917359999999999</c:v>
                </c:pt>
                <c:pt idx="183">
                  <c:v>32.048540000000003</c:v>
                </c:pt>
                <c:pt idx="184">
                  <c:v>32.181980000000003</c:v>
                </c:pt>
                <c:pt idx="185">
                  <c:v>32.316429999999997</c:v>
                </c:pt>
                <c:pt idx="186">
                  <c:v>32.44961</c:v>
                </c:pt>
                <c:pt idx="187">
                  <c:v>32.582369999999997</c:v>
                </c:pt>
                <c:pt idx="188">
                  <c:v>32.716009999999997</c:v>
                </c:pt>
                <c:pt idx="189">
                  <c:v>32.849240000000002</c:v>
                </c:pt>
                <c:pt idx="190">
                  <c:v>32.982439999999997</c:v>
                </c:pt>
                <c:pt idx="191">
                  <c:v>33.114980000000003</c:v>
                </c:pt>
                <c:pt idx="192">
                  <c:v>33.248730000000002</c:v>
                </c:pt>
                <c:pt idx="193">
                  <c:v>33.382390000000001</c:v>
                </c:pt>
                <c:pt idx="194">
                  <c:v>33.51567</c:v>
                </c:pt>
                <c:pt idx="195">
                  <c:v>33.646599999999999</c:v>
                </c:pt>
                <c:pt idx="196">
                  <c:v>33.777650000000001</c:v>
                </c:pt>
                <c:pt idx="197">
                  <c:v>33.91169</c:v>
                </c:pt>
                <c:pt idx="198">
                  <c:v>34.044379999999997</c:v>
                </c:pt>
                <c:pt idx="199">
                  <c:v>34.179299999999998</c:v>
                </c:pt>
                <c:pt idx="200">
                  <c:v>34.313870000000001</c:v>
                </c:pt>
                <c:pt idx="201">
                  <c:v>34.447580000000002</c:v>
                </c:pt>
                <c:pt idx="202">
                  <c:v>34.580329999999996</c:v>
                </c:pt>
                <c:pt idx="203">
                  <c:v>34.71358</c:v>
                </c:pt>
                <c:pt idx="204">
                  <c:v>34.846820000000001</c:v>
                </c:pt>
                <c:pt idx="205">
                  <c:v>34.978879999999997</c:v>
                </c:pt>
                <c:pt idx="206">
                  <c:v>35.113500000000002</c:v>
                </c:pt>
                <c:pt idx="207">
                  <c:v>35.247390000000003</c:v>
                </c:pt>
                <c:pt idx="208">
                  <c:v>35.379800000000003</c:v>
                </c:pt>
                <c:pt idx="209">
                  <c:v>35.513480000000001</c:v>
                </c:pt>
                <c:pt idx="210">
                  <c:v>35.647779999999997</c:v>
                </c:pt>
                <c:pt idx="211">
                  <c:v>35.780880000000003</c:v>
                </c:pt>
                <c:pt idx="212">
                  <c:v>35.915129999999998</c:v>
                </c:pt>
                <c:pt idx="213">
                  <c:v>36.048169999999999</c:v>
                </c:pt>
                <c:pt idx="214">
                  <c:v>36.181229999999999</c:v>
                </c:pt>
                <c:pt idx="215">
                  <c:v>36.314830000000001</c:v>
                </c:pt>
                <c:pt idx="216">
                  <c:v>36.449300000000001</c:v>
                </c:pt>
                <c:pt idx="217">
                  <c:v>36.582990000000002</c:v>
                </c:pt>
                <c:pt idx="218">
                  <c:v>36.715519999999998</c:v>
                </c:pt>
                <c:pt idx="219">
                  <c:v>36.84966</c:v>
                </c:pt>
                <c:pt idx="220">
                  <c:v>36.982860000000002</c:v>
                </c:pt>
                <c:pt idx="221">
                  <c:v>37.116770000000002</c:v>
                </c:pt>
                <c:pt idx="222">
                  <c:v>37.250010000000003</c:v>
                </c:pt>
                <c:pt idx="223">
                  <c:v>37.383299999999998</c:v>
                </c:pt>
                <c:pt idx="224">
                  <c:v>37.510719999999999</c:v>
                </c:pt>
                <c:pt idx="225">
                  <c:v>37.642420000000001</c:v>
                </c:pt>
                <c:pt idx="226">
                  <c:v>37.775410000000001</c:v>
                </c:pt>
                <c:pt idx="227">
                  <c:v>37.910130000000002</c:v>
                </c:pt>
                <c:pt idx="228">
                  <c:v>38.043340000000001</c:v>
                </c:pt>
                <c:pt idx="229">
                  <c:v>38.17633</c:v>
                </c:pt>
                <c:pt idx="230">
                  <c:v>38.310580000000002</c:v>
                </c:pt>
                <c:pt idx="231">
                  <c:v>38.4435</c:v>
                </c:pt>
                <c:pt idx="232">
                  <c:v>38.576999999999998</c:v>
                </c:pt>
                <c:pt idx="233">
                  <c:v>38.708979999999997</c:v>
                </c:pt>
                <c:pt idx="234">
                  <c:v>38.841929999999998</c:v>
                </c:pt>
                <c:pt idx="235">
                  <c:v>38.975290000000001</c:v>
                </c:pt>
                <c:pt idx="236">
                  <c:v>39.10951</c:v>
                </c:pt>
                <c:pt idx="237">
                  <c:v>39.242600000000003</c:v>
                </c:pt>
                <c:pt idx="238">
                  <c:v>39.377070000000003</c:v>
                </c:pt>
                <c:pt idx="239">
                  <c:v>39.509659999999997</c:v>
                </c:pt>
                <c:pt idx="240">
                  <c:v>39.642530000000001</c:v>
                </c:pt>
                <c:pt idx="241">
                  <c:v>39.776719999999997</c:v>
                </c:pt>
                <c:pt idx="242">
                  <c:v>39.911279999999998</c:v>
                </c:pt>
                <c:pt idx="243">
                  <c:v>40.044359999999998</c:v>
                </c:pt>
                <c:pt idx="244">
                  <c:v>40.17709</c:v>
                </c:pt>
                <c:pt idx="245">
                  <c:v>40.310130000000001</c:v>
                </c:pt>
                <c:pt idx="246">
                  <c:v>40.443199999999997</c:v>
                </c:pt>
                <c:pt idx="247">
                  <c:v>40.578429999999997</c:v>
                </c:pt>
                <c:pt idx="248">
                  <c:v>40.710810000000002</c:v>
                </c:pt>
                <c:pt idx="249">
                  <c:v>40.843899999999998</c:v>
                </c:pt>
                <c:pt idx="250">
                  <c:v>40.977400000000003</c:v>
                </c:pt>
                <c:pt idx="251">
                  <c:v>41.110999999999997</c:v>
                </c:pt>
                <c:pt idx="252">
                  <c:v>41.241930000000004</c:v>
                </c:pt>
                <c:pt idx="253">
                  <c:v>41.372929999999997</c:v>
                </c:pt>
                <c:pt idx="254">
                  <c:v>41.50712</c:v>
                </c:pt>
                <c:pt idx="255">
                  <c:v>41.642200000000003</c:v>
                </c:pt>
                <c:pt idx="256">
                  <c:v>41.774389999999997</c:v>
                </c:pt>
                <c:pt idx="257">
                  <c:v>41.908000000000001</c:v>
                </c:pt>
                <c:pt idx="258">
                  <c:v>42.042079999999999</c:v>
                </c:pt>
                <c:pt idx="259">
                  <c:v>42.173920000000003</c:v>
                </c:pt>
                <c:pt idx="260">
                  <c:v>42.306950000000001</c:v>
                </c:pt>
                <c:pt idx="261">
                  <c:v>42.44191</c:v>
                </c:pt>
                <c:pt idx="262">
                  <c:v>42.575130000000001</c:v>
                </c:pt>
                <c:pt idx="263">
                  <c:v>42.708179999999999</c:v>
                </c:pt>
                <c:pt idx="264">
                  <c:v>42.840719999999997</c:v>
                </c:pt>
                <c:pt idx="265">
                  <c:v>42.974229999999999</c:v>
                </c:pt>
                <c:pt idx="266">
                  <c:v>43.108269999999997</c:v>
                </c:pt>
                <c:pt idx="267">
                  <c:v>43.241439999999997</c:v>
                </c:pt>
                <c:pt idx="268">
                  <c:v>43.376240000000003</c:v>
                </c:pt>
                <c:pt idx="269">
                  <c:v>43.510350000000003</c:v>
                </c:pt>
                <c:pt idx="270">
                  <c:v>43.641970000000001</c:v>
                </c:pt>
                <c:pt idx="271">
                  <c:v>43.77581</c:v>
                </c:pt>
                <c:pt idx="272">
                  <c:v>43.909050000000001</c:v>
                </c:pt>
                <c:pt idx="273">
                  <c:v>44.042479999999998</c:v>
                </c:pt>
                <c:pt idx="274">
                  <c:v>44.17548</c:v>
                </c:pt>
                <c:pt idx="275">
                  <c:v>44.310279999999999</c:v>
                </c:pt>
                <c:pt idx="276">
                  <c:v>44.443040000000003</c:v>
                </c:pt>
                <c:pt idx="277">
                  <c:v>44.575319999999998</c:v>
                </c:pt>
                <c:pt idx="278">
                  <c:v>44.710059999999999</c:v>
                </c:pt>
                <c:pt idx="279">
                  <c:v>44.843089999999997</c:v>
                </c:pt>
                <c:pt idx="280">
                  <c:v>44.975499999999997</c:v>
                </c:pt>
                <c:pt idx="281">
                  <c:v>45.107779999999998</c:v>
                </c:pt>
                <c:pt idx="282">
                  <c:v>45.23762</c:v>
                </c:pt>
                <c:pt idx="283">
                  <c:v>45.371380000000002</c:v>
                </c:pt>
                <c:pt idx="284">
                  <c:v>45.505220000000001</c:v>
                </c:pt>
                <c:pt idx="285">
                  <c:v>45.638910000000003</c:v>
                </c:pt>
                <c:pt idx="286">
                  <c:v>45.77084</c:v>
                </c:pt>
                <c:pt idx="287">
                  <c:v>45.903359999999999</c:v>
                </c:pt>
                <c:pt idx="288">
                  <c:v>46.038670000000003</c:v>
                </c:pt>
                <c:pt idx="289">
                  <c:v>46.170560000000002</c:v>
                </c:pt>
                <c:pt idx="290">
                  <c:v>46.304250000000003</c:v>
                </c:pt>
                <c:pt idx="291">
                  <c:v>46.438029999999998</c:v>
                </c:pt>
                <c:pt idx="292">
                  <c:v>46.572139999999997</c:v>
                </c:pt>
                <c:pt idx="293">
                  <c:v>46.706130000000002</c:v>
                </c:pt>
                <c:pt idx="294">
                  <c:v>46.839500000000001</c:v>
                </c:pt>
                <c:pt idx="295">
                  <c:v>46.97184</c:v>
                </c:pt>
                <c:pt idx="296">
                  <c:v>47.105699999999999</c:v>
                </c:pt>
                <c:pt idx="297">
                  <c:v>47.239620000000002</c:v>
                </c:pt>
                <c:pt idx="298">
                  <c:v>47.372729999999997</c:v>
                </c:pt>
                <c:pt idx="299">
                  <c:v>47.50723</c:v>
                </c:pt>
                <c:pt idx="300">
                  <c:v>47.63908</c:v>
                </c:pt>
                <c:pt idx="301">
                  <c:v>47.772930000000002</c:v>
                </c:pt>
                <c:pt idx="302">
                  <c:v>47.90605</c:v>
                </c:pt>
                <c:pt idx="303">
                  <c:v>48.038809999999998</c:v>
                </c:pt>
                <c:pt idx="304">
                  <c:v>48.17304</c:v>
                </c:pt>
                <c:pt idx="305">
                  <c:v>48.305799999999998</c:v>
                </c:pt>
                <c:pt idx="306">
                  <c:v>48.439909999999998</c:v>
                </c:pt>
                <c:pt idx="307">
                  <c:v>48.572789999999998</c:v>
                </c:pt>
                <c:pt idx="308">
                  <c:v>48.707450000000001</c:v>
                </c:pt>
                <c:pt idx="309">
                  <c:v>48.84102</c:v>
                </c:pt>
                <c:pt idx="310">
                  <c:v>48.97343</c:v>
                </c:pt>
                <c:pt idx="311">
                  <c:v>49.104700000000001</c:v>
                </c:pt>
                <c:pt idx="312">
                  <c:v>49.236800000000002</c:v>
                </c:pt>
                <c:pt idx="313">
                  <c:v>49.370629999999998</c:v>
                </c:pt>
                <c:pt idx="314">
                  <c:v>49.503660000000004</c:v>
                </c:pt>
                <c:pt idx="315">
                  <c:v>49.636029999999998</c:v>
                </c:pt>
                <c:pt idx="316">
                  <c:v>49.7712</c:v>
                </c:pt>
                <c:pt idx="317">
                  <c:v>49.904710000000001</c:v>
                </c:pt>
                <c:pt idx="318">
                  <c:v>50.036909999999999</c:v>
                </c:pt>
                <c:pt idx="319">
                  <c:v>50.170780000000001</c:v>
                </c:pt>
                <c:pt idx="320">
                  <c:v>50.305239999999998</c:v>
                </c:pt>
                <c:pt idx="321">
                  <c:v>50.437220000000003</c:v>
                </c:pt>
                <c:pt idx="322">
                  <c:v>50.570990000000002</c:v>
                </c:pt>
                <c:pt idx="323">
                  <c:v>50.70429</c:v>
                </c:pt>
                <c:pt idx="324">
                  <c:v>50.838230000000003</c:v>
                </c:pt>
                <c:pt idx="325">
                  <c:v>50.97137</c:v>
                </c:pt>
                <c:pt idx="326">
                  <c:v>51.105339999999998</c:v>
                </c:pt>
                <c:pt idx="327">
                  <c:v>51.238079999999997</c:v>
                </c:pt>
                <c:pt idx="328">
                  <c:v>51.371079999999999</c:v>
                </c:pt>
                <c:pt idx="329">
                  <c:v>51.504219999999997</c:v>
                </c:pt>
                <c:pt idx="330">
                  <c:v>51.637140000000002</c:v>
                </c:pt>
                <c:pt idx="331">
                  <c:v>51.770310000000002</c:v>
                </c:pt>
                <c:pt idx="332">
                  <c:v>51.90372</c:v>
                </c:pt>
                <c:pt idx="333">
                  <c:v>52.03745</c:v>
                </c:pt>
                <c:pt idx="334">
                  <c:v>52.17154</c:v>
                </c:pt>
                <c:pt idx="335">
                  <c:v>52.304499999999997</c:v>
                </c:pt>
                <c:pt idx="336">
                  <c:v>52.438809999999997</c:v>
                </c:pt>
                <c:pt idx="337">
                  <c:v>52.572380000000003</c:v>
                </c:pt>
                <c:pt idx="338">
                  <c:v>52.705219999999997</c:v>
                </c:pt>
                <c:pt idx="339">
                  <c:v>52.835790000000003</c:v>
                </c:pt>
                <c:pt idx="340">
                  <c:v>52.96631</c:v>
                </c:pt>
                <c:pt idx="341">
                  <c:v>53.09881</c:v>
                </c:pt>
                <c:pt idx="342">
                  <c:v>53.231670000000001</c:v>
                </c:pt>
                <c:pt idx="343">
                  <c:v>53.36739</c:v>
                </c:pt>
                <c:pt idx="344">
                  <c:v>53.49944</c:v>
                </c:pt>
                <c:pt idx="345">
                  <c:v>53.633949999999999</c:v>
                </c:pt>
                <c:pt idx="346">
                  <c:v>53.766570000000002</c:v>
                </c:pt>
                <c:pt idx="347">
                  <c:v>53.898260000000001</c:v>
                </c:pt>
                <c:pt idx="348">
                  <c:v>54.031019999999998</c:v>
                </c:pt>
                <c:pt idx="349">
                  <c:v>54.165559999999999</c:v>
                </c:pt>
                <c:pt idx="350">
                  <c:v>54.299169999999997</c:v>
                </c:pt>
                <c:pt idx="351">
                  <c:v>54.431710000000002</c:v>
                </c:pt>
                <c:pt idx="352">
                  <c:v>54.564869999999999</c:v>
                </c:pt>
                <c:pt idx="353">
                  <c:v>54.698399999999999</c:v>
                </c:pt>
                <c:pt idx="354">
                  <c:v>54.831940000000003</c:v>
                </c:pt>
                <c:pt idx="355">
                  <c:v>54.96611</c:v>
                </c:pt>
                <c:pt idx="356">
                  <c:v>55.099600000000002</c:v>
                </c:pt>
                <c:pt idx="357">
                  <c:v>55.232300000000002</c:v>
                </c:pt>
                <c:pt idx="358">
                  <c:v>55.365310000000001</c:v>
                </c:pt>
                <c:pt idx="359">
                  <c:v>55.498309999999996</c:v>
                </c:pt>
                <c:pt idx="360">
                  <c:v>55.631030000000003</c:v>
                </c:pt>
                <c:pt idx="361">
                  <c:v>55.765039999999999</c:v>
                </c:pt>
                <c:pt idx="362">
                  <c:v>55.898919999999997</c:v>
                </c:pt>
                <c:pt idx="363">
                  <c:v>56.031750000000002</c:v>
                </c:pt>
                <c:pt idx="364">
                  <c:v>56.165999999999997</c:v>
                </c:pt>
                <c:pt idx="365">
                  <c:v>56.299120000000002</c:v>
                </c:pt>
                <c:pt idx="366">
                  <c:v>56.431809999999999</c:v>
                </c:pt>
                <c:pt idx="367">
                  <c:v>56.566450000000003</c:v>
                </c:pt>
                <c:pt idx="368">
                  <c:v>56.697690000000001</c:v>
                </c:pt>
                <c:pt idx="369">
                  <c:v>56.830930000000002</c:v>
                </c:pt>
                <c:pt idx="370">
                  <c:v>56.963659999999997</c:v>
                </c:pt>
                <c:pt idx="371">
                  <c:v>57.0974</c:v>
                </c:pt>
                <c:pt idx="372">
                  <c:v>57.230730000000001</c:v>
                </c:pt>
                <c:pt idx="373">
                  <c:v>57.364260000000002</c:v>
                </c:pt>
                <c:pt idx="374">
                  <c:v>57.49774</c:v>
                </c:pt>
                <c:pt idx="375">
                  <c:v>57.630189999999999</c:v>
                </c:pt>
                <c:pt idx="376">
                  <c:v>57.762779999999999</c:v>
                </c:pt>
                <c:pt idx="377">
                  <c:v>57.89564</c:v>
                </c:pt>
                <c:pt idx="378">
                  <c:v>58.029670000000003</c:v>
                </c:pt>
                <c:pt idx="379">
                  <c:v>58.16234</c:v>
                </c:pt>
                <c:pt idx="380">
                  <c:v>58.294339999999998</c:v>
                </c:pt>
                <c:pt idx="381">
                  <c:v>58.428959999999996</c:v>
                </c:pt>
                <c:pt idx="382">
                  <c:v>58.561669999999999</c:v>
                </c:pt>
                <c:pt idx="383">
                  <c:v>58.695700000000002</c:v>
                </c:pt>
                <c:pt idx="384">
                  <c:v>58.830869999999997</c:v>
                </c:pt>
                <c:pt idx="385">
                  <c:v>58.963230000000003</c:v>
                </c:pt>
                <c:pt idx="386">
                  <c:v>59.095849999999999</c:v>
                </c:pt>
                <c:pt idx="387">
                  <c:v>59.229750000000003</c:v>
                </c:pt>
                <c:pt idx="388">
                  <c:v>59.362540000000003</c:v>
                </c:pt>
                <c:pt idx="389">
                  <c:v>59.496220000000001</c:v>
                </c:pt>
                <c:pt idx="390">
                  <c:v>59.628959999999999</c:v>
                </c:pt>
                <c:pt idx="391">
                  <c:v>59.762250000000002</c:v>
                </c:pt>
              </c:numCache>
            </c:numRef>
          </c:xVal>
          <c:yVal>
            <c:numRef>
              <c:f>Sheet1!$G$2:$G$394</c:f>
              <c:numCache>
                <c:formatCode>General</c:formatCode>
                <c:ptCount val="393"/>
                <c:pt idx="14" formatCode="0.00E+00">
                  <c:v>3.6702000000000002E-3</c:v>
                </c:pt>
                <c:pt idx="15" formatCode="0.00E+00">
                  <c:v>1.7359000000000001E-3</c:v>
                </c:pt>
                <c:pt idx="16" formatCode="0.00E+00">
                  <c:v>1.6612599999999999E-3</c:v>
                </c:pt>
                <c:pt idx="17" formatCode="0.00E+00">
                  <c:v>1.6268700000000001E-3</c:v>
                </c:pt>
                <c:pt idx="18" formatCode="0.00E+00">
                  <c:v>-1.77783E-3</c:v>
                </c:pt>
                <c:pt idx="19" formatCode="0.00E+00">
                  <c:v>-1.1739400000000001E-3</c:v>
                </c:pt>
                <c:pt idx="20" formatCode="0.00E+00">
                  <c:v>-1.9502499999999998E-4</c:v>
                </c:pt>
                <c:pt idx="21" formatCode="0.00E+00">
                  <c:v>1.3078200000000001E-3</c:v>
                </c:pt>
                <c:pt idx="22" formatCode="0.00E+00">
                  <c:v>-1.0485900000000001E-3</c:v>
                </c:pt>
                <c:pt idx="23" formatCode="0.00E+00">
                  <c:v>-8.9179200000000008E-4</c:v>
                </c:pt>
                <c:pt idx="24" formatCode="0.00E+00">
                  <c:v>6.1330599999999999E-4</c:v>
                </c:pt>
                <c:pt idx="25" formatCode="0.00E+00">
                  <c:v>2.49314E-3</c:v>
                </c:pt>
                <c:pt idx="26" formatCode="0.00E+00">
                  <c:v>2.9142400000000002E-3</c:v>
                </c:pt>
                <c:pt idx="27" formatCode="0.00E+00">
                  <c:v>3.0016400000000003E-3</c:v>
                </c:pt>
                <c:pt idx="28" formatCode="0.00E+00">
                  <c:v>8.8342300000000004E-4</c:v>
                </c:pt>
                <c:pt idx="29" formatCode="0.00E+00">
                  <c:v>1.2714899999999999E-3</c:v>
                </c:pt>
                <c:pt idx="30" formatCode="0.00E+00">
                  <c:v>6.317889999999999E-4</c:v>
                </c:pt>
                <c:pt idx="31" formatCode="0.00E+00">
                  <c:v>-1.66424E-4</c:v>
                </c:pt>
                <c:pt idx="32" formatCode="0.00E+00">
                  <c:v>-9.4661500000000004E-4</c:v>
                </c:pt>
                <c:pt idx="33" formatCode="0.00E+00">
                  <c:v>-2.6096399999999999E-3</c:v>
                </c:pt>
                <c:pt idx="34" formatCode="0.00E+00">
                  <c:v>-2.5762099999999998E-3</c:v>
                </c:pt>
                <c:pt idx="35" formatCode="0.00E+00">
                  <c:v>-2.1643499999999998E-3</c:v>
                </c:pt>
                <c:pt idx="36" formatCode="0.00E+00">
                  <c:v>-1.6360300000000001E-3</c:v>
                </c:pt>
                <c:pt idx="37" formatCode="0.00E+00">
                  <c:v>9.37583E-5</c:v>
                </c:pt>
                <c:pt idx="38" formatCode="0.00E+00">
                  <c:v>-3.4095200000000001E-3</c:v>
                </c:pt>
                <c:pt idx="39" formatCode="0.00E+00">
                  <c:v>-4.2601100000000001E-3</c:v>
                </c:pt>
                <c:pt idx="40" formatCode="0.00E+00">
                  <c:v>-1.5161599999999999E-3</c:v>
                </c:pt>
                <c:pt idx="41" formatCode="0.00E+00">
                  <c:v>-1.09355E-3</c:v>
                </c:pt>
                <c:pt idx="42" formatCode="0.00E+00">
                  <c:v>-2.1073999999999997E-3</c:v>
                </c:pt>
                <c:pt idx="43" formatCode="0.00E+00">
                  <c:v>-4.6372999999999996E-3</c:v>
                </c:pt>
                <c:pt idx="44" formatCode="0.00E+00">
                  <c:v>-5.0290500000000002E-3</c:v>
                </c:pt>
                <c:pt idx="45" formatCode="0.00E+00">
                  <c:v>-2.8421199999999996E-3</c:v>
                </c:pt>
                <c:pt idx="46" formatCode="0.00E+00">
                  <c:v>-3.7270200000000002E-3</c:v>
                </c:pt>
                <c:pt idx="47" formatCode="0.00E+00">
                  <c:v>-1.6596699999999999E-4</c:v>
                </c:pt>
                <c:pt idx="48" formatCode="0.00E+00">
                  <c:v>3.7806700000000003E-3</c:v>
                </c:pt>
                <c:pt idx="49" formatCode="0.00E+00">
                  <c:v>1.48212E-3</c:v>
                </c:pt>
                <c:pt idx="50" formatCode="0.00E+00">
                  <c:v>-1.3874999999999998E-3</c:v>
                </c:pt>
                <c:pt idx="51" formatCode="0.00E+00">
                  <c:v>2.0413199999999999E-4</c:v>
                </c:pt>
                <c:pt idx="52" formatCode="0.00E+00">
                  <c:v>2.7334199999999999E-3</c:v>
                </c:pt>
                <c:pt idx="53" formatCode="0.00E+00">
                  <c:v>4.1772900000000002E-3</c:v>
                </c:pt>
                <c:pt idx="54" formatCode="0.00E+00">
                  <c:v>5.0956999999999999E-4</c:v>
                </c:pt>
                <c:pt idx="55" formatCode="0.00E+00">
                  <c:v>1.7714299999999998E-3</c:v>
                </c:pt>
                <c:pt idx="56" formatCode="0.00E+00">
                  <c:v>1.4406599999999999E-3</c:v>
                </c:pt>
                <c:pt idx="57" formatCode="0.00E+00">
                  <c:v>4.23472E-3</c:v>
                </c:pt>
                <c:pt idx="58" formatCode="0.00E+00">
                  <c:v>3.19068E-3</c:v>
                </c:pt>
                <c:pt idx="59" formatCode="0.00E+00">
                  <c:v>-1.6201899999999999E-3</c:v>
                </c:pt>
                <c:pt idx="60" formatCode="0.00E+00">
                  <c:v>1.38495E-3</c:v>
                </c:pt>
                <c:pt idx="61" formatCode="0.00E+00">
                  <c:v>5.1952200000000004E-3</c:v>
                </c:pt>
                <c:pt idx="62" formatCode="0.00E+00">
                  <c:v>6.2274800000000005E-3</c:v>
                </c:pt>
                <c:pt idx="63" formatCode="0.00E+00">
                  <c:v>6.4648600000000002E-3</c:v>
                </c:pt>
                <c:pt idx="64" formatCode="0.00E+00">
                  <c:v>8.2870500000000007E-3</c:v>
                </c:pt>
                <c:pt idx="65" formatCode="0.00E+00">
                  <c:v>1.0023799999999999E-2</c:v>
                </c:pt>
                <c:pt idx="66" formatCode="0.00E+00">
                  <c:v>1.31176E-2</c:v>
                </c:pt>
                <c:pt idx="67" formatCode="0.00E+00">
                  <c:v>1.3515900000000001E-2</c:v>
                </c:pt>
                <c:pt idx="68" formatCode="0.00E+00">
                  <c:v>1.4939800000000001E-2</c:v>
                </c:pt>
                <c:pt idx="69" formatCode="0.00E+00">
                  <c:v>1.79461E-2</c:v>
                </c:pt>
                <c:pt idx="70" formatCode="0.00E+00">
                  <c:v>1.9224399999999999E-2</c:v>
                </c:pt>
                <c:pt idx="71" formatCode="0.00E+00">
                  <c:v>1.6447900000000001E-2</c:v>
                </c:pt>
                <c:pt idx="72" formatCode="0.00E+00">
                  <c:v>1.6045400000000001E-2</c:v>
                </c:pt>
                <c:pt idx="73" formatCode="0.00E+00">
                  <c:v>1.6728699999999999E-2</c:v>
                </c:pt>
                <c:pt idx="74" formatCode="0.00E+00">
                  <c:v>1.5753899999999998E-2</c:v>
                </c:pt>
                <c:pt idx="75" formatCode="0.00E+00">
                  <c:v>1.4831400000000002E-2</c:v>
                </c:pt>
                <c:pt idx="76" formatCode="0.00E+00">
                  <c:v>1.7314E-2</c:v>
                </c:pt>
                <c:pt idx="77" formatCode="0.00E+00">
                  <c:v>1.71451E-2</c:v>
                </c:pt>
                <c:pt idx="78" formatCode="0.00E+00">
                  <c:v>1.6737700000000001E-2</c:v>
                </c:pt>
                <c:pt idx="79" formatCode="0.00E+00">
                  <c:v>1.8366999999999998E-2</c:v>
                </c:pt>
                <c:pt idx="80" formatCode="0.00E+00">
                  <c:v>2.2684099999999999E-2</c:v>
                </c:pt>
                <c:pt idx="81" formatCode="0.00E+00">
                  <c:v>2.2918400000000002E-2</c:v>
                </c:pt>
                <c:pt idx="82" formatCode="0.00E+00">
                  <c:v>2.4072800000000002E-2</c:v>
                </c:pt>
                <c:pt idx="83" formatCode="0.00E+00">
                  <c:v>2.30929E-2</c:v>
                </c:pt>
                <c:pt idx="84" formatCode="0.00E+00">
                  <c:v>2.3195399999999998E-2</c:v>
                </c:pt>
                <c:pt idx="85" formatCode="0.00E+00">
                  <c:v>2.4210799999999998E-2</c:v>
                </c:pt>
                <c:pt idx="86" formatCode="0.00E+00">
                  <c:v>2.5910599999999999E-2</c:v>
                </c:pt>
                <c:pt idx="87" formatCode="0.00E+00">
                  <c:v>2.5205399999999999E-2</c:v>
                </c:pt>
                <c:pt idx="88" formatCode="0.00E+00">
                  <c:v>2.3555099999999999E-2</c:v>
                </c:pt>
                <c:pt idx="89" formatCode="0.00E+00">
                  <c:v>1.7786099999999999E-2</c:v>
                </c:pt>
                <c:pt idx="90" formatCode="0.00E+00">
                  <c:v>2.1439799999999998E-2</c:v>
                </c:pt>
                <c:pt idx="91" formatCode="0.00E+00">
                  <c:v>2.42443E-2</c:v>
                </c:pt>
                <c:pt idx="92" formatCode="0.00E+00">
                  <c:v>2.5356299999999998E-2</c:v>
                </c:pt>
                <c:pt idx="93" formatCode="0.00E+00">
                  <c:v>2.3649099999999999E-2</c:v>
                </c:pt>
                <c:pt idx="94" formatCode="0.00E+00">
                  <c:v>2.2555100000000002E-2</c:v>
                </c:pt>
                <c:pt idx="95" formatCode="0.00E+00">
                  <c:v>2.3742099999999999E-2</c:v>
                </c:pt>
                <c:pt idx="96" formatCode="0.00E+00">
                  <c:v>2.4918300000000001E-2</c:v>
                </c:pt>
                <c:pt idx="97" formatCode="0.00E+00">
                  <c:v>2.6801099999999998E-2</c:v>
                </c:pt>
                <c:pt idx="98" formatCode="0.00E+00">
                  <c:v>2.9803699999999999E-2</c:v>
                </c:pt>
                <c:pt idx="99" formatCode="0.00E+00">
                  <c:v>2.8801900000000002E-2</c:v>
                </c:pt>
                <c:pt idx="100" formatCode="0.00E+00">
                  <c:v>2.69632E-2</c:v>
                </c:pt>
                <c:pt idx="101" formatCode="0.00E+00">
                  <c:v>2.5963699999999999E-2</c:v>
                </c:pt>
                <c:pt idx="102" formatCode="0.00E+00">
                  <c:v>2.6049900000000001E-2</c:v>
                </c:pt>
                <c:pt idx="103" formatCode="0.00E+00">
                  <c:v>2.83542E-2</c:v>
                </c:pt>
                <c:pt idx="104" formatCode="0.00E+00">
                  <c:v>2.8920099999999997E-2</c:v>
                </c:pt>
                <c:pt idx="105" formatCode="0.00E+00">
                  <c:v>3.1734600000000002E-2</c:v>
                </c:pt>
                <c:pt idx="106" formatCode="0.00E+00">
                  <c:v>2.9331400000000001E-2</c:v>
                </c:pt>
                <c:pt idx="107" formatCode="0.00E+00">
                  <c:v>2.3029999999999998E-2</c:v>
                </c:pt>
                <c:pt idx="108" formatCode="0.00E+00">
                  <c:v>2.31962E-2</c:v>
                </c:pt>
                <c:pt idx="109" formatCode="0.00E+00">
                  <c:v>2.4432199999999998E-2</c:v>
                </c:pt>
                <c:pt idx="110" formatCode="0.00E+00">
                  <c:v>2.5628100000000001E-2</c:v>
                </c:pt>
                <c:pt idx="111" formatCode="0.00E+00">
                  <c:v>2.6799700000000003E-2</c:v>
                </c:pt>
                <c:pt idx="112" formatCode="0.00E+00">
                  <c:v>2.8991200000000002E-2</c:v>
                </c:pt>
                <c:pt idx="113" formatCode="0.00E+00">
                  <c:v>2.9991499999999997E-2</c:v>
                </c:pt>
                <c:pt idx="114" formatCode="0.00E+00">
                  <c:v>3.1298800000000002E-2</c:v>
                </c:pt>
                <c:pt idx="115" formatCode="0.00E+00">
                  <c:v>3.4326099999999998E-2</c:v>
                </c:pt>
                <c:pt idx="116" formatCode="0.00E+00">
                  <c:v>3.4232600000000002E-2</c:v>
                </c:pt>
                <c:pt idx="117" formatCode="0.00E+00">
                  <c:v>3.4913699999999999E-2</c:v>
                </c:pt>
                <c:pt idx="118" formatCode="0.00E+00">
                  <c:v>3.6033099999999998E-2</c:v>
                </c:pt>
                <c:pt idx="119" formatCode="0.00E+00">
                  <c:v>3.4480899999999995E-2</c:v>
                </c:pt>
                <c:pt idx="120" formatCode="0.00E+00">
                  <c:v>3.4259699999999997E-2</c:v>
                </c:pt>
                <c:pt idx="121" formatCode="0.00E+00">
                  <c:v>3.5639200000000003E-2</c:v>
                </c:pt>
                <c:pt idx="122" formatCode="0.00E+00">
                  <c:v>3.6566500000000002E-2</c:v>
                </c:pt>
                <c:pt idx="123" formatCode="0.00E+00">
                  <c:v>3.7266899999999999E-2</c:v>
                </c:pt>
                <c:pt idx="124" formatCode="0.00E+00">
                  <c:v>3.7151499999999997E-2</c:v>
                </c:pt>
                <c:pt idx="125" formatCode="0.00E+00">
                  <c:v>3.6519700000000002E-2</c:v>
                </c:pt>
                <c:pt idx="126" formatCode="0.00E+00">
                  <c:v>4.0742800000000003E-2</c:v>
                </c:pt>
                <c:pt idx="127" formatCode="0.00E+00">
                  <c:v>4.91276E-2</c:v>
                </c:pt>
                <c:pt idx="128" formatCode="0.00E+00">
                  <c:v>5.5474100000000005E-2</c:v>
                </c:pt>
                <c:pt idx="129" formatCode="0.00E+00">
                  <c:v>5.5757800000000003E-2</c:v>
                </c:pt>
                <c:pt idx="130" formatCode="0.00E+00">
                  <c:v>5.0788699999999999E-2</c:v>
                </c:pt>
                <c:pt idx="131" formatCode="0.00E+00">
                  <c:v>4.7987700000000001E-2</c:v>
                </c:pt>
                <c:pt idx="132" formatCode="0.00E+00">
                  <c:v>4.1938799999999998E-2</c:v>
                </c:pt>
                <c:pt idx="133" formatCode="0.00E+00">
                  <c:v>3.7692999999999997E-2</c:v>
                </c:pt>
                <c:pt idx="134" formatCode="0.00E+00">
                  <c:v>4.4217800000000002E-2</c:v>
                </c:pt>
                <c:pt idx="135" formatCode="0.00E+00">
                  <c:v>4.84529E-2</c:v>
                </c:pt>
                <c:pt idx="136" formatCode="0.00E+00">
                  <c:v>5.0434800000000002E-2</c:v>
                </c:pt>
                <c:pt idx="137" formatCode="0.00E+00">
                  <c:v>5.4270900000000004E-2</c:v>
                </c:pt>
                <c:pt idx="138" formatCode="0.00E+00">
                  <c:v>5.425E-2</c:v>
                </c:pt>
                <c:pt idx="139" formatCode="0.00E+00">
                  <c:v>5.5818399999999997E-2</c:v>
                </c:pt>
                <c:pt idx="140" formatCode="0.00E+00">
                  <c:v>5.2224399999999997E-2</c:v>
                </c:pt>
                <c:pt idx="141" formatCode="0.00E+00">
                  <c:v>5.2316000000000001E-2</c:v>
                </c:pt>
                <c:pt idx="142" formatCode="0.00E+00">
                  <c:v>5.8070599999999993E-2</c:v>
                </c:pt>
                <c:pt idx="143" formatCode="0.00E+00">
                  <c:v>6.2601299999999999E-2</c:v>
                </c:pt>
                <c:pt idx="144" formatCode="0.00E+00">
                  <c:v>6.0063000000000005E-2</c:v>
                </c:pt>
                <c:pt idx="145" formatCode="0.00E+00">
                  <c:v>5.92443E-2</c:v>
                </c:pt>
                <c:pt idx="146" formatCode="0.00E+00">
                  <c:v>6.1902399999999996E-2</c:v>
                </c:pt>
                <c:pt idx="147" formatCode="0.00E+00">
                  <c:v>6.0829800000000003E-2</c:v>
                </c:pt>
                <c:pt idx="148" formatCode="0.00E+00">
                  <c:v>6.5218499999999999E-2</c:v>
                </c:pt>
                <c:pt idx="149" formatCode="0.00E+00">
                  <c:v>7.0374199999999998E-2</c:v>
                </c:pt>
                <c:pt idx="150" formatCode="0.00E+00">
                  <c:v>7.0753099999999999E-2</c:v>
                </c:pt>
                <c:pt idx="151" formatCode="0.00E+00">
                  <c:v>6.8488999999999994E-2</c:v>
                </c:pt>
                <c:pt idx="152" formatCode="0.00E+00">
                  <c:v>6.9432800000000003E-2</c:v>
                </c:pt>
                <c:pt idx="153" formatCode="0.00E+00">
                  <c:v>7.3093599999999995E-2</c:v>
                </c:pt>
                <c:pt idx="154" formatCode="0.00E+00">
                  <c:v>7.5039399999999992E-2</c:v>
                </c:pt>
                <c:pt idx="155" formatCode="0.00E+00">
                  <c:v>7.3632400000000001E-2</c:v>
                </c:pt>
                <c:pt idx="156" formatCode="0.00E+00">
                  <c:v>7.5796500000000003E-2</c:v>
                </c:pt>
                <c:pt idx="157" formatCode="0.00E+00">
                  <c:v>8.3264099999999994E-2</c:v>
                </c:pt>
                <c:pt idx="158" formatCode="0.00E+00">
                  <c:v>8.3801199999999992E-2</c:v>
                </c:pt>
                <c:pt idx="159" formatCode="0.00E+00">
                  <c:v>8.5261100000000006E-2</c:v>
                </c:pt>
                <c:pt idx="160" formatCode="0.00E+00">
                  <c:v>8.7606599999999993E-2</c:v>
                </c:pt>
                <c:pt idx="161" formatCode="0.00E+00">
                  <c:v>8.6124800000000001E-2</c:v>
                </c:pt>
                <c:pt idx="162" formatCode="0.00E+00">
                  <c:v>8.7016399999999994E-2</c:v>
                </c:pt>
                <c:pt idx="163" formatCode="0.00E+00">
                  <c:v>9.0194799999999992E-2</c:v>
                </c:pt>
                <c:pt idx="164" formatCode="0.00E+00">
                  <c:v>9.0760800000000003E-2</c:v>
                </c:pt>
                <c:pt idx="165" formatCode="0.00E+00">
                  <c:v>9.1712100000000005E-2</c:v>
                </c:pt>
                <c:pt idx="166" formatCode="0.00E+00">
                  <c:v>9.3646599999999997E-2</c:v>
                </c:pt>
                <c:pt idx="167" formatCode="0.00E+00">
                  <c:v>9.8554299999999997E-2</c:v>
                </c:pt>
                <c:pt idx="168" formatCode="0.00E+00">
                  <c:v>0.100374</c:v>
                </c:pt>
                <c:pt idx="169" formatCode="0.00E+00">
                  <c:v>9.9565500000000001E-2</c:v>
                </c:pt>
                <c:pt idx="170" formatCode="0.00E+00">
                  <c:v>0.100632</c:v>
                </c:pt>
                <c:pt idx="171" formatCode="0.00E+00">
                  <c:v>0.10383100000000001</c:v>
                </c:pt>
                <c:pt idx="172" formatCode="0.00E+00">
                  <c:v>9.9754099999999998E-2</c:v>
                </c:pt>
                <c:pt idx="173" formatCode="0.00E+00">
                  <c:v>0.10215500000000001</c:v>
                </c:pt>
                <c:pt idx="174" formatCode="0.00E+00">
                  <c:v>0.10397899999999999</c:v>
                </c:pt>
                <c:pt idx="175" formatCode="0.00E+00">
                  <c:v>0.10251800000000001</c:v>
                </c:pt>
                <c:pt idx="176" formatCode="0.00E+00">
                  <c:v>0.103558</c:v>
                </c:pt>
                <c:pt idx="177" formatCode="0.00E+00">
                  <c:v>0.10637300000000001</c:v>
                </c:pt>
                <c:pt idx="178" formatCode="0.00E+00">
                  <c:v>0.110276</c:v>
                </c:pt>
                <c:pt idx="179" formatCode="0.00E+00">
                  <c:v>0.11137</c:v>
                </c:pt>
                <c:pt idx="180" formatCode="0.00E+00">
                  <c:v>0.10707799999999999</c:v>
                </c:pt>
                <c:pt idx="181" formatCode="0.00E+00">
                  <c:v>0.106071</c:v>
                </c:pt>
                <c:pt idx="182" formatCode="0.00E+00">
                  <c:v>0.103419</c:v>
                </c:pt>
                <c:pt idx="183" formatCode="0.00E+00">
                  <c:v>0.10381600000000001</c:v>
                </c:pt>
                <c:pt idx="184" formatCode="0.00E+00">
                  <c:v>0.102687</c:v>
                </c:pt>
                <c:pt idx="185" formatCode="0.00E+00">
                  <c:v>0.10091900000000001</c:v>
                </c:pt>
                <c:pt idx="186" formatCode="0.00E+00">
                  <c:v>0.101378</c:v>
                </c:pt>
                <c:pt idx="187" formatCode="0.00E+00">
                  <c:v>0.105434</c:v>
                </c:pt>
                <c:pt idx="188" formatCode="0.00E+00">
                  <c:v>0.100534</c:v>
                </c:pt>
                <c:pt idx="189" formatCode="0.00E+00">
                  <c:v>0.10286699999999999</c:v>
                </c:pt>
                <c:pt idx="190" formatCode="0.00E+00">
                  <c:v>0.10787200000000001</c:v>
                </c:pt>
                <c:pt idx="191" formatCode="0.00E+00">
                  <c:v>0.109445</c:v>
                </c:pt>
                <c:pt idx="192" formatCode="0.00E+00">
                  <c:v>0.110888</c:v>
                </c:pt>
                <c:pt idx="193" formatCode="0.00E+00">
                  <c:v>0.1149</c:v>
                </c:pt>
                <c:pt idx="194" formatCode="0.00E+00">
                  <c:v>0.11809</c:v>
                </c:pt>
                <c:pt idx="195" formatCode="0.00E+00">
                  <c:v>0.11661299999999999</c:v>
                </c:pt>
                <c:pt idx="196" formatCode="0.00E+00">
                  <c:v>0.12176100000000001</c:v>
                </c:pt>
                <c:pt idx="197" formatCode="0.00E+00">
                  <c:v>0.12595600000000001</c:v>
                </c:pt>
                <c:pt idx="198" formatCode="0.00E+00">
                  <c:v>0.12586600000000001</c:v>
                </c:pt>
                <c:pt idx="199" formatCode="0.00E+00">
                  <c:v>0.132717</c:v>
                </c:pt>
                <c:pt idx="200" formatCode="0.00E+00">
                  <c:v>0.139015</c:v>
                </c:pt>
                <c:pt idx="201" formatCode="0.00E+00">
                  <c:v>0.139039</c:v>
                </c:pt>
                <c:pt idx="202" formatCode="0.00E+00">
                  <c:v>0.14200199999999999</c:v>
                </c:pt>
                <c:pt idx="203" formatCode="0.00E+00">
                  <c:v>0.14438000000000001</c:v>
                </c:pt>
                <c:pt idx="204" formatCode="0.00E+00">
                  <c:v>0.14588599999999999</c:v>
                </c:pt>
                <c:pt idx="205" formatCode="0.00E+00">
                  <c:v>0.14685899999999999</c:v>
                </c:pt>
                <c:pt idx="206" formatCode="0.00E+00">
                  <c:v>0.147872</c:v>
                </c:pt>
                <c:pt idx="207" formatCode="0.00E+00">
                  <c:v>0.14976600000000001</c:v>
                </c:pt>
                <c:pt idx="208" formatCode="0.00E+00">
                  <c:v>0.152554</c:v>
                </c:pt>
                <c:pt idx="209" formatCode="0.00E+00">
                  <c:v>0.15689900000000001</c:v>
                </c:pt>
                <c:pt idx="210" formatCode="0.00E+00">
                  <c:v>0.159362</c:v>
                </c:pt>
                <c:pt idx="211" formatCode="0.00E+00">
                  <c:v>0.16390000000000002</c:v>
                </c:pt>
                <c:pt idx="212" formatCode="0.00E+00">
                  <c:v>0.16841100000000001</c:v>
                </c:pt>
                <c:pt idx="213" formatCode="0.00E+00">
                  <c:v>0.16900000000000001</c:v>
                </c:pt>
                <c:pt idx="214" formatCode="0.00E+00">
                  <c:v>0.169714</c:v>
                </c:pt>
                <c:pt idx="215" formatCode="0.00E+00">
                  <c:v>0.171962</c:v>
                </c:pt>
                <c:pt idx="216" formatCode="0.00E+00">
                  <c:v>0.170459</c:v>
                </c:pt>
                <c:pt idx="217" formatCode="0.00E+00">
                  <c:v>0.17422200000000002</c:v>
                </c:pt>
                <c:pt idx="218" formatCode="0.00E+00">
                  <c:v>0.172764</c:v>
                </c:pt>
                <c:pt idx="219" formatCode="0.00E+00">
                  <c:v>0.17055499999999998</c:v>
                </c:pt>
                <c:pt idx="220" formatCode="0.00E+00">
                  <c:v>0.17231199999999999</c:v>
                </c:pt>
                <c:pt idx="221" formatCode="0.00E+00">
                  <c:v>0.17700500000000002</c:v>
                </c:pt>
                <c:pt idx="222" formatCode="0.00E+00">
                  <c:v>0.17801900000000001</c:v>
                </c:pt>
                <c:pt idx="223" formatCode="0.00E+00">
                  <c:v>0.17922199999999999</c:v>
                </c:pt>
                <c:pt idx="224" formatCode="0.00E+00">
                  <c:v>0.18209800000000001</c:v>
                </c:pt>
                <c:pt idx="225" formatCode="0.00E+00">
                  <c:v>0.18499200000000002</c:v>
                </c:pt>
                <c:pt idx="226" formatCode="0.00E+00">
                  <c:v>0.18938400000000002</c:v>
                </c:pt>
                <c:pt idx="227" formatCode="0.00E+00">
                  <c:v>0.19295100000000001</c:v>
                </c:pt>
                <c:pt idx="228" formatCode="0.00E+00">
                  <c:v>0.19406200000000001</c:v>
                </c:pt>
                <c:pt idx="229" formatCode="0.00E+00">
                  <c:v>0.19622400000000001</c:v>
                </c:pt>
                <c:pt idx="230" formatCode="0.00E+00">
                  <c:v>0.19882</c:v>
                </c:pt>
                <c:pt idx="231" formatCode="0.00E+00">
                  <c:v>0.19714799999999999</c:v>
                </c:pt>
                <c:pt idx="232" formatCode="0.00E+00">
                  <c:v>0.19892199999999999</c:v>
                </c:pt>
                <c:pt idx="233" formatCode="0.00E+00">
                  <c:v>0.200879</c:v>
                </c:pt>
                <c:pt idx="234" formatCode="0.00E+00">
                  <c:v>0.20104</c:v>
                </c:pt>
                <c:pt idx="235" formatCode="0.00E+00">
                  <c:v>0.20397599999999999</c:v>
                </c:pt>
                <c:pt idx="236" formatCode="0.00E+00">
                  <c:v>0.20489600000000002</c:v>
                </c:pt>
                <c:pt idx="237" formatCode="0.00E+00">
                  <c:v>0.206979</c:v>
                </c:pt>
                <c:pt idx="238" formatCode="0.00E+00">
                  <c:v>0.210976</c:v>
                </c:pt>
                <c:pt idx="239" formatCode="0.00E+00">
                  <c:v>0.213029</c:v>
                </c:pt>
                <c:pt idx="240" formatCode="0.00E+00">
                  <c:v>0.21154299999999998</c:v>
                </c:pt>
                <c:pt idx="241" formatCode="0.00E+00">
                  <c:v>0.21437499999999998</c:v>
                </c:pt>
                <c:pt idx="242" formatCode="0.00E+00">
                  <c:v>0.21693799999999999</c:v>
                </c:pt>
                <c:pt idx="243" formatCode="0.00E+00">
                  <c:v>0.219809</c:v>
                </c:pt>
                <c:pt idx="244" formatCode="0.00E+00">
                  <c:v>0.22394800000000001</c:v>
                </c:pt>
                <c:pt idx="245" formatCode="0.00E+00">
                  <c:v>0.224551</c:v>
                </c:pt>
                <c:pt idx="246" formatCode="0.00E+00">
                  <c:v>0.22803899999999999</c:v>
                </c:pt>
                <c:pt idx="247" formatCode="0.00E+00">
                  <c:v>0.230328</c:v>
                </c:pt>
                <c:pt idx="248" formatCode="0.00E+00">
                  <c:v>0.231659</c:v>
                </c:pt>
                <c:pt idx="249" formatCode="0.00E+00">
                  <c:v>0.23239699999999999</c:v>
                </c:pt>
                <c:pt idx="250" formatCode="0.00E+00">
                  <c:v>0.23694699999999999</c:v>
                </c:pt>
                <c:pt idx="251" formatCode="0.00E+00">
                  <c:v>0.23780099999999998</c:v>
                </c:pt>
                <c:pt idx="252" formatCode="0.00E+00">
                  <c:v>0.24015</c:v>
                </c:pt>
                <c:pt idx="253" formatCode="0.00E+00">
                  <c:v>0.24018</c:v>
                </c:pt>
                <c:pt idx="254" formatCode="0.00E+00">
                  <c:v>0.23924300000000001</c:v>
                </c:pt>
                <c:pt idx="255" formatCode="0.00E+00">
                  <c:v>0.241425</c:v>
                </c:pt>
                <c:pt idx="256" formatCode="0.00E+00">
                  <c:v>0.24147000000000002</c:v>
                </c:pt>
                <c:pt idx="257" formatCode="0.00E+00">
                  <c:v>0.24570500000000001</c:v>
                </c:pt>
                <c:pt idx="258" formatCode="0.00E+00">
                  <c:v>0.25084699999999999</c:v>
                </c:pt>
                <c:pt idx="259" formatCode="0.00E+00">
                  <c:v>0.25132700000000002</c:v>
                </c:pt>
                <c:pt idx="260" formatCode="0.00E+00">
                  <c:v>0.251612</c:v>
                </c:pt>
                <c:pt idx="261" formatCode="0.00E+00">
                  <c:v>0.25663399999999997</c:v>
                </c:pt>
                <c:pt idx="262" formatCode="0.00E+00">
                  <c:v>0.26041200000000003</c:v>
                </c:pt>
                <c:pt idx="263" formatCode="0.00E+00">
                  <c:v>0.26758999999999999</c:v>
                </c:pt>
                <c:pt idx="264" formatCode="0.00E+00">
                  <c:v>0.27057300000000001</c:v>
                </c:pt>
                <c:pt idx="265" formatCode="0.00E+00">
                  <c:v>0.27435199999999998</c:v>
                </c:pt>
                <c:pt idx="266" formatCode="0.00E+00">
                  <c:v>0.28185199999999999</c:v>
                </c:pt>
                <c:pt idx="267" formatCode="0.00E+00">
                  <c:v>0.28234700000000001</c:v>
                </c:pt>
                <c:pt idx="268" formatCode="0.00E+00">
                  <c:v>0.28430699999999998</c:v>
                </c:pt>
                <c:pt idx="269" formatCode="0.00E+00">
                  <c:v>0.28636899999999998</c:v>
                </c:pt>
                <c:pt idx="270" formatCode="0.00E+00">
                  <c:v>0.28682799999999997</c:v>
                </c:pt>
                <c:pt idx="271" formatCode="0.00E+00">
                  <c:v>0.29055799999999998</c:v>
                </c:pt>
                <c:pt idx="272" formatCode="0.00E+00">
                  <c:v>0.29071200000000003</c:v>
                </c:pt>
                <c:pt idx="273" formatCode="0.00E+00">
                  <c:v>0.29151100000000002</c:v>
                </c:pt>
                <c:pt idx="274" formatCode="0.00E+00">
                  <c:v>0.29677200000000004</c:v>
                </c:pt>
                <c:pt idx="275" formatCode="0.00E+00">
                  <c:v>0.296373</c:v>
                </c:pt>
                <c:pt idx="276" formatCode="0.00E+00">
                  <c:v>0.29431999999999997</c:v>
                </c:pt>
                <c:pt idx="277" formatCode="0.00E+00">
                  <c:v>0.29654999999999998</c:v>
                </c:pt>
                <c:pt idx="278" formatCode="0.00E+00">
                  <c:v>0.29331200000000002</c:v>
                </c:pt>
                <c:pt idx="279" formatCode="0.00E+00">
                  <c:v>0.29573700000000003</c:v>
                </c:pt>
                <c:pt idx="280" formatCode="0.00E+00">
                  <c:v>0.294796</c:v>
                </c:pt>
                <c:pt idx="281" formatCode="0.00E+00">
                  <c:v>0.29402200000000001</c:v>
                </c:pt>
                <c:pt idx="282" formatCode="0.00E+00">
                  <c:v>0.29084199999999999</c:v>
                </c:pt>
                <c:pt idx="283" formatCode="0.00E+00">
                  <c:v>0.28515699999999999</c:v>
                </c:pt>
                <c:pt idx="284" formatCode="0.00E+00">
                  <c:v>0.27650000000000002</c:v>
                </c:pt>
                <c:pt idx="285" formatCode="0.00E+00">
                  <c:v>0.27117999999999998</c:v>
                </c:pt>
                <c:pt idx="286" formatCode="0.00E+00">
                  <c:v>0.26527200000000001</c:v>
                </c:pt>
                <c:pt idx="287" formatCode="0.00E+00">
                  <c:v>0.25756099999999998</c:v>
                </c:pt>
                <c:pt idx="288" formatCode="0.00E+00">
                  <c:v>0.24851200000000001</c:v>
                </c:pt>
                <c:pt idx="289" formatCode="0.00E+00">
                  <c:v>0.239209</c:v>
                </c:pt>
                <c:pt idx="290" formatCode="0.00E+00">
                  <c:v>0.228487</c:v>
                </c:pt>
                <c:pt idx="291" formatCode="0.00E+00">
                  <c:v>0.21964700000000001</c:v>
                </c:pt>
                <c:pt idx="292" formatCode="0.00E+00">
                  <c:v>0.207373</c:v>
                </c:pt>
                <c:pt idx="293" formatCode="0.00E+00">
                  <c:v>0.19955000000000001</c:v>
                </c:pt>
                <c:pt idx="294" formatCode="0.00E+00">
                  <c:v>0.18622</c:v>
                </c:pt>
                <c:pt idx="295" formatCode="0.00E+00">
                  <c:v>0.17414299999999999</c:v>
                </c:pt>
                <c:pt idx="296" formatCode="0.00E+00">
                  <c:v>0.162269</c:v>
                </c:pt>
                <c:pt idx="297" formatCode="0.00E+00">
                  <c:v>0.148592</c:v>
                </c:pt>
                <c:pt idx="298" formatCode="0.00E+00">
                  <c:v>0.136347</c:v>
                </c:pt>
                <c:pt idx="299" formatCode="0.00E+00">
                  <c:v>0.12268</c:v>
                </c:pt>
                <c:pt idx="300" formatCode="0.00E+00">
                  <c:v>0.11369000000000001</c:v>
                </c:pt>
                <c:pt idx="301" formatCode="0.00E+00">
                  <c:v>0.101187</c:v>
                </c:pt>
                <c:pt idx="302" formatCode="0.00E+00">
                  <c:v>8.9284700000000009E-2</c:v>
                </c:pt>
                <c:pt idx="303" formatCode="0.00E+00">
                  <c:v>7.8303399999999995E-2</c:v>
                </c:pt>
                <c:pt idx="304" formatCode="0.00E+00">
                  <c:v>7.0870900000000001E-2</c:v>
                </c:pt>
                <c:pt idx="305" formatCode="0.00E+00">
                  <c:v>6.18352E-2</c:v>
                </c:pt>
                <c:pt idx="306" formatCode="0.00E+00">
                  <c:v>5.5413800000000006E-2</c:v>
                </c:pt>
                <c:pt idx="307" formatCode="0.00E+00">
                  <c:v>5.1972300000000006E-2</c:v>
                </c:pt>
                <c:pt idx="308" formatCode="0.00E+00">
                  <c:v>4.5671800000000005E-2</c:v>
                </c:pt>
                <c:pt idx="309" formatCode="0.00E+00">
                  <c:v>3.7233099999999998E-2</c:v>
                </c:pt>
                <c:pt idx="310" formatCode="0.00E+00">
                  <c:v>3.3211899999999996E-2</c:v>
                </c:pt>
                <c:pt idx="311" formatCode="0.00E+00">
                  <c:v>2.6863500000000002E-2</c:v>
                </c:pt>
                <c:pt idx="312" formatCode="0.00E+00">
                  <c:v>2.4922200000000002E-2</c:v>
                </c:pt>
                <c:pt idx="313" formatCode="0.00E+00">
                  <c:v>2.3048400000000004E-2</c:v>
                </c:pt>
                <c:pt idx="314" formatCode="0.00E+00">
                  <c:v>1.86044E-2</c:v>
                </c:pt>
                <c:pt idx="315" formatCode="0.00E+00">
                  <c:v>1.87634E-2</c:v>
                </c:pt>
                <c:pt idx="316" formatCode="0.00E+00">
                  <c:v>1.7295999999999999E-2</c:v>
                </c:pt>
                <c:pt idx="317" formatCode="0.00E+00">
                  <c:v>1.39224E-2</c:v>
                </c:pt>
                <c:pt idx="318" formatCode="0.00E+00">
                  <c:v>1.3321299999999999E-2</c:v>
                </c:pt>
                <c:pt idx="319" formatCode="0.00E+00">
                  <c:v>1.25348E-2</c:v>
                </c:pt>
                <c:pt idx="320" formatCode="0.00E+00">
                  <c:v>1.11597E-2</c:v>
                </c:pt>
                <c:pt idx="321" formatCode="0.00E+00">
                  <c:v>1.3627E-2</c:v>
                </c:pt>
                <c:pt idx="322" formatCode="0.00E+00">
                  <c:v>1.4246699999999999E-2</c:v>
                </c:pt>
                <c:pt idx="323" formatCode="0.00E+00">
                  <c:v>1.2317100000000001E-2</c:v>
                </c:pt>
                <c:pt idx="324" formatCode="0.00E+00">
                  <c:v>6.2765499999999997E-3</c:v>
                </c:pt>
                <c:pt idx="325" formatCode="0.00E+00">
                  <c:v>4.4421700000000005E-3</c:v>
                </c:pt>
                <c:pt idx="326" formatCode="0.00E+00">
                  <c:v>5.3387E-3</c:v>
                </c:pt>
                <c:pt idx="327" formatCode="0.00E+00">
                  <c:v>4.8216099999999996E-3</c:v>
                </c:pt>
                <c:pt idx="328" formatCode="0.00E+00">
                  <c:v>5.6861999999999998E-3</c:v>
                </c:pt>
                <c:pt idx="329" formatCode="0.00E+00">
                  <c:v>8.4084799999999994E-3</c:v>
                </c:pt>
                <c:pt idx="330" formatCode="0.00E+00">
                  <c:v>5.9554899999999999E-3</c:v>
                </c:pt>
                <c:pt idx="331" formatCode="0.00E+00">
                  <c:v>8.7453199999999991E-3</c:v>
                </c:pt>
                <c:pt idx="332" formatCode="0.00E+00">
                  <c:v>5.4058499999999994E-3</c:v>
                </c:pt>
                <c:pt idx="333" formatCode="0.00E+00">
                  <c:v>4.9192000000000003E-3</c:v>
                </c:pt>
                <c:pt idx="334" formatCode="0.00E+00">
                  <c:v>4.8405000000000002E-3</c:v>
                </c:pt>
                <c:pt idx="335" formatCode="0.00E+00">
                  <c:v>3.6879299999999996E-4</c:v>
                </c:pt>
                <c:pt idx="336" formatCode="0.00E+00">
                  <c:v>-1.70622E-3</c:v>
                </c:pt>
                <c:pt idx="337" formatCode="0.00E+00">
                  <c:v>1.53857E-3</c:v>
                </c:pt>
                <c:pt idx="338" formatCode="0.00E+00">
                  <c:v>1.58694E-3</c:v>
                </c:pt>
                <c:pt idx="339" formatCode="0.00E+00">
                  <c:v>-1.0899600000000001E-3</c:v>
                </c:pt>
                <c:pt idx="340" formatCode="0.00E+00">
                  <c:v>-1.8101999999999999E-3</c:v>
                </c:pt>
                <c:pt idx="341" formatCode="0.00E+00">
                  <c:v>-9.2109099999999997E-4</c:v>
                </c:pt>
                <c:pt idx="342" formatCode="0.00E+00">
                  <c:v>1.34837E-3</c:v>
                </c:pt>
                <c:pt idx="343" formatCode="0.00E+00">
                  <c:v>4.4295099999999997E-4</c:v>
                </c:pt>
                <c:pt idx="344" formatCode="0.00E+00">
                  <c:v>-2.2287700000000001E-4</c:v>
                </c:pt>
                <c:pt idx="345" formatCode="0.00E+00">
                  <c:v>-6.3062000000000003E-4</c:v>
                </c:pt>
                <c:pt idx="346" formatCode="0.00E+00">
                  <c:v>-5.0525799999999992E-3</c:v>
                </c:pt>
                <c:pt idx="347" formatCode="0.00E+00">
                  <c:v>-5.4473000000000004E-3</c:v>
                </c:pt>
                <c:pt idx="348" formatCode="0.00E+00">
                  <c:v>-1.52625E-3</c:v>
                </c:pt>
                <c:pt idx="349" formatCode="0.00E+00">
                  <c:v>1.8986600000000001E-4</c:v>
                </c:pt>
                <c:pt idx="350" formatCode="0.00E+00">
                  <c:v>2.0591199999999998E-3</c:v>
                </c:pt>
                <c:pt idx="351" formatCode="0.00E+00">
                  <c:v>1.34768E-3</c:v>
                </c:pt>
                <c:pt idx="352" formatCode="0.00E+00">
                  <c:v>1.8463000000000002E-3</c:v>
                </c:pt>
                <c:pt idx="353" formatCode="0.00E+00">
                  <c:v>3.3457499999999998E-3</c:v>
                </c:pt>
                <c:pt idx="354" formatCode="0.00E+00">
                  <c:v>-7.90419E-4</c:v>
                </c:pt>
                <c:pt idx="355" formatCode="0.00E+00">
                  <c:v>1.8619900000000002E-3</c:v>
                </c:pt>
                <c:pt idx="356" formatCode="0.00E+00">
                  <c:v>1.25231E-3</c:v>
                </c:pt>
                <c:pt idx="357" formatCode="0.00E+00">
                  <c:v>-2.9942099999999998E-3</c:v>
                </c:pt>
                <c:pt idx="358" formatCode="0.00E+00">
                  <c:v>-1.30185E-3</c:v>
                </c:pt>
                <c:pt idx="359" formatCode="0.00E+00">
                  <c:v>9.7725799999999995E-4</c:v>
                </c:pt>
                <c:pt idx="360" formatCode="0.00E+00">
                  <c:v>3.5610399999999999E-4</c:v>
                </c:pt>
                <c:pt idx="361" formatCode="0.00E+00">
                  <c:v>4.1316599999999997E-3</c:v>
                </c:pt>
                <c:pt idx="362" formatCode="0.00E+00">
                  <c:v>-5.1955800000000002E-5</c:v>
                </c:pt>
                <c:pt idx="363" formatCode="0.00E+00">
                  <c:v>-2.5132800000000001E-3</c:v>
                </c:pt>
                <c:pt idx="364" formatCode="0.00E+00">
                  <c:v>-1.36673E-4</c:v>
                </c:pt>
                <c:pt idx="365" formatCode="0.00E+00">
                  <c:v>-2.4629600000000001E-3</c:v>
                </c:pt>
                <c:pt idx="366" formatCode="0.00E+00">
                  <c:v>-4.1727300000000004E-3</c:v>
                </c:pt>
                <c:pt idx="367" formatCode="0.00E+00">
                  <c:v>-3.2837599999999997E-3</c:v>
                </c:pt>
                <c:pt idx="368" formatCode="0.00E+00">
                  <c:v>-3.6513399999999999E-3</c:v>
                </c:pt>
                <c:pt idx="369" formatCode="0.00E+00">
                  <c:v>-6.5679599999999996E-4</c:v>
                </c:pt>
                <c:pt idx="370" formatCode="0.00E+00">
                  <c:v>7.6424100000000003E-4</c:v>
                </c:pt>
                <c:pt idx="371" formatCode="0.00E+00">
                  <c:v>-4.4185400000000003E-3</c:v>
                </c:pt>
                <c:pt idx="372" formatCode="0.00E+00">
                  <c:v>-3.4462099999999999E-3</c:v>
                </c:pt>
                <c:pt idx="373" formatCode="0.00E+00">
                  <c:v>-3.5929300000000003E-3</c:v>
                </c:pt>
                <c:pt idx="374" formatCode="0.00E+00">
                  <c:v>1.6778E-4</c:v>
                </c:pt>
                <c:pt idx="375" formatCode="0.00E+00">
                  <c:v>4.3922500000000001E-4</c:v>
                </c:pt>
                <c:pt idx="376" formatCode="0.00E+00">
                  <c:v>-1.6343500000000001E-3</c:v>
                </c:pt>
                <c:pt idx="377" formatCode="0.00E+00">
                  <c:v>2.6963699999999998E-4</c:v>
                </c:pt>
                <c:pt idx="378" formatCode="0.00E+00">
                  <c:v>2.6665899999999999E-3</c:v>
                </c:pt>
                <c:pt idx="379" formatCode="0.00E+00">
                  <c:v>1.80412E-3</c:v>
                </c:pt>
                <c:pt idx="380" formatCode="0.00E+00">
                  <c:v>4.2822299999999997E-3</c:v>
                </c:pt>
                <c:pt idx="381" formatCode="0.00E+00">
                  <c:v>4.3140100000000001E-3</c:v>
                </c:pt>
                <c:pt idx="382" formatCode="0.00E+00">
                  <c:v>5.8348799999999995E-4</c:v>
                </c:pt>
                <c:pt idx="383" formatCode="0.00E+00">
                  <c:v>1.8193299999999999E-3</c:v>
                </c:pt>
                <c:pt idx="384" formatCode="0.00E+00">
                  <c:v>2.1749600000000001E-3</c:v>
                </c:pt>
                <c:pt idx="385" formatCode="0.00E+00">
                  <c:v>1.17588E-3</c:v>
                </c:pt>
                <c:pt idx="386" formatCode="0.00E+00">
                  <c:v>1.76797E-3</c:v>
                </c:pt>
                <c:pt idx="387" formatCode="0.00E+00">
                  <c:v>-5.8008099999999998E-4</c:v>
                </c:pt>
                <c:pt idx="388" formatCode="0.00E+00">
                  <c:v>1.8230100000000001E-3</c:v>
                </c:pt>
                <c:pt idx="389" formatCode="0.00E+00">
                  <c:v>1.0244900000000001E-3</c:v>
                </c:pt>
                <c:pt idx="390" formatCode="0.00E+00">
                  <c:v>1.8172399999999999E-3</c:v>
                </c:pt>
                <c:pt idx="391" formatCode="0.00E+00">
                  <c:v>-1.2144999999999999E-3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H$1</c:f>
              <c:strCache>
                <c:ptCount val="1"/>
                <c:pt idx="0">
                  <c:v>Sonicated GLA-AF Lot #1</c:v>
                </c:pt>
              </c:strCache>
            </c:strRef>
          </c:tx>
          <c:spPr>
            <a:ln w="19050"/>
          </c:spPr>
          <c:marker>
            <c:symbol val="none"/>
          </c:marker>
          <c:xVal>
            <c:numRef>
              <c:f>Sheet1!$A$2:$A$394</c:f>
              <c:numCache>
                <c:formatCode>General</c:formatCode>
                <c:ptCount val="393"/>
                <c:pt idx="0">
                  <c:v>7.6610899999999997</c:v>
                </c:pt>
                <c:pt idx="1">
                  <c:v>7.7944199999999997</c:v>
                </c:pt>
                <c:pt idx="2">
                  <c:v>7.9281800000000002</c:v>
                </c:pt>
                <c:pt idx="3">
                  <c:v>8.0620200000000004</c:v>
                </c:pt>
                <c:pt idx="4">
                  <c:v>8.1950699999999994</c:v>
                </c:pt>
                <c:pt idx="5">
                  <c:v>8.3279800000000002</c:v>
                </c:pt>
                <c:pt idx="6">
                  <c:v>8.4612999999999996</c:v>
                </c:pt>
                <c:pt idx="7">
                  <c:v>8.5946899999999999</c:v>
                </c:pt>
                <c:pt idx="8">
                  <c:v>8.72898</c:v>
                </c:pt>
                <c:pt idx="9">
                  <c:v>8.8628300000000007</c:v>
                </c:pt>
                <c:pt idx="10">
                  <c:v>8.9957399999999996</c:v>
                </c:pt>
                <c:pt idx="11">
                  <c:v>9.1294500000000003</c:v>
                </c:pt>
                <c:pt idx="12">
                  <c:v>9.26342</c:v>
                </c:pt>
                <c:pt idx="13">
                  <c:v>9.3959799999999998</c:v>
                </c:pt>
                <c:pt idx="14">
                  <c:v>9.5299999999999994</c:v>
                </c:pt>
                <c:pt idx="15">
                  <c:v>9.6634600000000006</c:v>
                </c:pt>
                <c:pt idx="16">
                  <c:v>9.7977399999999992</c:v>
                </c:pt>
                <c:pt idx="17">
                  <c:v>9.9310799999999997</c:v>
                </c:pt>
                <c:pt idx="18">
                  <c:v>10.0641</c:v>
                </c:pt>
                <c:pt idx="19">
                  <c:v>10.197480000000001</c:v>
                </c:pt>
                <c:pt idx="20">
                  <c:v>10.33029</c:v>
                </c:pt>
                <c:pt idx="21">
                  <c:v>10.463100000000001</c:v>
                </c:pt>
                <c:pt idx="22">
                  <c:v>10.596769999999999</c:v>
                </c:pt>
                <c:pt idx="23">
                  <c:v>10.7296</c:v>
                </c:pt>
                <c:pt idx="24">
                  <c:v>10.861359999999999</c:v>
                </c:pt>
                <c:pt idx="25">
                  <c:v>10.994440000000001</c:v>
                </c:pt>
                <c:pt idx="26">
                  <c:v>11.127420000000001</c:v>
                </c:pt>
                <c:pt idx="27">
                  <c:v>11.261060000000001</c:v>
                </c:pt>
                <c:pt idx="28">
                  <c:v>11.39434</c:v>
                </c:pt>
                <c:pt idx="29">
                  <c:v>11.527659999999999</c:v>
                </c:pt>
                <c:pt idx="30">
                  <c:v>11.66004</c:v>
                </c:pt>
                <c:pt idx="31">
                  <c:v>11.79407</c:v>
                </c:pt>
                <c:pt idx="32">
                  <c:v>11.92831</c:v>
                </c:pt>
                <c:pt idx="33">
                  <c:v>12.061909999999999</c:v>
                </c:pt>
                <c:pt idx="34">
                  <c:v>12.19483</c:v>
                </c:pt>
                <c:pt idx="35">
                  <c:v>12.32816</c:v>
                </c:pt>
                <c:pt idx="36">
                  <c:v>12.461869999999999</c:v>
                </c:pt>
                <c:pt idx="37">
                  <c:v>12.59474</c:v>
                </c:pt>
                <c:pt idx="38">
                  <c:v>12.72813</c:v>
                </c:pt>
                <c:pt idx="39">
                  <c:v>12.86239</c:v>
                </c:pt>
                <c:pt idx="40">
                  <c:v>12.996219999999999</c:v>
                </c:pt>
                <c:pt idx="41">
                  <c:v>13.12875</c:v>
                </c:pt>
                <c:pt idx="42">
                  <c:v>13.261150000000001</c:v>
                </c:pt>
                <c:pt idx="43">
                  <c:v>13.396179999999999</c:v>
                </c:pt>
                <c:pt idx="44">
                  <c:v>13.52951</c:v>
                </c:pt>
                <c:pt idx="45">
                  <c:v>13.66248</c:v>
                </c:pt>
                <c:pt idx="46">
                  <c:v>13.797040000000001</c:v>
                </c:pt>
                <c:pt idx="47">
                  <c:v>13.929959999999999</c:v>
                </c:pt>
                <c:pt idx="48">
                  <c:v>14.063739999999999</c:v>
                </c:pt>
                <c:pt idx="49">
                  <c:v>14.197419999999999</c:v>
                </c:pt>
                <c:pt idx="50">
                  <c:v>14.330069999999999</c:v>
                </c:pt>
                <c:pt idx="51">
                  <c:v>14.463710000000001</c:v>
                </c:pt>
                <c:pt idx="52">
                  <c:v>14.59592</c:v>
                </c:pt>
                <c:pt idx="53">
                  <c:v>14.72569</c:v>
                </c:pt>
                <c:pt idx="54">
                  <c:v>14.85899</c:v>
                </c:pt>
                <c:pt idx="55">
                  <c:v>14.99072</c:v>
                </c:pt>
                <c:pt idx="56">
                  <c:v>15.12476</c:v>
                </c:pt>
                <c:pt idx="57">
                  <c:v>15.259180000000001</c:v>
                </c:pt>
                <c:pt idx="58">
                  <c:v>15.39245</c:v>
                </c:pt>
                <c:pt idx="59">
                  <c:v>15.5259</c:v>
                </c:pt>
                <c:pt idx="60">
                  <c:v>15.660069999999999</c:v>
                </c:pt>
                <c:pt idx="61">
                  <c:v>15.79339</c:v>
                </c:pt>
                <c:pt idx="62">
                  <c:v>15.925890000000001</c:v>
                </c:pt>
                <c:pt idx="63">
                  <c:v>16.059449999999998</c:v>
                </c:pt>
                <c:pt idx="64">
                  <c:v>16.19295</c:v>
                </c:pt>
                <c:pt idx="65">
                  <c:v>16.32657</c:v>
                </c:pt>
                <c:pt idx="66">
                  <c:v>16.46087</c:v>
                </c:pt>
                <c:pt idx="67">
                  <c:v>16.593990000000002</c:v>
                </c:pt>
                <c:pt idx="68">
                  <c:v>16.727270000000001</c:v>
                </c:pt>
                <c:pt idx="69">
                  <c:v>16.861149999999999</c:v>
                </c:pt>
                <c:pt idx="70">
                  <c:v>16.99465</c:v>
                </c:pt>
                <c:pt idx="71">
                  <c:v>17.126930000000002</c:v>
                </c:pt>
                <c:pt idx="72">
                  <c:v>17.260819999999999</c:v>
                </c:pt>
                <c:pt idx="73">
                  <c:v>17.394780000000001</c:v>
                </c:pt>
                <c:pt idx="74">
                  <c:v>17.52871</c:v>
                </c:pt>
                <c:pt idx="75">
                  <c:v>17.663740000000001</c:v>
                </c:pt>
                <c:pt idx="76">
                  <c:v>17.795480000000001</c:v>
                </c:pt>
                <c:pt idx="77">
                  <c:v>17.928370000000001</c:v>
                </c:pt>
                <c:pt idx="78">
                  <c:v>18.060700000000001</c:v>
                </c:pt>
                <c:pt idx="79">
                  <c:v>18.196020000000001</c:v>
                </c:pt>
                <c:pt idx="80">
                  <c:v>18.328579999999999</c:v>
                </c:pt>
                <c:pt idx="81">
                  <c:v>18.459879999999998</c:v>
                </c:pt>
                <c:pt idx="82">
                  <c:v>18.591989999999999</c:v>
                </c:pt>
                <c:pt idx="83">
                  <c:v>18.726469999999999</c:v>
                </c:pt>
                <c:pt idx="84">
                  <c:v>18.859529999999999</c:v>
                </c:pt>
                <c:pt idx="85">
                  <c:v>18.99193</c:v>
                </c:pt>
                <c:pt idx="86">
                  <c:v>19.125610000000002</c:v>
                </c:pt>
                <c:pt idx="87">
                  <c:v>19.25929</c:v>
                </c:pt>
                <c:pt idx="88">
                  <c:v>19.392389999999999</c:v>
                </c:pt>
                <c:pt idx="89">
                  <c:v>19.526540000000001</c:v>
                </c:pt>
                <c:pt idx="90">
                  <c:v>19.658989999999999</c:v>
                </c:pt>
                <c:pt idx="91">
                  <c:v>19.79243</c:v>
                </c:pt>
                <c:pt idx="92">
                  <c:v>19.92576</c:v>
                </c:pt>
                <c:pt idx="93">
                  <c:v>20.05932</c:v>
                </c:pt>
                <c:pt idx="94">
                  <c:v>20.19265</c:v>
                </c:pt>
                <c:pt idx="95">
                  <c:v>20.325199999999999</c:v>
                </c:pt>
                <c:pt idx="96">
                  <c:v>20.45909</c:v>
                </c:pt>
                <c:pt idx="97">
                  <c:v>20.59299</c:v>
                </c:pt>
                <c:pt idx="98">
                  <c:v>20.72635</c:v>
                </c:pt>
                <c:pt idx="99">
                  <c:v>20.859960000000001</c:v>
                </c:pt>
                <c:pt idx="100">
                  <c:v>20.993829999999999</c:v>
                </c:pt>
                <c:pt idx="101">
                  <c:v>21.126619999999999</c:v>
                </c:pt>
                <c:pt idx="102">
                  <c:v>21.260899999999999</c:v>
                </c:pt>
                <c:pt idx="103">
                  <c:v>21.394770000000001</c:v>
                </c:pt>
                <c:pt idx="104">
                  <c:v>21.52769</c:v>
                </c:pt>
                <c:pt idx="105">
                  <c:v>21.661290000000001</c:v>
                </c:pt>
                <c:pt idx="106">
                  <c:v>21.794360000000001</c:v>
                </c:pt>
                <c:pt idx="107">
                  <c:v>21.928180000000001</c:v>
                </c:pt>
                <c:pt idx="108">
                  <c:v>22.061260000000001</c:v>
                </c:pt>
                <c:pt idx="109">
                  <c:v>22.191469999999999</c:v>
                </c:pt>
                <c:pt idx="110">
                  <c:v>22.320640000000001</c:v>
                </c:pt>
                <c:pt idx="111">
                  <c:v>22.454719999999998</c:v>
                </c:pt>
                <c:pt idx="112">
                  <c:v>22.587669999999999</c:v>
                </c:pt>
                <c:pt idx="113">
                  <c:v>22.720600000000001</c:v>
                </c:pt>
                <c:pt idx="114">
                  <c:v>22.853860000000001</c:v>
                </c:pt>
                <c:pt idx="115">
                  <c:v>22.986440000000002</c:v>
                </c:pt>
                <c:pt idx="116">
                  <c:v>23.12058</c:v>
                </c:pt>
                <c:pt idx="117">
                  <c:v>23.254940000000001</c:v>
                </c:pt>
                <c:pt idx="118">
                  <c:v>23.389489999999999</c:v>
                </c:pt>
                <c:pt idx="119">
                  <c:v>23.522670000000002</c:v>
                </c:pt>
                <c:pt idx="120">
                  <c:v>23.656030000000001</c:v>
                </c:pt>
                <c:pt idx="121">
                  <c:v>23.787790000000001</c:v>
                </c:pt>
                <c:pt idx="122">
                  <c:v>23.92173</c:v>
                </c:pt>
                <c:pt idx="123">
                  <c:v>24.05518</c:v>
                </c:pt>
                <c:pt idx="124">
                  <c:v>24.18938</c:v>
                </c:pt>
                <c:pt idx="125">
                  <c:v>24.32283</c:v>
                </c:pt>
                <c:pt idx="126">
                  <c:v>24.45712</c:v>
                </c:pt>
                <c:pt idx="127">
                  <c:v>24.589400000000001</c:v>
                </c:pt>
                <c:pt idx="128">
                  <c:v>24.721360000000001</c:v>
                </c:pt>
                <c:pt idx="129">
                  <c:v>24.855039999999999</c:v>
                </c:pt>
                <c:pt idx="130">
                  <c:v>24.98884</c:v>
                </c:pt>
                <c:pt idx="131">
                  <c:v>25.121690000000001</c:v>
                </c:pt>
                <c:pt idx="132">
                  <c:v>25.25637</c:v>
                </c:pt>
                <c:pt idx="133">
                  <c:v>25.39021</c:v>
                </c:pt>
                <c:pt idx="134">
                  <c:v>25.523109999999999</c:v>
                </c:pt>
                <c:pt idx="135">
                  <c:v>25.655909999999999</c:v>
                </c:pt>
                <c:pt idx="136">
                  <c:v>25.788930000000001</c:v>
                </c:pt>
                <c:pt idx="137">
                  <c:v>25.92334</c:v>
                </c:pt>
                <c:pt idx="138">
                  <c:v>26.05452</c:v>
                </c:pt>
                <c:pt idx="139">
                  <c:v>26.185829999999999</c:v>
                </c:pt>
                <c:pt idx="140">
                  <c:v>26.320309999999999</c:v>
                </c:pt>
                <c:pt idx="141">
                  <c:v>26.45336</c:v>
                </c:pt>
                <c:pt idx="142">
                  <c:v>26.586790000000001</c:v>
                </c:pt>
                <c:pt idx="143">
                  <c:v>26.719899999999999</c:v>
                </c:pt>
                <c:pt idx="144">
                  <c:v>26.853819999999999</c:v>
                </c:pt>
                <c:pt idx="145">
                  <c:v>26.986499999999999</c:v>
                </c:pt>
                <c:pt idx="146">
                  <c:v>27.121220000000001</c:v>
                </c:pt>
                <c:pt idx="147">
                  <c:v>27.255179999999999</c:v>
                </c:pt>
                <c:pt idx="148">
                  <c:v>27.389220000000002</c:v>
                </c:pt>
                <c:pt idx="149">
                  <c:v>27.52272</c:v>
                </c:pt>
                <c:pt idx="150">
                  <c:v>27.65579</c:v>
                </c:pt>
                <c:pt idx="151">
                  <c:v>27.78838</c:v>
                </c:pt>
                <c:pt idx="152">
                  <c:v>27.921939999999999</c:v>
                </c:pt>
                <c:pt idx="153">
                  <c:v>28.055299999999999</c:v>
                </c:pt>
                <c:pt idx="154">
                  <c:v>28.18927</c:v>
                </c:pt>
                <c:pt idx="155">
                  <c:v>28.32255</c:v>
                </c:pt>
                <c:pt idx="156">
                  <c:v>28.457350000000002</c:v>
                </c:pt>
                <c:pt idx="157">
                  <c:v>28.5899</c:v>
                </c:pt>
                <c:pt idx="158">
                  <c:v>28.7224</c:v>
                </c:pt>
                <c:pt idx="159">
                  <c:v>28.856829999999999</c:v>
                </c:pt>
                <c:pt idx="160">
                  <c:v>28.989519999999999</c:v>
                </c:pt>
                <c:pt idx="161">
                  <c:v>29.122039999999998</c:v>
                </c:pt>
                <c:pt idx="162">
                  <c:v>29.2563</c:v>
                </c:pt>
                <c:pt idx="163">
                  <c:v>29.391159999999999</c:v>
                </c:pt>
                <c:pt idx="164">
                  <c:v>29.52478</c:v>
                </c:pt>
                <c:pt idx="165">
                  <c:v>29.65634</c:v>
                </c:pt>
                <c:pt idx="166">
                  <c:v>29.788869999999999</c:v>
                </c:pt>
                <c:pt idx="167">
                  <c:v>29.915369999999999</c:v>
                </c:pt>
                <c:pt idx="168">
                  <c:v>30.04833</c:v>
                </c:pt>
                <c:pt idx="169">
                  <c:v>30.181640000000002</c:v>
                </c:pt>
                <c:pt idx="170">
                  <c:v>30.313939999999999</c:v>
                </c:pt>
                <c:pt idx="171">
                  <c:v>30.447590000000002</c:v>
                </c:pt>
                <c:pt idx="172">
                  <c:v>30.580939999999998</c:v>
                </c:pt>
                <c:pt idx="173">
                  <c:v>30.714320000000001</c:v>
                </c:pt>
                <c:pt idx="174">
                  <c:v>30.847059999999999</c:v>
                </c:pt>
                <c:pt idx="175">
                  <c:v>30.981780000000001</c:v>
                </c:pt>
                <c:pt idx="176">
                  <c:v>31.115020000000001</c:v>
                </c:pt>
                <c:pt idx="177">
                  <c:v>31.248529999999999</c:v>
                </c:pt>
                <c:pt idx="178">
                  <c:v>31.382840000000002</c:v>
                </c:pt>
                <c:pt idx="179">
                  <c:v>31.515640000000001</c:v>
                </c:pt>
                <c:pt idx="180">
                  <c:v>31.64884</c:v>
                </c:pt>
                <c:pt idx="181">
                  <c:v>31.78172</c:v>
                </c:pt>
                <c:pt idx="182">
                  <c:v>31.917359999999999</c:v>
                </c:pt>
                <c:pt idx="183">
                  <c:v>32.048540000000003</c:v>
                </c:pt>
                <c:pt idx="184">
                  <c:v>32.181980000000003</c:v>
                </c:pt>
                <c:pt idx="185">
                  <c:v>32.316429999999997</c:v>
                </c:pt>
                <c:pt idx="186">
                  <c:v>32.44961</c:v>
                </c:pt>
                <c:pt idx="187">
                  <c:v>32.582369999999997</c:v>
                </c:pt>
                <c:pt idx="188">
                  <c:v>32.716009999999997</c:v>
                </c:pt>
                <c:pt idx="189">
                  <c:v>32.849240000000002</c:v>
                </c:pt>
                <c:pt idx="190">
                  <c:v>32.982439999999997</c:v>
                </c:pt>
                <c:pt idx="191">
                  <c:v>33.114980000000003</c:v>
                </c:pt>
                <c:pt idx="192">
                  <c:v>33.248730000000002</c:v>
                </c:pt>
                <c:pt idx="193">
                  <c:v>33.382390000000001</c:v>
                </c:pt>
                <c:pt idx="194">
                  <c:v>33.51567</c:v>
                </c:pt>
                <c:pt idx="195">
                  <c:v>33.646599999999999</c:v>
                </c:pt>
                <c:pt idx="196">
                  <c:v>33.777650000000001</c:v>
                </c:pt>
                <c:pt idx="197">
                  <c:v>33.91169</c:v>
                </c:pt>
                <c:pt idx="198">
                  <c:v>34.044379999999997</c:v>
                </c:pt>
                <c:pt idx="199">
                  <c:v>34.179299999999998</c:v>
                </c:pt>
                <c:pt idx="200">
                  <c:v>34.313870000000001</c:v>
                </c:pt>
                <c:pt idx="201">
                  <c:v>34.447580000000002</c:v>
                </c:pt>
                <c:pt idx="202">
                  <c:v>34.580329999999996</c:v>
                </c:pt>
                <c:pt idx="203">
                  <c:v>34.71358</c:v>
                </c:pt>
                <c:pt idx="204">
                  <c:v>34.846820000000001</c:v>
                </c:pt>
                <c:pt idx="205">
                  <c:v>34.978879999999997</c:v>
                </c:pt>
                <c:pt idx="206">
                  <c:v>35.113500000000002</c:v>
                </c:pt>
                <c:pt idx="207">
                  <c:v>35.247390000000003</c:v>
                </c:pt>
                <c:pt idx="208">
                  <c:v>35.379800000000003</c:v>
                </c:pt>
                <c:pt idx="209">
                  <c:v>35.513480000000001</c:v>
                </c:pt>
                <c:pt idx="210">
                  <c:v>35.647779999999997</c:v>
                </c:pt>
                <c:pt idx="211">
                  <c:v>35.780880000000003</c:v>
                </c:pt>
                <c:pt idx="212">
                  <c:v>35.915129999999998</c:v>
                </c:pt>
                <c:pt idx="213">
                  <c:v>36.048169999999999</c:v>
                </c:pt>
                <c:pt idx="214">
                  <c:v>36.181229999999999</c:v>
                </c:pt>
                <c:pt idx="215">
                  <c:v>36.314830000000001</c:v>
                </c:pt>
                <c:pt idx="216">
                  <c:v>36.449300000000001</c:v>
                </c:pt>
                <c:pt idx="217">
                  <c:v>36.582990000000002</c:v>
                </c:pt>
                <c:pt idx="218">
                  <c:v>36.715519999999998</c:v>
                </c:pt>
                <c:pt idx="219">
                  <c:v>36.84966</c:v>
                </c:pt>
                <c:pt idx="220">
                  <c:v>36.982860000000002</c:v>
                </c:pt>
                <c:pt idx="221">
                  <c:v>37.116770000000002</c:v>
                </c:pt>
                <c:pt idx="222">
                  <c:v>37.250010000000003</c:v>
                </c:pt>
                <c:pt idx="223">
                  <c:v>37.383299999999998</c:v>
                </c:pt>
                <c:pt idx="224">
                  <c:v>37.510719999999999</c:v>
                </c:pt>
                <c:pt idx="225">
                  <c:v>37.642420000000001</c:v>
                </c:pt>
                <c:pt idx="226">
                  <c:v>37.775410000000001</c:v>
                </c:pt>
                <c:pt idx="227">
                  <c:v>37.910130000000002</c:v>
                </c:pt>
                <c:pt idx="228">
                  <c:v>38.043340000000001</c:v>
                </c:pt>
                <c:pt idx="229">
                  <c:v>38.17633</c:v>
                </c:pt>
                <c:pt idx="230">
                  <c:v>38.310580000000002</c:v>
                </c:pt>
                <c:pt idx="231">
                  <c:v>38.4435</c:v>
                </c:pt>
                <c:pt idx="232">
                  <c:v>38.576999999999998</c:v>
                </c:pt>
                <c:pt idx="233">
                  <c:v>38.708979999999997</c:v>
                </c:pt>
                <c:pt idx="234">
                  <c:v>38.841929999999998</c:v>
                </c:pt>
                <c:pt idx="235">
                  <c:v>38.975290000000001</c:v>
                </c:pt>
                <c:pt idx="236">
                  <c:v>39.10951</c:v>
                </c:pt>
                <c:pt idx="237">
                  <c:v>39.242600000000003</c:v>
                </c:pt>
                <c:pt idx="238">
                  <c:v>39.377070000000003</c:v>
                </c:pt>
                <c:pt idx="239">
                  <c:v>39.509659999999997</c:v>
                </c:pt>
                <c:pt idx="240">
                  <c:v>39.642530000000001</c:v>
                </c:pt>
                <c:pt idx="241">
                  <c:v>39.776719999999997</c:v>
                </c:pt>
                <c:pt idx="242">
                  <c:v>39.911279999999998</c:v>
                </c:pt>
                <c:pt idx="243">
                  <c:v>40.044359999999998</c:v>
                </c:pt>
                <c:pt idx="244">
                  <c:v>40.17709</c:v>
                </c:pt>
                <c:pt idx="245">
                  <c:v>40.310130000000001</c:v>
                </c:pt>
                <c:pt idx="246">
                  <c:v>40.443199999999997</c:v>
                </c:pt>
                <c:pt idx="247">
                  <c:v>40.578429999999997</c:v>
                </c:pt>
                <c:pt idx="248">
                  <c:v>40.710810000000002</c:v>
                </c:pt>
                <c:pt idx="249">
                  <c:v>40.843899999999998</c:v>
                </c:pt>
                <c:pt idx="250">
                  <c:v>40.977400000000003</c:v>
                </c:pt>
                <c:pt idx="251">
                  <c:v>41.110999999999997</c:v>
                </c:pt>
                <c:pt idx="252">
                  <c:v>41.241930000000004</c:v>
                </c:pt>
                <c:pt idx="253">
                  <c:v>41.372929999999997</c:v>
                </c:pt>
                <c:pt idx="254">
                  <c:v>41.50712</c:v>
                </c:pt>
                <c:pt idx="255">
                  <c:v>41.642200000000003</c:v>
                </c:pt>
                <c:pt idx="256">
                  <c:v>41.774389999999997</c:v>
                </c:pt>
                <c:pt idx="257">
                  <c:v>41.908000000000001</c:v>
                </c:pt>
                <c:pt idx="258">
                  <c:v>42.042079999999999</c:v>
                </c:pt>
                <c:pt idx="259">
                  <c:v>42.173920000000003</c:v>
                </c:pt>
                <c:pt idx="260">
                  <c:v>42.306950000000001</c:v>
                </c:pt>
                <c:pt idx="261">
                  <c:v>42.44191</c:v>
                </c:pt>
                <c:pt idx="262">
                  <c:v>42.575130000000001</c:v>
                </c:pt>
                <c:pt idx="263">
                  <c:v>42.708179999999999</c:v>
                </c:pt>
                <c:pt idx="264">
                  <c:v>42.840719999999997</c:v>
                </c:pt>
                <c:pt idx="265">
                  <c:v>42.974229999999999</c:v>
                </c:pt>
                <c:pt idx="266">
                  <c:v>43.108269999999997</c:v>
                </c:pt>
                <c:pt idx="267">
                  <c:v>43.241439999999997</c:v>
                </c:pt>
                <c:pt idx="268">
                  <c:v>43.376240000000003</c:v>
                </c:pt>
                <c:pt idx="269">
                  <c:v>43.510350000000003</c:v>
                </c:pt>
                <c:pt idx="270">
                  <c:v>43.641970000000001</c:v>
                </c:pt>
                <c:pt idx="271">
                  <c:v>43.77581</c:v>
                </c:pt>
                <c:pt idx="272">
                  <c:v>43.909050000000001</c:v>
                </c:pt>
                <c:pt idx="273">
                  <c:v>44.042479999999998</c:v>
                </c:pt>
                <c:pt idx="274">
                  <c:v>44.17548</c:v>
                </c:pt>
                <c:pt idx="275">
                  <c:v>44.310279999999999</c:v>
                </c:pt>
                <c:pt idx="276">
                  <c:v>44.443040000000003</c:v>
                </c:pt>
                <c:pt idx="277">
                  <c:v>44.575319999999998</c:v>
                </c:pt>
                <c:pt idx="278">
                  <c:v>44.710059999999999</c:v>
                </c:pt>
                <c:pt idx="279">
                  <c:v>44.843089999999997</c:v>
                </c:pt>
                <c:pt idx="280">
                  <c:v>44.975499999999997</c:v>
                </c:pt>
                <c:pt idx="281">
                  <c:v>45.107779999999998</c:v>
                </c:pt>
                <c:pt idx="282">
                  <c:v>45.23762</c:v>
                </c:pt>
                <c:pt idx="283">
                  <c:v>45.371380000000002</c:v>
                </c:pt>
                <c:pt idx="284">
                  <c:v>45.505220000000001</c:v>
                </c:pt>
                <c:pt idx="285">
                  <c:v>45.638910000000003</c:v>
                </c:pt>
                <c:pt idx="286">
                  <c:v>45.77084</c:v>
                </c:pt>
                <c:pt idx="287">
                  <c:v>45.903359999999999</c:v>
                </c:pt>
                <c:pt idx="288">
                  <c:v>46.038670000000003</c:v>
                </c:pt>
                <c:pt idx="289">
                  <c:v>46.170560000000002</c:v>
                </c:pt>
                <c:pt idx="290">
                  <c:v>46.304250000000003</c:v>
                </c:pt>
                <c:pt idx="291">
                  <c:v>46.438029999999998</c:v>
                </c:pt>
                <c:pt idx="292">
                  <c:v>46.572139999999997</c:v>
                </c:pt>
                <c:pt idx="293">
                  <c:v>46.706130000000002</c:v>
                </c:pt>
                <c:pt idx="294">
                  <c:v>46.839500000000001</c:v>
                </c:pt>
                <c:pt idx="295">
                  <c:v>46.97184</c:v>
                </c:pt>
                <c:pt idx="296">
                  <c:v>47.105699999999999</c:v>
                </c:pt>
                <c:pt idx="297">
                  <c:v>47.239620000000002</c:v>
                </c:pt>
                <c:pt idx="298">
                  <c:v>47.372729999999997</c:v>
                </c:pt>
                <c:pt idx="299">
                  <c:v>47.50723</c:v>
                </c:pt>
                <c:pt idx="300">
                  <c:v>47.63908</c:v>
                </c:pt>
                <c:pt idx="301">
                  <c:v>47.772930000000002</c:v>
                </c:pt>
                <c:pt idx="302">
                  <c:v>47.90605</c:v>
                </c:pt>
                <c:pt idx="303">
                  <c:v>48.038809999999998</c:v>
                </c:pt>
                <c:pt idx="304">
                  <c:v>48.17304</c:v>
                </c:pt>
                <c:pt idx="305">
                  <c:v>48.305799999999998</c:v>
                </c:pt>
                <c:pt idx="306">
                  <c:v>48.439909999999998</c:v>
                </c:pt>
                <c:pt idx="307">
                  <c:v>48.572789999999998</c:v>
                </c:pt>
                <c:pt idx="308">
                  <c:v>48.707450000000001</c:v>
                </c:pt>
                <c:pt idx="309">
                  <c:v>48.84102</c:v>
                </c:pt>
                <c:pt idx="310">
                  <c:v>48.97343</c:v>
                </c:pt>
                <c:pt idx="311">
                  <c:v>49.104700000000001</c:v>
                </c:pt>
                <c:pt idx="312">
                  <c:v>49.236800000000002</c:v>
                </c:pt>
                <c:pt idx="313">
                  <c:v>49.370629999999998</c:v>
                </c:pt>
                <c:pt idx="314">
                  <c:v>49.503660000000004</c:v>
                </c:pt>
                <c:pt idx="315">
                  <c:v>49.636029999999998</c:v>
                </c:pt>
                <c:pt idx="316">
                  <c:v>49.7712</c:v>
                </c:pt>
                <c:pt idx="317">
                  <c:v>49.904710000000001</c:v>
                </c:pt>
                <c:pt idx="318">
                  <c:v>50.036909999999999</c:v>
                </c:pt>
                <c:pt idx="319">
                  <c:v>50.170780000000001</c:v>
                </c:pt>
                <c:pt idx="320">
                  <c:v>50.305239999999998</c:v>
                </c:pt>
                <c:pt idx="321">
                  <c:v>50.437220000000003</c:v>
                </c:pt>
                <c:pt idx="322">
                  <c:v>50.570990000000002</c:v>
                </c:pt>
                <c:pt idx="323">
                  <c:v>50.70429</c:v>
                </c:pt>
                <c:pt idx="324">
                  <c:v>50.838230000000003</c:v>
                </c:pt>
                <c:pt idx="325">
                  <c:v>50.97137</c:v>
                </c:pt>
                <c:pt idx="326">
                  <c:v>51.105339999999998</c:v>
                </c:pt>
                <c:pt idx="327">
                  <c:v>51.238079999999997</c:v>
                </c:pt>
                <c:pt idx="328">
                  <c:v>51.371079999999999</c:v>
                </c:pt>
                <c:pt idx="329">
                  <c:v>51.504219999999997</c:v>
                </c:pt>
                <c:pt idx="330">
                  <c:v>51.637140000000002</c:v>
                </c:pt>
                <c:pt idx="331">
                  <c:v>51.770310000000002</c:v>
                </c:pt>
                <c:pt idx="332">
                  <c:v>51.90372</c:v>
                </c:pt>
                <c:pt idx="333">
                  <c:v>52.03745</c:v>
                </c:pt>
                <c:pt idx="334">
                  <c:v>52.17154</c:v>
                </c:pt>
                <c:pt idx="335">
                  <c:v>52.304499999999997</c:v>
                </c:pt>
                <c:pt idx="336">
                  <c:v>52.438809999999997</c:v>
                </c:pt>
                <c:pt idx="337">
                  <c:v>52.572380000000003</c:v>
                </c:pt>
                <c:pt idx="338">
                  <c:v>52.705219999999997</c:v>
                </c:pt>
                <c:pt idx="339">
                  <c:v>52.835790000000003</c:v>
                </c:pt>
                <c:pt idx="340">
                  <c:v>52.96631</c:v>
                </c:pt>
                <c:pt idx="341">
                  <c:v>53.09881</c:v>
                </c:pt>
                <c:pt idx="342">
                  <c:v>53.231670000000001</c:v>
                </c:pt>
                <c:pt idx="343">
                  <c:v>53.36739</c:v>
                </c:pt>
                <c:pt idx="344">
                  <c:v>53.49944</c:v>
                </c:pt>
                <c:pt idx="345">
                  <c:v>53.633949999999999</c:v>
                </c:pt>
                <c:pt idx="346">
                  <c:v>53.766570000000002</c:v>
                </c:pt>
                <c:pt idx="347">
                  <c:v>53.898260000000001</c:v>
                </c:pt>
                <c:pt idx="348">
                  <c:v>54.031019999999998</c:v>
                </c:pt>
                <c:pt idx="349">
                  <c:v>54.165559999999999</c:v>
                </c:pt>
                <c:pt idx="350">
                  <c:v>54.299169999999997</c:v>
                </c:pt>
                <c:pt idx="351">
                  <c:v>54.431710000000002</c:v>
                </c:pt>
                <c:pt idx="352">
                  <c:v>54.564869999999999</c:v>
                </c:pt>
                <c:pt idx="353">
                  <c:v>54.698399999999999</c:v>
                </c:pt>
                <c:pt idx="354">
                  <c:v>54.831940000000003</c:v>
                </c:pt>
                <c:pt idx="355">
                  <c:v>54.96611</c:v>
                </c:pt>
                <c:pt idx="356">
                  <c:v>55.099600000000002</c:v>
                </c:pt>
                <c:pt idx="357">
                  <c:v>55.232300000000002</c:v>
                </c:pt>
                <c:pt idx="358">
                  <c:v>55.365310000000001</c:v>
                </c:pt>
                <c:pt idx="359">
                  <c:v>55.498309999999996</c:v>
                </c:pt>
                <c:pt idx="360">
                  <c:v>55.631030000000003</c:v>
                </c:pt>
                <c:pt idx="361">
                  <c:v>55.765039999999999</c:v>
                </c:pt>
                <c:pt idx="362">
                  <c:v>55.898919999999997</c:v>
                </c:pt>
                <c:pt idx="363">
                  <c:v>56.031750000000002</c:v>
                </c:pt>
                <c:pt idx="364">
                  <c:v>56.165999999999997</c:v>
                </c:pt>
                <c:pt idx="365">
                  <c:v>56.299120000000002</c:v>
                </c:pt>
                <c:pt idx="366">
                  <c:v>56.431809999999999</c:v>
                </c:pt>
                <c:pt idx="367">
                  <c:v>56.566450000000003</c:v>
                </c:pt>
                <c:pt idx="368">
                  <c:v>56.697690000000001</c:v>
                </c:pt>
                <c:pt idx="369">
                  <c:v>56.830930000000002</c:v>
                </c:pt>
                <c:pt idx="370">
                  <c:v>56.963659999999997</c:v>
                </c:pt>
                <c:pt idx="371">
                  <c:v>57.0974</c:v>
                </c:pt>
                <c:pt idx="372">
                  <c:v>57.230730000000001</c:v>
                </c:pt>
                <c:pt idx="373">
                  <c:v>57.364260000000002</c:v>
                </c:pt>
                <c:pt idx="374">
                  <c:v>57.49774</c:v>
                </c:pt>
                <c:pt idx="375">
                  <c:v>57.630189999999999</c:v>
                </c:pt>
                <c:pt idx="376">
                  <c:v>57.762779999999999</c:v>
                </c:pt>
                <c:pt idx="377">
                  <c:v>57.89564</c:v>
                </c:pt>
                <c:pt idx="378">
                  <c:v>58.029670000000003</c:v>
                </c:pt>
                <c:pt idx="379">
                  <c:v>58.16234</c:v>
                </c:pt>
                <c:pt idx="380">
                  <c:v>58.294339999999998</c:v>
                </c:pt>
                <c:pt idx="381">
                  <c:v>58.428959999999996</c:v>
                </c:pt>
                <c:pt idx="382">
                  <c:v>58.561669999999999</c:v>
                </c:pt>
                <c:pt idx="383">
                  <c:v>58.695700000000002</c:v>
                </c:pt>
                <c:pt idx="384">
                  <c:v>58.830869999999997</c:v>
                </c:pt>
                <c:pt idx="385">
                  <c:v>58.963230000000003</c:v>
                </c:pt>
                <c:pt idx="386">
                  <c:v>59.095849999999999</c:v>
                </c:pt>
                <c:pt idx="387">
                  <c:v>59.229750000000003</c:v>
                </c:pt>
                <c:pt idx="388">
                  <c:v>59.362540000000003</c:v>
                </c:pt>
                <c:pt idx="389">
                  <c:v>59.496220000000001</c:v>
                </c:pt>
                <c:pt idx="390">
                  <c:v>59.628959999999999</c:v>
                </c:pt>
                <c:pt idx="391">
                  <c:v>59.762250000000002</c:v>
                </c:pt>
              </c:numCache>
            </c:numRef>
          </c:xVal>
          <c:yVal>
            <c:numRef>
              <c:f>Sheet1!$H$2:$H$394</c:f>
              <c:numCache>
                <c:formatCode>General</c:formatCode>
                <c:ptCount val="393"/>
                <c:pt idx="37" formatCode="0.00E+00">
                  <c:v>2.8046499999999998E-4</c:v>
                </c:pt>
                <c:pt idx="38" formatCode="0.00E+00">
                  <c:v>-1.9571200000000001E-3</c:v>
                </c:pt>
                <c:pt idx="39" formatCode="0.00E+00">
                  <c:v>-2.39392E-4</c:v>
                </c:pt>
                <c:pt idx="40" formatCode="0.00E+00">
                  <c:v>1.61353E-3</c:v>
                </c:pt>
                <c:pt idx="41" formatCode="0.00E+00">
                  <c:v>-4.9551700000000001E-4</c:v>
                </c:pt>
                <c:pt idx="42" formatCode="0.00E+00">
                  <c:v>-7.1227299999999992E-4</c:v>
                </c:pt>
                <c:pt idx="43" formatCode="0.00E+00">
                  <c:v>-6.0931799999999997E-4</c:v>
                </c:pt>
                <c:pt idx="44" formatCode="0.00E+00">
                  <c:v>1.4296400000000001E-5</c:v>
                </c:pt>
                <c:pt idx="45" formatCode="0.00E+00">
                  <c:v>3.0132800000000001E-3</c:v>
                </c:pt>
                <c:pt idx="46" formatCode="0.00E+00">
                  <c:v>4.18565E-3</c:v>
                </c:pt>
                <c:pt idx="47" formatCode="0.00E+00">
                  <c:v>6.6429200000000001E-3</c:v>
                </c:pt>
                <c:pt idx="48" formatCode="0.00E+00">
                  <c:v>8.4763800000000004E-3</c:v>
                </c:pt>
                <c:pt idx="49" formatCode="0.00E+00">
                  <c:v>4.9374600000000003E-3</c:v>
                </c:pt>
                <c:pt idx="50" formatCode="0.00E+00">
                  <c:v>1.71536E-3</c:v>
                </c:pt>
                <c:pt idx="51" formatCode="0.00E+00">
                  <c:v>2.7047500000000001E-3</c:v>
                </c:pt>
                <c:pt idx="52" formatCode="0.00E+00">
                  <c:v>5.8002799999999997E-3</c:v>
                </c:pt>
                <c:pt idx="53" formatCode="0.00E+00">
                  <c:v>-3.4659400000000002E-5</c:v>
                </c:pt>
                <c:pt idx="54" formatCode="0.00E+00">
                  <c:v>-6.7444299999999994E-4</c:v>
                </c:pt>
                <c:pt idx="55" formatCode="0.00E+00">
                  <c:v>2.98036E-4</c:v>
                </c:pt>
                <c:pt idx="56" formatCode="0.00E+00">
                  <c:v>-9.4482300000000002E-4</c:v>
                </c:pt>
                <c:pt idx="57" formatCode="0.00E+00">
                  <c:v>-3.0309100000000004E-3</c:v>
                </c:pt>
                <c:pt idx="58" formatCode="0.00E+00">
                  <c:v>-3.6661999999999997E-3</c:v>
                </c:pt>
                <c:pt idx="59" formatCode="0.00E+00">
                  <c:v>-5.4577000000000002E-3</c:v>
                </c:pt>
                <c:pt idx="60" formatCode="0.00E+00">
                  <c:v>-2.4513599999999997E-3</c:v>
                </c:pt>
                <c:pt idx="61" formatCode="0.00E+00">
                  <c:v>-1.2270200000000001E-3</c:v>
                </c:pt>
                <c:pt idx="62" formatCode="0.00E+00">
                  <c:v>-1.9499700000000001E-3</c:v>
                </c:pt>
                <c:pt idx="63" formatCode="0.00E+00">
                  <c:v>-3.9281699999999999E-3</c:v>
                </c:pt>
                <c:pt idx="64" formatCode="0.00E+00">
                  <c:v>-3.3875199999999998E-3</c:v>
                </c:pt>
                <c:pt idx="65" formatCode="0.00E+00">
                  <c:v>-4.9025399999999995E-3</c:v>
                </c:pt>
                <c:pt idx="66" formatCode="0.00E+00">
                  <c:v>-4.8931000000000001E-3</c:v>
                </c:pt>
                <c:pt idx="67" formatCode="0.00E+00">
                  <c:v>-3.6481999999999999E-3</c:v>
                </c:pt>
                <c:pt idx="68" formatCode="0.00E+00">
                  <c:v>-7.022939999999999E-4</c:v>
                </c:pt>
                <c:pt idx="69" formatCode="0.00E+00">
                  <c:v>1.8139599999999999E-3</c:v>
                </c:pt>
                <c:pt idx="70" formatCode="0.00E+00">
                  <c:v>-1.9189999999999998E-4</c:v>
                </c:pt>
                <c:pt idx="71" formatCode="0.00E+00">
                  <c:v>-3.9249200000000001E-3</c:v>
                </c:pt>
                <c:pt idx="72" formatCode="0.00E+00">
                  <c:v>-1.4094699999999999E-3</c:v>
                </c:pt>
                <c:pt idx="73" formatCode="0.00E+00">
                  <c:v>6.2800499999999995E-4</c:v>
                </c:pt>
                <c:pt idx="74" formatCode="0.00E+00">
                  <c:v>-4.4076300000000001E-3</c:v>
                </c:pt>
                <c:pt idx="75" formatCode="0.00E+00">
                  <c:v>-5.16578E-3</c:v>
                </c:pt>
                <c:pt idx="76" formatCode="0.00E+00">
                  <c:v>-3.6899300000000001E-3</c:v>
                </c:pt>
                <c:pt idx="77" formatCode="0.00E+00">
                  <c:v>-2.0467300000000001E-3</c:v>
                </c:pt>
                <c:pt idx="78" formatCode="0.00E+00">
                  <c:v>-2.8051700000000001E-3</c:v>
                </c:pt>
                <c:pt idx="79" formatCode="0.00E+00">
                  <c:v>-2.1632399999999999E-3</c:v>
                </c:pt>
                <c:pt idx="80" formatCode="0.00E+00">
                  <c:v>1.19825E-4</c:v>
                </c:pt>
                <c:pt idx="81" formatCode="0.00E+00">
                  <c:v>-8.4667100000000001E-4</c:v>
                </c:pt>
                <c:pt idx="82" formatCode="0.00E+00">
                  <c:v>1.0492100000000001E-3</c:v>
                </c:pt>
                <c:pt idx="83" formatCode="0.00E+00">
                  <c:v>-4.64024E-4</c:v>
                </c:pt>
                <c:pt idx="84" formatCode="0.00E+00">
                  <c:v>-2.6157099999999999E-4</c:v>
                </c:pt>
                <c:pt idx="85" formatCode="0.00E+00">
                  <c:v>3.5095100000000001E-4</c:v>
                </c:pt>
                <c:pt idx="86" formatCode="0.00E+00">
                  <c:v>2.17826E-3</c:v>
                </c:pt>
                <c:pt idx="87" formatCode="0.00E+00">
                  <c:v>3.8591400000000001E-3</c:v>
                </c:pt>
                <c:pt idx="88" formatCode="0.00E+00">
                  <c:v>4.4220600000000002E-3</c:v>
                </c:pt>
                <c:pt idx="89" formatCode="0.00E+00">
                  <c:v>2.7468100000000001E-3</c:v>
                </c:pt>
                <c:pt idx="90" formatCode="0.00E+00">
                  <c:v>4.3959300000000001E-3</c:v>
                </c:pt>
                <c:pt idx="91" formatCode="0.00E+00">
                  <c:v>7.9300199999999994E-3</c:v>
                </c:pt>
                <c:pt idx="92" formatCode="0.00E+00">
                  <c:v>3.1129999999999999E-3</c:v>
                </c:pt>
                <c:pt idx="93" formatCode="0.00E+00">
                  <c:v>1.0872E-3</c:v>
                </c:pt>
                <c:pt idx="94" formatCode="0.00E+00">
                  <c:v>5.8350599999999996E-3</c:v>
                </c:pt>
                <c:pt idx="95" formatCode="0.00E+00">
                  <c:v>7.3962400000000001E-3</c:v>
                </c:pt>
                <c:pt idx="96" formatCode="0.00E+00">
                  <c:v>7.1663999999999999E-3</c:v>
                </c:pt>
                <c:pt idx="97" formatCode="0.00E+00">
                  <c:v>9.6379299999999994E-3</c:v>
                </c:pt>
                <c:pt idx="98" formatCode="0.00E+00">
                  <c:v>1.1461499999999999E-2</c:v>
                </c:pt>
                <c:pt idx="99" formatCode="0.00E+00">
                  <c:v>1.0739199999999999E-2</c:v>
                </c:pt>
                <c:pt idx="100" formatCode="0.00E+00">
                  <c:v>9.0455499999999994E-3</c:v>
                </c:pt>
                <c:pt idx="101" formatCode="0.00E+00">
                  <c:v>9.0503500000000004E-3</c:v>
                </c:pt>
                <c:pt idx="102" formatCode="0.00E+00">
                  <c:v>7.1689299999999996E-3</c:v>
                </c:pt>
                <c:pt idx="103" formatCode="0.00E+00">
                  <c:v>8.4210499999999994E-3</c:v>
                </c:pt>
                <c:pt idx="104" formatCode="0.00E+00">
                  <c:v>9.8047699999999991E-3</c:v>
                </c:pt>
                <c:pt idx="105" formatCode="0.00E+00">
                  <c:v>1.01187E-2</c:v>
                </c:pt>
                <c:pt idx="106" formatCode="0.00E+00">
                  <c:v>1.0416699999999999E-2</c:v>
                </c:pt>
                <c:pt idx="107" formatCode="0.00E+00">
                  <c:v>9.8929299999999994E-3</c:v>
                </c:pt>
                <c:pt idx="108" formatCode="0.00E+00">
                  <c:v>1.2724399999999999E-2</c:v>
                </c:pt>
                <c:pt idx="109" formatCode="0.00E+00">
                  <c:v>1.0661400000000001E-2</c:v>
                </c:pt>
                <c:pt idx="110" formatCode="0.00E+00">
                  <c:v>9.2692499999999997E-3</c:v>
                </c:pt>
                <c:pt idx="111" formatCode="0.00E+00">
                  <c:v>1.1399900000000001E-2</c:v>
                </c:pt>
                <c:pt idx="112" formatCode="0.00E+00">
                  <c:v>1.3981100000000002E-2</c:v>
                </c:pt>
                <c:pt idx="113" formatCode="0.00E+00">
                  <c:v>1.7468500000000001E-2</c:v>
                </c:pt>
                <c:pt idx="114" formatCode="0.00E+00">
                  <c:v>2.0615999999999999E-2</c:v>
                </c:pt>
                <c:pt idx="115" formatCode="0.00E+00">
                  <c:v>1.8840800000000001E-2</c:v>
                </c:pt>
                <c:pt idx="116" formatCode="0.00E+00">
                  <c:v>1.6729600000000001E-2</c:v>
                </c:pt>
                <c:pt idx="117" formatCode="0.00E+00">
                  <c:v>1.8825100000000001E-2</c:v>
                </c:pt>
                <c:pt idx="118" formatCode="0.00E+00">
                  <c:v>1.6576299999999999E-2</c:v>
                </c:pt>
                <c:pt idx="119" formatCode="0.00E+00">
                  <c:v>1.2792599999999999E-2</c:v>
                </c:pt>
                <c:pt idx="120" formatCode="0.00E+00">
                  <c:v>1.02389E-2</c:v>
                </c:pt>
                <c:pt idx="121" formatCode="0.00E+00">
                  <c:v>1.0156799999999999E-2</c:v>
                </c:pt>
                <c:pt idx="122" formatCode="0.00E+00">
                  <c:v>8.9608099999999996E-3</c:v>
                </c:pt>
                <c:pt idx="123" formatCode="0.00E+00">
                  <c:v>5.7570600000000005E-3</c:v>
                </c:pt>
                <c:pt idx="124" formatCode="0.00E+00">
                  <c:v>7.0184800000000006E-3</c:v>
                </c:pt>
                <c:pt idx="125" formatCode="0.00E+00">
                  <c:v>1.26462E-2</c:v>
                </c:pt>
                <c:pt idx="126" formatCode="0.00E+00">
                  <c:v>1.0732299999999998E-2</c:v>
                </c:pt>
                <c:pt idx="127" formatCode="0.00E+00">
                  <c:v>1.7817699999999999E-2</c:v>
                </c:pt>
                <c:pt idx="128" formatCode="0.00E+00">
                  <c:v>2.28182E-2</c:v>
                </c:pt>
                <c:pt idx="129" formatCode="0.00E+00">
                  <c:v>1.39816E-2</c:v>
                </c:pt>
                <c:pt idx="130" formatCode="0.00E+00">
                  <c:v>1.1943599999999999E-2</c:v>
                </c:pt>
                <c:pt idx="131" formatCode="0.00E+00">
                  <c:v>1.06932E-2</c:v>
                </c:pt>
                <c:pt idx="132" formatCode="0.00E+00">
                  <c:v>6.0200200000000001E-3</c:v>
                </c:pt>
                <c:pt idx="133" formatCode="0.00E+00">
                  <c:v>8.0274600000000002E-3</c:v>
                </c:pt>
                <c:pt idx="134" formatCode="0.00E+00">
                  <c:v>7.1122399999999997E-3</c:v>
                </c:pt>
                <c:pt idx="135" formatCode="0.00E+00">
                  <c:v>4.19002E-3</c:v>
                </c:pt>
                <c:pt idx="136" formatCode="0.00E+00">
                  <c:v>8.395950000000001E-3</c:v>
                </c:pt>
                <c:pt idx="137" formatCode="0.00E+00">
                  <c:v>1.00719E-2</c:v>
                </c:pt>
                <c:pt idx="138" formatCode="0.00E+00">
                  <c:v>5.7917500000000009E-3</c:v>
                </c:pt>
                <c:pt idx="139" formatCode="0.00E+00">
                  <c:v>7.0613100000000003E-3</c:v>
                </c:pt>
                <c:pt idx="140" formatCode="0.00E+00">
                  <c:v>7.9803500000000006E-3</c:v>
                </c:pt>
                <c:pt idx="141" formatCode="0.00E+00">
                  <c:v>8.1680499999999996E-3</c:v>
                </c:pt>
                <c:pt idx="142" formatCode="0.00E+00">
                  <c:v>1.3456000000000001E-2</c:v>
                </c:pt>
                <c:pt idx="143" formatCode="0.00E+00">
                  <c:v>1.3778E-2</c:v>
                </c:pt>
                <c:pt idx="144" formatCode="0.00E+00">
                  <c:v>9.8073499999999994E-3</c:v>
                </c:pt>
                <c:pt idx="145" formatCode="0.00E+00">
                  <c:v>8.0019500000000007E-3</c:v>
                </c:pt>
                <c:pt idx="146" formatCode="0.00E+00">
                  <c:v>1.0083E-2</c:v>
                </c:pt>
                <c:pt idx="147" formatCode="0.00E+00">
                  <c:v>9.7458500000000003E-3</c:v>
                </c:pt>
                <c:pt idx="148" formatCode="0.00E+00">
                  <c:v>1.29944E-2</c:v>
                </c:pt>
                <c:pt idx="149" formatCode="0.00E+00">
                  <c:v>1.50974E-2</c:v>
                </c:pt>
                <c:pt idx="150" formatCode="0.00E+00">
                  <c:v>1.16334E-2</c:v>
                </c:pt>
                <c:pt idx="151" formatCode="0.00E+00">
                  <c:v>1.1324599999999999E-2</c:v>
                </c:pt>
                <c:pt idx="152" formatCode="0.00E+00">
                  <c:v>1.2396299999999999E-2</c:v>
                </c:pt>
                <c:pt idx="153" formatCode="0.00E+00">
                  <c:v>1.39522E-2</c:v>
                </c:pt>
                <c:pt idx="154" formatCode="0.00E+00">
                  <c:v>1.5940200000000002E-2</c:v>
                </c:pt>
                <c:pt idx="155" formatCode="0.00E+00">
                  <c:v>1.32257E-2</c:v>
                </c:pt>
                <c:pt idx="156" formatCode="0.00E+00">
                  <c:v>1.50911E-2</c:v>
                </c:pt>
                <c:pt idx="157" formatCode="0.00E+00">
                  <c:v>1.9833300000000002E-2</c:v>
                </c:pt>
                <c:pt idx="158" formatCode="0.00E+00">
                  <c:v>1.7232000000000001E-2</c:v>
                </c:pt>
                <c:pt idx="159" formatCode="0.00E+00">
                  <c:v>1.80833E-2</c:v>
                </c:pt>
                <c:pt idx="160" formatCode="0.00E+00">
                  <c:v>1.7817599999999999E-2</c:v>
                </c:pt>
                <c:pt idx="161" formatCode="0.00E+00">
                  <c:v>1.8739100000000002E-2</c:v>
                </c:pt>
                <c:pt idx="162" formatCode="0.00E+00">
                  <c:v>2.0454100000000003E-2</c:v>
                </c:pt>
                <c:pt idx="163" formatCode="0.00E+00">
                  <c:v>2.01642E-2</c:v>
                </c:pt>
                <c:pt idx="164" formatCode="0.00E+00">
                  <c:v>2.30724E-2</c:v>
                </c:pt>
                <c:pt idx="165" formatCode="0.00E+00">
                  <c:v>2.2330099999999999E-2</c:v>
                </c:pt>
                <c:pt idx="166" formatCode="0.00E+00">
                  <c:v>2.10961E-2</c:v>
                </c:pt>
                <c:pt idx="167" formatCode="0.00E+00">
                  <c:v>2.1195799999999997E-2</c:v>
                </c:pt>
                <c:pt idx="168" formatCode="0.00E+00">
                  <c:v>2.0673800000000003E-2</c:v>
                </c:pt>
                <c:pt idx="169" formatCode="0.00E+00">
                  <c:v>1.8598699999999999E-2</c:v>
                </c:pt>
                <c:pt idx="170" formatCode="0.00E+00">
                  <c:v>1.8932599999999997E-2</c:v>
                </c:pt>
                <c:pt idx="171" formatCode="0.00E+00">
                  <c:v>2.1081100000000002E-2</c:v>
                </c:pt>
                <c:pt idx="172" formatCode="0.00E+00">
                  <c:v>2.0665999999999997E-2</c:v>
                </c:pt>
                <c:pt idx="173" formatCode="0.00E+00">
                  <c:v>1.9343799999999998E-2</c:v>
                </c:pt>
                <c:pt idx="174" formatCode="0.00E+00">
                  <c:v>2.1118499999999998E-2</c:v>
                </c:pt>
                <c:pt idx="175" formatCode="0.00E+00">
                  <c:v>2.1075099999999999E-2</c:v>
                </c:pt>
                <c:pt idx="176" formatCode="0.00E+00">
                  <c:v>2.1608799999999997E-2</c:v>
                </c:pt>
                <c:pt idx="177" formatCode="0.00E+00">
                  <c:v>2.4399999999999998E-2</c:v>
                </c:pt>
                <c:pt idx="178" formatCode="0.00E+00">
                  <c:v>2.8692800000000001E-2</c:v>
                </c:pt>
                <c:pt idx="179" formatCode="0.00E+00">
                  <c:v>3.1195099999999996E-2</c:v>
                </c:pt>
                <c:pt idx="180" formatCode="0.00E+00">
                  <c:v>2.5330799999999997E-2</c:v>
                </c:pt>
                <c:pt idx="181" formatCode="0.00E+00">
                  <c:v>2.7522199999999997E-2</c:v>
                </c:pt>
                <c:pt idx="182" formatCode="0.00E+00">
                  <c:v>2.8007900000000002E-2</c:v>
                </c:pt>
                <c:pt idx="183" formatCode="0.00E+00">
                  <c:v>2.6355699999999999E-2</c:v>
                </c:pt>
                <c:pt idx="184" formatCode="0.00E+00">
                  <c:v>2.8647499999999999E-2</c:v>
                </c:pt>
                <c:pt idx="185" formatCode="0.00E+00">
                  <c:v>2.4732400000000002E-2</c:v>
                </c:pt>
                <c:pt idx="186" formatCode="0.00E+00">
                  <c:v>2.89611E-2</c:v>
                </c:pt>
                <c:pt idx="187" formatCode="0.00E+00">
                  <c:v>3.02096E-2</c:v>
                </c:pt>
                <c:pt idx="188" formatCode="0.00E+00">
                  <c:v>3.14696E-2</c:v>
                </c:pt>
                <c:pt idx="189" formatCode="0.00E+00">
                  <c:v>3.4632300000000005E-2</c:v>
                </c:pt>
                <c:pt idx="190" formatCode="0.00E+00">
                  <c:v>3.4146799999999998E-2</c:v>
                </c:pt>
                <c:pt idx="191" formatCode="0.00E+00">
                  <c:v>3.8256100000000001E-2</c:v>
                </c:pt>
                <c:pt idx="192" formatCode="0.00E+00">
                  <c:v>3.8462499999999997E-2</c:v>
                </c:pt>
                <c:pt idx="193" formatCode="0.00E+00">
                  <c:v>4.0266499999999997E-2</c:v>
                </c:pt>
                <c:pt idx="194" formatCode="0.00E+00">
                  <c:v>4.2024400000000003E-2</c:v>
                </c:pt>
                <c:pt idx="195" formatCode="0.00E+00">
                  <c:v>4.0824199999999998E-2</c:v>
                </c:pt>
                <c:pt idx="196" formatCode="0.00E+00">
                  <c:v>4.3348700000000004E-2</c:v>
                </c:pt>
                <c:pt idx="197" formatCode="0.00E+00">
                  <c:v>4.4797100000000006E-2</c:v>
                </c:pt>
                <c:pt idx="198" formatCode="0.00E+00">
                  <c:v>4.8591599999999999E-2</c:v>
                </c:pt>
                <c:pt idx="199" formatCode="0.00E+00">
                  <c:v>5.0056500000000004E-2</c:v>
                </c:pt>
                <c:pt idx="200" formatCode="0.00E+00">
                  <c:v>5.0653900000000002E-2</c:v>
                </c:pt>
                <c:pt idx="201" formatCode="0.00E+00">
                  <c:v>5.4624899999999997E-2</c:v>
                </c:pt>
                <c:pt idx="202" formatCode="0.00E+00">
                  <c:v>5.40191E-2</c:v>
                </c:pt>
                <c:pt idx="203" formatCode="0.00E+00">
                  <c:v>5.7655899999999996E-2</c:v>
                </c:pt>
                <c:pt idx="204" formatCode="0.00E+00">
                  <c:v>5.8501500000000005E-2</c:v>
                </c:pt>
                <c:pt idx="205" formatCode="0.00E+00">
                  <c:v>5.93787E-2</c:v>
                </c:pt>
                <c:pt idx="206" formatCode="0.00E+00">
                  <c:v>6.3053700000000004E-2</c:v>
                </c:pt>
                <c:pt idx="207" formatCode="0.00E+00">
                  <c:v>6.2612500000000001E-2</c:v>
                </c:pt>
                <c:pt idx="208" formatCode="0.00E+00">
                  <c:v>6.4396099999999998E-2</c:v>
                </c:pt>
                <c:pt idx="209" formatCode="0.00E+00">
                  <c:v>6.5716700000000003E-2</c:v>
                </c:pt>
                <c:pt idx="210" formatCode="0.00E+00">
                  <c:v>6.7929200000000009E-2</c:v>
                </c:pt>
                <c:pt idx="211" formatCode="0.00E+00">
                  <c:v>6.859019999999999E-2</c:v>
                </c:pt>
                <c:pt idx="212" formatCode="0.00E+00">
                  <c:v>7.3707499999999995E-2</c:v>
                </c:pt>
                <c:pt idx="213" formatCode="0.00E+00">
                  <c:v>7.4587200000000006E-2</c:v>
                </c:pt>
                <c:pt idx="214" formatCode="0.00E+00">
                  <c:v>7.5669700000000006E-2</c:v>
                </c:pt>
                <c:pt idx="215" formatCode="0.00E+00">
                  <c:v>7.737970000000001E-2</c:v>
                </c:pt>
                <c:pt idx="216" formatCode="0.00E+00">
                  <c:v>7.8203099999999998E-2</c:v>
                </c:pt>
                <c:pt idx="217" formatCode="0.00E+00">
                  <c:v>7.8479499999999994E-2</c:v>
                </c:pt>
                <c:pt idx="218" formatCode="0.00E+00">
                  <c:v>7.7440099999999998E-2</c:v>
                </c:pt>
                <c:pt idx="219" formatCode="0.00E+00">
                  <c:v>8.0970399999999998E-2</c:v>
                </c:pt>
                <c:pt idx="220" formatCode="0.00E+00">
                  <c:v>8.242300000000001E-2</c:v>
                </c:pt>
                <c:pt idx="221" formatCode="0.00E+00">
                  <c:v>8.535630000000001E-2</c:v>
                </c:pt>
                <c:pt idx="222" formatCode="0.00E+00">
                  <c:v>8.8187299999999996E-2</c:v>
                </c:pt>
                <c:pt idx="223" formatCode="0.00E+00">
                  <c:v>9.2016500000000001E-2</c:v>
                </c:pt>
                <c:pt idx="224" formatCode="0.00E+00">
                  <c:v>9.1790899999999995E-2</c:v>
                </c:pt>
                <c:pt idx="225" formatCode="0.00E+00">
                  <c:v>9.1832000000000011E-2</c:v>
                </c:pt>
                <c:pt idx="226" formatCode="0.00E+00">
                  <c:v>9.5519400000000004E-2</c:v>
                </c:pt>
                <c:pt idx="227" formatCode="0.00E+00">
                  <c:v>9.7556800000000013E-2</c:v>
                </c:pt>
                <c:pt idx="228" formatCode="0.00E+00">
                  <c:v>0.10127899999999999</c:v>
                </c:pt>
                <c:pt idx="229" formatCode="0.00E+00">
                  <c:v>0.10446899999999999</c:v>
                </c:pt>
                <c:pt idx="230" formatCode="0.00E+00">
                  <c:v>0.11096499999999999</c:v>
                </c:pt>
                <c:pt idx="231" formatCode="0.00E+00">
                  <c:v>0.112704</c:v>
                </c:pt>
                <c:pt idx="232" formatCode="0.00E+00">
                  <c:v>0.11629400000000001</c:v>
                </c:pt>
                <c:pt idx="233" formatCode="0.00E+00">
                  <c:v>0.12085</c:v>
                </c:pt>
                <c:pt idx="234" formatCode="0.00E+00">
                  <c:v>0.121059</c:v>
                </c:pt>
                <c:pt idx="235" formatCode="0.00E+00">
                  <c:v>0.121907</c:v>
                </c:pt>
                <c:pt idx="236" formatCode="0.00E+00">
                  <c:v>0.12675800000000001</c:v>
                </c:pt>
                <c:pt idx="237" formatCode="0.00E+00">
                  <c:v>0.131966</c:v>
                </c:pt>
                <c:pt idx="238" formatCode="0.00E+00">
                  <c:v>0.13688400000000001</c:v>
                </c:pt>
                <c:pt idx="239" formatCode="0.00E+00">
                  <c:v>0.14252599999999999</c:v>
                </c:pt>
                <c:pt idx="240" formatCode="0.00E+00">
                  <c:v>0.14413600000000001</c:v>
                </c:pt>
                <c:pt idx="241" formatCode="0.00E+00">
                  <c:v>0.148427</c:v>
                </c:pt>
                <c:pt idx="242" formatCode="0.00E+00">
                  <c:v>0.15256899999999998</c:v>
                </c:pt>
                <c:pt idx="243" formatCode="0.00E+00">
                  <c:v>0.15521900000000002</c:v>
                </c:pt>
                <c:pt idx="244" formatCode="0.00E+00">
                  <c:v>0.15815799999999999</c:v>
                </c:pt>
                <c:pt idx="245" formatCode="0.00E+00">
                  <c:v>0.15897799999999998</c:v>
                </c:pt>
                <c:pt idx="246" formatCode="0.00E+00">
                  <c:v>0.16450400000000001</c:v>
                </c:pt>
                <c:pt idx="247" formatCode="0.00E+00">
                  <c:v>0.16678599999999999</c:v>
                </c:pt>
                <c:pt idx="248" formatCode="0.00E+00">
                  <c:v>0.16875699999999999</c:v>
                </c:pt>
                <c:pt idx="249" formatCode="0.00E+00">
                  <c:v>0.172204</c:v>
                </c:pt>
                <c:pt idx="250" formatCode="0.00E+00">
                  <c:v>0.17167700000000002</c:v>
                </c:pt>
                <c:pt idx="251" formatCode="0.00E+00">
                  <c:v>0.17152000000000001</c:v>
                </c:pt>
                <c:pt idx="252" formatCode="0.00E+00">
                  <c:v>0.173459</c:v>
                </c:pt>
                <c:pt idx="253" formatCode="0.00E+00">
                  <c:v>0.17729500000000001</c:v>
                </c:pt>
                <c:pt idx="254" formatCode="0.00E+00">
                  <c:v>0.17671200000000001</c:v>
                </c:pt>
                <c:pt idx="255" formatCode="0.00E+00">
                  <c:v>0.183061</c:v>
                </c:pt>
                <c:pt idx="256" formatCode="0.00E+00">
                  <c:v>0.18606299999999998</c:v>
                </c:pt>
                <c:pt idx="257" formatCode="0.00E+00">
                  <c:v>0.19383</c:v>
                </c:pt>
                <c:pt idx="258" formatCode="0.00E+00">
                  <c:v>0.19772500000000001</c:v>
                </c:pt>
                <c:pt idx="259" formatCode="0.00E+00">
                  <c:v>0.195941</c:v>
                </c:pt>
                <c:pt idx="260" formatCode="0.00E+00">
                  <c:v>0.19533399999999998</c:v>
                </c:pt>
                <c:pt idx="261" formatCode="0.00E+00">
                  <c:v>0.20099199999999998</c:v>
                </c:pt>
                <c:pt idx="262" formatCode="0.00E+00">
                  <c:v>0.205093</c:v>
                </c:pt>
                <c:pt idx="263" formatCode="0.00E+00">
                  <c:v>0.20446999999999999</c:v>
                </c:pt>
                <c:pt idx="264" formatCode="0.00E+00">
                  <c:v>0.20917999999999998</c:v>
                </c:pt>
                <c:pt idx="265" formatCode="0.00E+00">
                  <c:v>0.21012100000000003</c:v>
                </c:pt>
                <c:pt idx="266" formatCode="0.00E+00">
                  <c:v>0.21619100000000002</c:v>
                </c:pt>
                <c:pt idx="267" formatCode="0.00E+00">
                  <c:v>0.21298500000000001</c:v>
                </c:pt>
                <c:pt idx="268" formatCode="0.00E+00">
                  <c:v>0.21193700000000001</c:v>
                </c:pt>
                <c:pt idx="269" formatCode="0.00E+00">
                  <c:v>0.20883199999999999</c:v>
                </c:pt>
                <c:pt idx="270" formatCode="0.00E+00">
                  <c:v>0.20244899999999999</c:v>
                </c:pt>
                <c:pt idx="271" formatCode="0.00E+00">
                  <c:v>0.20218900000000001</c:v>
                </c:pt>
                <c:pt idx="272" formatCode="0.00E+00">
                  <c:v>0.20741600000000002</c:v>
                </c:pt>
                <c:pt idx="273" formatCode="0.00E+00">
                  <c:v>0.21237300000000001</c:v>
                </c:pt>
                <c:pt idx="274" formatCode="0.00E+00">
                  <c:v>0.21627000000000002</c:v>
                </c:pt>
                <c:pt idx="275" formatCode="0.00E+00">
                  <c:v>0.217497</c:v>
                </c:pt>
                <c:pt idx="276" formatCode="0.00E+00">
                  <c:v>0.21570500000000001</c:v>
                </c:pt>
                <c:pt idx="277" formatCode="0.00E+00">
                  <c:v>0.21843200000000002</c:v>
                </c:pt>
                <c:pt idx="278" formatCode="0.00E+00">
                  <c:v>0.21820299999999998</c:v>
                </c:pt>
                <c:pt idx="279" formatCode="0.00E+00">
                  <c:v>0.22033699999999998</c:v>
                </c:pt>
                <c:pt idx="280" formatCode="0.00E+00">
                  <c:v>0.22024000000000002</c:v>
                </c:pt>
                <c:pt idx="281" formatCode="0.00E+00">
                  <c:v>0.22545299999999999</c:v>
                </c:pt>
                <c:pt idx="282" formatCode="0.00E+00">
                  <c:v>0.22395799999999999</c:v>
                </c:pt>
                <c:pt idx="283" formatCode="0.00E+00">
                  <c:v>0.226075</c:v>
                </c:pt>
                <c:pt idx="284" formatCode="0.00E+00">
                  <c:v>0.22295700000000002</c:v>
                </c:pt>
                <c:pt idx="285" formatCode="0.00E+00">
                  <c:v>0.22534699999999999</c:v>
                </c:pt>
                <c:pt idx="286" formatCode="0.00E+00">
                  <c:v>0.225434</c:v>
                </c:pt>
                <c:pt idx="287" formatCode="0.00E+00">
                  <c:v>0.22661700000000001</c:v>
                </c:pt>
                <c:pt idx="288" formatCode="0.00E+00">
                  <c:v>0.227683</c:v>
                </c:pt>
                <c:pt idx="289" formatCode="0.00E+00">
                  <c:v>0.22555500000000001</c:v>
                </c:pt>
                <c:pt idx="290" formatCode="0.00E+00">
                  <c:v>0.225963</c:v>
                </c:pt>
                <c:pt idx="291" formatCode="0.00E+00">
                  <c:v>0.22450799999999999</c:v>
                </c:pt>
                <c:pt idx="292" formatCode="0.00E+00">
                  <c:v>0.225687</c:v>
                </c:pt>
                <c:pt idx="293" formatCode="0.00E+00">
                  <c:v>0.22806099999999999</c:v>
                </c:pt>
                <c:pt idx="294" formatCode="0.00E+00">
                  <c:v>0.22843000000000002</c:v>
                </c:pt>
                <c:pt idx="295" formatCode="0.00E+00">
                  <c:v>0.22276399999999999</c:v>
                </c:pt>
                <c:pt idx="296" formatCode="0.00E+00">
                  <c:v>0.22455399999999998</c:v>
                </c:pt>
                <c:pt idx="297" formatCode="0.00E+00">
                  <c:v>0.223466</c:v>
                </c:pt>
                <c:pt idx="298" formatCode="0.00E+00">
                  <c:v>0.22602100000000003</c:v>
                </c:pt>
                <c:pt idx="299" formatCode="0.00E+00">
                  <c:v>0.22728500000000001</c:v>
                </c:pt>
                <c:pt idx="300" formatCode="0.00E+00">
                  <c:v>0.22922800000000002</c:v>
                </c:pt>
                <c:pt idx="301" formatCode="0.00E+00">
                  <c:v>0.226712</c:v>
                </c:pt>
                <c:pt idx="302" formatCode="0.00E+00">
                  <c:v>0.22741800000000001</c:v>
                </c:pt>
                <c:pt idx="303" formatCode="0.00E+00">
                  <c:v>0.22859399999999999</c:v>
                </c:pt>
                <c:pt idx="304" formatCode="0.00E+00">
                  <c:v>0.22925199999999998</c:v>
                </c:pt>
                <c:pt idx="305" formatCode="0.00E+00">
                  <c:v>0.228162</c:v>
                </c:pt>
                <c:pt idx="306" formatCode="0.00E+00">
                  <c:v>0.23064199999999999</c:v>
                </c:pt>
                <c:pt idx="307" formatCode="0.00E+00">
                  <c:v>0.22781799999999999</c:v>
                </c:pt>
                <c:pt idx="308" formatCode="0.00E+00">
                  <c:v>0.22539600000000001</c:v>
                </c:pt>
                <c:pt idx="309" formatCode="0.00E+00">
                  <c:v>0.22275700000000001</c:v>
                </c:pt>
                <c:pt idx="310" formatCode="0.00E+00">
                  <c:v>0.22145700000000001</c:v>
                </c:pt>
                <c:pt idx="311" formatCode="0.00E+00">
                  <c:v>0.21931799999999999</c:v>
                </c:pt>
                <c:pt idx="312" formatCode="0.00E+00">
                  <c:v>0.21646699999999999</c:v>
                </c:pt>
                <c:pt idx="313" formatCode="0.00E+00">
                  <c:v>0.21617700000000001</c:v>
                </c:pt>
                <c:pt idx="314" formatCode="0.00E+00">
                  <c:v>0.21470600000000001</c:v>
                </c:pt>
                <c:pt idx="315" formatCode="0.00E+00">
                  <c:v>0.213975</c:v>
                </c:pt>
                <c:pt idx="316" formatCode="0.00E+00">
                  <c:v>0.20951600000000001</c:v>
                </c:pt>
                <c:pt idx="317" formatCode="0.00E+00">
                  <c:v>0.206507</c:v>
                </c:pt>
                <c:pt idx="318" formatCode="0.00E+00">
                  <c:v>0.20536299999999999</c:v>
                </c:pt>
                <c:pt idx="319" formatCode="0.00E+00">
                  <c:v>0.202572</c:v>
                </c:pt>
                <c:pt idx="320" formatCode="0.00E+00">
                  <c:v>0.20166600000000001</c:v>
                </c:pt>
                <c:pt idx="321" formatCode="0.00E+00">
                  <c:v>0.20155600000000001</c:v>
                </c:pt>
                <c:pt idx="322" formatCode="0.00E+00">
                  <c:v>0.20328199999999999</c:v>
                </c:pt>
                <c:pt idx="323" formatCode="0.00E+00">
                  <c:v>0.19944100000000001</c:v>
                </c:pt>
                <c:pt idx="324" formatCode="0.00E+00">
                  <c:v>0.19559400000000002</c:v>
                </c:pt>
                <c:pt idx="325" formatCode="0.00E+00">
                  <c:v>0.18964400000000001</c:v>
                </c:pt>
                <c:pt idx="326" formatCode="0.00E+00">
                  <c:v>0.18173799999999998</c:v>
                </c:pt>
                <c:pt idx="327" formatCode="0.00E+00">
                  <c:v>0.161465</c:v>
                </c:pt>
                <c:pt idx="328" formatCode="0.00E+00">
                  <c:v>0.141236</c:v>
                </c:pt>
                <c:pt idx="329" formatCode="0.00E+00">
                  <c:v>0.121443</c:v>
                </c:pt>
                <c:pt idx="330" formatCode="0.00E+00">
                  <c:v>0.10364899999999999</c:v>
                </c:pt>
                <c:pt idx="331" formatCode="0.00E+00">
                  <c:v>8.6760799999999999E-2</c:v>
                </c:pt>
                <c:pt idx="332" formatCode="0.00E+00">
                  <c:v>7.4428899999999992E-2</c:v>
                </c:pt>
                <c:pt idx="333" formatCode="0.00E+00">
                  <c:v>6.1915999999999999E-2</c:v>
                </c:pt>
                <c:pt idx="334" formatCode="0.00E+00">
                  <c:v>5.4182099999999997E-2</c:v>
                </c:pt>
                <c:pt idx="335" formatCode="0.00E+00">
                  <c:v>4.4670399999999999E-2</c:v>
                </c:pt>
                <c:pt idx="336" formatCode="0.00E+00">
                  <c:v>3.87949E-2</c:v>
                </c:pt>
                <c:pt idx="337" formatCode="0.00E+00">
                  <c:v>3.26503E-2</c:v>
                </c:pt>
                <c:pt idx="338" formatCode="0.00E+00">
                  <c:v>2.8046999999999999E-2</c:v>
                </c:pt>
                <c:pt idx="339" formatCode="0.00E+00">
                  <c:v>2.2859000000000001E-2</c:v>
                </c:pt>
                <c:pt idx="340" formatCode="0.00E+00">
                  <c:v>2.1882500000000003E-2</c:v>
                </c:pt>
                <c:pt idx="341" formatCode="0.00E+00">
                  <c:v>1.87429E-2</c:v>
                </c:pt>
                <c:pt idx="342" formatCode="0.00E+00">
                  <c:v>1.55061E-2</c:v>
                </c:pt>
                <c:pt idx="343" formatCode="0.00E+00">
                  <c:v>1.05024E-2</c:v>
                </c:pt>
                <c:pt idx="344" formatCode="0.00E+00">
                  <c:v>8.0605499999999997E-3</c:v>
                </c:pt>
                <c:pt idx="345" formatCode="0.00E+00">
                  <c:v>4.6603800000000004E-3</c:v>
                </c:pt>
                <c:pt idx="346" formatCode="0.00E+00">
                  <c:v>-1.43834E-3</c:v>
                </c:pt>
                <c:pt idx="347" formatCode="0.00E+00">
                  <c:v>-4.7927799999999997E-4</c:v>
                </c:pt>
                <c:pt idx="348" formatCode="0.00E+00">
                  <c:v>1.2637599999999998E-3</c:v>
                </c:pt>
                <c:pt idx="349" formatCode="0.00E+00">
                  <c:v>4.68251E-3</c:v>
                </c:pt>
                <c:pt idx="350" formatCode="0.00E+00">
                  <c:v>4.0233100000000004E-3</c:v>
                </c:pt>
                <c:pt idx="351" formatCode="0.00E+00">
                  <c:v>2.1004600000000002E-3</c:v>
                </c:pt>
                <c:pt idx="352" formatCode="0.00E+00">
                  <c:v>1.37335E-3</c:v>
                </c:pt>
                <c:pt idx="353" formatCode="0.00E+00">
                  <c:v>4.2763100000000002E-3</c:v>
                </c:pt>
                <c:pt idx="354" formatCode="0.00E+00">
                  <c:v>1.2420899999999999E-3</c:v>
                </c:pt>
                <c:pt idx="355" formatCode="0.00E+00">
                  <c:v>2.2085400000000002E-3</c:v>
                </c:pt>
                <c:pt idx="356" formatCode="0.00E+00">
                  <c:v>-3.13387E-3</c:v>
                </c:pt>
                <c:pt idx="357" formatCode="0.00E+00">
                  <c:v>-3.2552100000000001E-3</c:v>
                </c:pt>
                <c:pt idx="358" formatCode="0.00E+00">
                  <c:v>-4.1147900000000001E-3</c:v>
                </c:pt>
                <c:pt idx="359" formatCode="0.00E+00">
                  <c:v>1.7680300000000001E-3</c:v>
                </c:pt>
                <c:pt idx="360" formatCode="0.00E+00">
                  <c:v>5.6085200000000003E-5</c:v>
                </c:pt>
                <c:pt idx="361" formatCode="0.00E+00">
                  <c:v>3.7828599999999999E-3</c:v>
                </c:pt>
                <c:pt idx="362" formatCode="0.00E+00">
                  <c:v>-9.6353200000000002E-4</c:v>
                </c:pt>
                <c:pt idx="363" formatCode="0.00E+00">
                  <c:v>2.6518199999999998E-4</c:v>
                </c:pt>
                <c:pt idx="364" formatCode="0.00E+00">
                  <c:v>9.7398199999999997E-4</c:v>
                </c:pt>
                <c:pt idx="365" formatCode="0.00E+00">
                  <c:v>-2.2006E-3</c:v>
                </c:pt>
                <c:pt idx="366" formatCode="0.00E+00">
                  <c:v>-2.7312899999999999E-3</c:v>
                </c:pt>
                <c:pt idx="367" formatCode="0.00E+00">
                  <c:v>-3.1239000000000002E-3</c:v>
                </c:pt>
                <c:pt idx="368" formatCode="0.00E+00">
                  <c:v>-4.8356800000000002E-3</c:v>
                </c:pt>
                <c:pt idx="369" formatCode="0.00E+00">
                  <c:v>-2.7537600000000001E-3</c:v>
                </c:pt>
                <c:pt idx="370" formatCode="0.00E+00">
                  <c:v>1.4189999999999999E-3</c:v>
                </c:pt>
                <c:pt idx="371" formatCode="0.00E+00">
                  <c:v>-1.1919599999999999E-3</c:v>
                </c:pt>
                <c:pt idx="372" formatCode="0.00E+00">
                  <c:v>-4.9002200000000001E-4</c:v>
                </c:pt>
                <c:pt idx="373" formatCode="0.00E+00">
                  <c:v>-8.5254500000000002E-4</c:v>
                </c:pt>
                <c:pt idx="374" formatCode="0.00E+00">
                  <c:v>-3.7203200000000001E-4</c:v>
                </c:pt>
                <c:pt idx="375" formatCode="0.00E+00">
                  <c:v>-2.52118E-3</c:v>
                </c:pt>
                <c:pt idx="376" formatCode="0.00E+00">
                  <c:v>-2.44372E-5</c:v>
                </c:pt>
                <c:pt idx="377" formatCode="0.00E+00">
                  <c:v>-2.2517100000000001E-3</c:v>
                </c:pt>
                <c:pt idx="378" formatCode="0.00E+00">
                  <c:v>2.2150199999999998E-3</c:v>
                </c:pt>
                <c:pt idx="379" formatCode="0.00E+00">
                  <c:v>5.8797699999999994E-4</c:v>
                </c:pt>
                <c:pt idx="380" formatCode="0.00E+00">
                  <c:v>8.5269700000000003E-4</c:v>
                </c:pt>
                <c:pt idx="381" formatCode="0.00E+00">
                  <c:v>-2.37594E-3</c:v>
                </c:pt>
                <c:pt idx="382" formatCode="0.00E+00">
                  <c:v>-2.08517E-4</c:v>
                </c:pt>
                <c:pt idx="383" formatCode="0.00E+00">
                  <c:v>1.2270500000000001E-3</c:v>
                </c:pt>
                <c:pt idx="384" formatCode="0.00E+00">
                  <c:v>9.0866000000000004E-4</c:v>
                </c:pt>
                <c:pt idx="385" formatCode="0.00E+00">
                  <c:v>-1.98102E-3</c:v>
                </c:pt>
                <c:pt idx="386" formatCode="0.00E+00">
                  <c:v>2.07691E-3</c:v>
                </c:pt>
                <c:pt idx="387" formatCode="0.00E+00">
                  <c:v>5.4898600000000001E-4</c:v>
                </c:pt>
                <c:pt idx="388" formatCode="0.00E+00">
                  <c:v>2.8247000000000003E-3</c:v>
                </c:pt>
                <c:pt idx="389" formatCode="0.00E+00">
                  <c:v>8.5865499999999994E-4</c:v>
                </c:pt>
                <c:pt idx="390" formatCode="0.00E+00">
                  <c:v>4.0732399999999997E-3</c:v>
                </c:pt>
                <c:pt idx="391" formatCode="0.00E+00">
                  <c:v>-4.46441E-4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I$1</c:f>
              <c:strCache>
                <c:ptCount val="1"/>
                <c:pt idx="0">
                  <c:v>Sonicated GLA-AF Lot #2</c:v>
                </c:pt>
              </c:strCache>
            </c:strRef>
          </c:tx>
          <c:spPr>
            <a:ln w="19050"/>
          </c:spPr>
          <c:marker>
            <c:symbol val="none"/>
          </c:marker>
          <c:xVal>
            <c:numRef>
              <c:f>Sheet1!$A$2:$A$394</c:f>
              <c:numCache>
                <c:formatCode>General</c:formatCode>
                <c:ptCount val="393"/>
                <c:pt idx="0">
                  <c:v>7.6610899999999997</c:v>
                </c:pt>
                <c:pt idx="1">
                  <c:v>7.7944199999999997</c:v>
                </c:pt>
                <c:pt idx="2">
                  <c:v>7.9281800000000002</c:v>
                </c:pt>
                <c:pt idx="3">
                  <c:v>8.0620200000000004</c:v>
                </c:pt>
                <c:pt idx="4">
                  <c:v>8.1950699999999994</c:v>
                </c:pt>
                <c:pt idx="5">
                  <c:v>8.3279800000000002</c:v>
                </c:pt>
                <c:pt idx="6">
                  <c:v>8.4612999999999996</c:v>
                </c:pt>
                <c:pt idx="7">
                  <c:v>8.5946899999999999</c:v>
                </c:pt>
                <c:pt idx="8">
                  <c:v>8.72898</c:v>
                </c:pt>
                <c:pt idx="9">
                  <c:v>8.8628300000000007</c:v>
                </c:pt>
                <c:pt idx="10">
                  <c:v>8.9957399999999996</c:v>
                </c:pt>
                <c:pt idx="11">
                  <c:v>9.1294500000000003</c:v>
                </c:pt>
                <c:pt idx="12">
                  <c:v>9.26342</c:v>
                </c:pt>
                <c:pt idx="13">
                  <c:v>9.3959799999999998</c:v>
                </c:pt>
                <c:pt idx="14">
                  <c:v>9.5299999999999994</c:v>
                </c:pt>
                <c:pt idx="15">
                  <c:v>9.6634600000000006</c:v>
                </c:pt>
                <c:pt idx="16">
                  <c:v>9.7977399999999992</c:v>
                </c:pt>
                <c:pt idx="17">
                  <c:v>9.9310799999999997</c:v>
                </c:pt>
                <c:pt idx="18">
                  <c:v>10.0641</c:v>
                </c:pt>
                <c:pt idx="19">
                  <c:v>10.197480000000001</c:v>
                </c:pt>
                <c:pt idx="20">
                  <c:v>10.33029</c:v>
                </c:pt>
                <c:pt idx="21">
                  <c:v>10.463100000000001</c:v>
                </c:pt>
                <c:pt idx="22">
                  <c:v>10.596769999999999</c:v>
                </c:pt>
                <c:pt idx="23">
                  <c:v>10.7296</c:v>
                </c:pt>
                <c:pt idx="24">
                  <c:v>10.861359999999999</c:v>
                </c:pt>
                <c:pt idx="25">
                  <c:v>10.994440000000001</c:v>
                </c:pt>
                <c:pt idx="26">
                  <c:v>11.127420000000001</c:v>
                </c:pt>
                <c:pt idx="27">
                  <c:v>11.261060000000001</c:v>
                </c:pt>
                <c:pt idx="28">
                  <c:v>11.39434</c:v>
                </c:pt>
                <c:pt idx="29">
                  <c:v>11.527659999999999</c:v>
                </c:pt>
                <c:pt idx="30">
                  <c:v>11.66004</c:v>
                </c:pt>
                <c:pt idx="31">
                  <c:v>11.79407</c:v>
                </c:pt>
                <c:pt idx="32">
                  <c:v>11.92831</c:v>
                </c:pt>
                <c:pt idx="33">
                  <c:v>12.061909999999999</c:v>
                </c:pt>
                <c:pt idx="34">
                  <c:v>12.19483</c:v>
                </c:pt>
                <c:pt idx="35">
                  <c:v>12.32816</c:v>
                </c:pt>
                <c:pt idx="36">
                  <c:v>12.461869999999999</c:v>
                </c:pt>
                <c:pt idx="37">
                  <c:v>12.59474</c:v>
                </c:pt>
                <c:pt idx="38">
                  <c:v>12.72813</c:v>
                </c:pt>
                <c:pt idx="39">
                  <c:v>12.86239</c:v>
                </c:pt>
                <c:pt idx="40">
                  <c:v>12.996219999999999</c:v>
                </c:pt>
                <c:pt idx="41">
                  <c:v>13.12875</c:v>
                </c:pt>
                <c:pt idx="42">
                  <c:v>13.261150000000001</c:v>
                </c:pt>
                <c:pt idx="43">
                  <c:v>13.396179999999999</c:v>
                </c:pt>
                <c:pt idx="44">
                  <c:v>13.52951</c:v>
                </c:pt>
                <c:pt idx="45">
                  <c:v>13.66248</c:v>
                </c:pt>
                <c:pt idx="46">
                  <c:v>13.797040000000001</c:v>
                </c:pt>
                <c:pt idx="47">
                  <c:v>13.929959999999999</c:v>
                </c:pt>
                <c:pt idx="48">
                  <c:v>14.063739999999999</c:v>
                </c:pt>
                <c:pt idx="49">
                  <c:v>14.197419999999999</c:v>
                </c:pt>
                <c:pt idx="50">
                  <c:v>14.330069999999999</c:v>
                </c:pt>
                <c:pt idx="51">
                  <c:v>14.463710000000001</c:v>
                </c:pt>
                <c:pt idx="52">
                  <c:v>14.59592</c:v>
                </c:pt>
                <c:pt idx="53">
                  <c:v>14.72569</c:v>
                </c:pt>
                <c:pt idx="54">
                  <c:v>14.85899</c:v>
                </c:pt>
                <c:pt idx="55">
                  <c:v>14.99072</c:v>
                </c:pt>
                <c:pt idx="56">
                  <c:v>15.12476</c:v>
                </c:pt>
                <c:pt idx="57">
                  <c:v>15.259180000000001</c:v>
                </c:pt>
                <c:pt idx="58">
                  <c:v>15.39245</c:v>
                </c:pt>
                <c:pt idx="59">
                  <c:v>15.5259</c:v>
                </c:pt>
                <c:pt idx="60">
                  <c:v>15.660069999999999</c:v>
                </c:pt>
                <c:pt idx="61">
                  <c:v>15.79339</c:v>
                </c:pt>
                <c:pt idx="62">
                  <c:v>15.925890000000001</c:v>
                </c:pt>
                <c:pt idx="63">
                  <c:v>16.059449999999998</c:v>
                </c:pt>
                <c:pt idx="64">
                  <c:v>16.19295</c:v>
                </c:pt>
                <c:pt idx="65">
                  <c:v>16.32657</c:v>
                </c:pt>
                <c:pt idx="66">
                  <c:v>16.46087</c:v>
                </c:pt>
                <c:pt idx="67">
                  <c:v>16.593990000000002</c:v>
                </c:pt>
                <c:pt idx="68">
                  <c:v>16.727270000000001</c:v>
                </c:pt>
                <c:pt idx="69">
                  <c:v>16.861149999999999</c:v>
                </c:pt>
                <c:pt idx="70">
                  <c:v>16.99465</c:v>
                </c:pt>
                <c:pt idx="71">
                  <c:v>17.126930000000002</c:v>
                </c:pt>
                <c:pt idx="72">
                  <c:v>17.260819999999999</c:v>
                </c:pt>
                <c:pt idx="73">
                  <c:v>17.394780000000001</c:v>
                </c:pt>
                <c:pt idx="74">
                  <c:v>17.52871</c:v>
                </c:pt>
                <c:pt idx="75">
                  <c:v>17.663740000000001</c:v>
                </c:pt>
                <c:pt idx="76">
                  <c:v>17.795480000000001</c:v>
                </c:pt>
                <c:pt idx="77">
                  <c:v>17.928370000000001</c:v>
                </c:pt>
                <c:pt idx="78">
                  <c:v>18.060700000000001</c:v>
                </c:pt>
                <c:pt idx="79">
                  <c:v>18.196020000000001</c:v>
                </c:pt>
                <c:pt idx="80">
                  <c:v>18.328579999999999</c:v>
                </c:pt>
                <c:pt idx="81">
                  <c:v>18.459879999999998</c:v>
                </c:pt>
                <c:pt idx="82">
                  <c:v>18.591989999999999</c:v>
                </c:pt>
                <c:pt idx="83">
                  <c:v>18.726469999999999</c:v>
                </c:pt>
                <c:pt idx="84">
                  <c:v>18.859529999999999</c:v>
                </c:pt>
                <c:pt idx="85">
                  <c:v>18.99193</c:v>
                </c:pt>
                <c:pt idx="86">
                  <c:v>19.125610000000002</c:v>
                </c:pt>
                <c:pt idx="87">
                  <c:v>19.25929</c:v>
                </c:pt>
                <c:pt idx="88">
                  <c:v>19.392389999999999</c:v>
                </c:pt>
                <c:pt idx="89">
                  <c:v>19.526540000000001</c:v>
                </c:pt>
                <c:pt idx="90">
                  <c:v>19.658989999999999</c:v>
                </c:pt>
                <c:pt idx="91">
                  <c:v>19.79243</c:v>
                </c:pt>
                <c:pt idx="92">
                  <c:v>19.92576</c:v>
                </c:pt>
                <c:pt idx="93">
                  <c:v>20.05932</c:v>
                </c:pt>
                <c:pt idx="94">
                  <c:v>20.19265</c:v>
                </c:pt>
                <c:pt idx="95">
                  <c:v>20.325199999999999</c:v>
                </c:pt>
                <c:pt idx="96">
                  <c:v>20.45909</c:v>
                </c:pt>
                <c:pt idx="97">
                  <c:v>20.59299</c:v>
                </c:pt>
                <c:pt idx="98">
                  <c:v>20.72635</c:v>
                </c:pt>
                <c:pt idx="99">
                  <c:v>20.859960000000001</c:v>
                </c:pt>
                <c:pt idx="100">
                  <c:v>20.993829999999999</c:v>
                </c:pt>
                <c:pt idx="101">
                  <c:v>21.126619999999999</c:v>
                </c:pt>
                <c:pt idx="102">
                  <c:v>21.260899999999999</c:v>
                </c:pt>
                <c:pt idx="103">
                  <c:v>21.394770000000001</c:v>
                </c:pt>
                <c:pt idx="104">
                  <c:v>21.52769</c:v>
                </c:pt>
                <c:pt idx="105">
                  <c:v>21.661290000000001</c:v>
                </c:pt>
                <c:pt idx="106">
                  <c:v>21.794360000000001</c:v>
                </c:pt>
                <c:pt idx="107">
                  <c:v>21.928180000000001</c:v>
                </c:pt>
                <c:pt idx="108">
                  <c:v>22.061260000000001</c:v>
                </c:pt>
                <c:pt idx="109">
                  <c:v>22.191469999999999</c:v>
                </c:pt>
                <c:pt idx="110">
                  <c:v>22.320640000000001</c:v>
                </c:pt>
                <c:pt idx="111">
                  <c:v>22.454719999999998</c:v>
                </c:pt>
                <c:pt idx="112">
                  <c:v>22.587669999999999</c:v>
                </c:pt>
                <c:pt idx="113">
                  <c:v>22.720600000000001</c:v>
                </c:pt>
                <c:pt idx="114">
                  <c:v>22.853860000000001</c:v>
                </c:pt>
                <c:pt idx="115">
                  <c:v>22.986440000000002</c:v>
                </c:pt>
                <c:pt idx="116">
                  <c:v>23.12058</c:v>
                </c:pt>
                <c:pt idx="117">
                  <c:v>23.254940000000001</c:v>
                </c:pt>
                <c:pt idx="118">
                  <c:v>23.389489999999999</c:v>
                </c:pt>
                <c:pt idx="119">
                  <c:v>23.522670000000002</c:v>
                </c:pt>
                <c:pt idx="120">
                  <c:v>23.656030000000001</c:v>
                </c:pt>
                <c:pt idx="121">
                  <c:v>23.787790000000001</c:v>
                </c:pt>
                <c:pt idx="122">
                  <c:v>23.92173</c:v>
                </c:pt>
                <c:pt idx="123">
                  <c:v>24.05518</c:v>
                </c:pt>
                <c:pt idx="124">
                  <c:v>24.18938</c:v>
                </c:pt>
                <c:pt idx="125">
                  <c:v>24.32283</c:v>
                </c:pt>
                <c:pt idx="126">
                  <c:v>24.45712</c:v>
                </c:pt>
                <c:pt idx="127">
                  <c:v>24.589400000000001</c:v>
                </c:pt>
                <c:pt idx="128">
                  <c:v>24.721360000000001</c:v>
                </c:pt>
                <c:pt idx="129">
                  <c:v>24.855039999999999</c:v>
                </c:pt>
                <c:pt idx="130">
                  <c:v>24.98884</c:v>
                </c:pt>
                <c:pt idx="131">
                  <c:v>25.121690000000001</c:v>
                </c:pt>
                <c:pt idx="132">
                  <c:v>25.25637</c:v>
                </c:pt>
                <c:pt idx="133">
                  <c:v>25.39021</c:v>
                </c:pt>
                <c:pt idx="134">
                  <c:v>25.523109999999999</c:v>
                </c:pt>
                <c:pt idx="135">
                  <c:v>25.655909999999999</c:v>
                </c:pt>
                <c:pt idx="136">
                  <c:v>25.788930000000001</c:v>
                </c:pt>
                <c:pt idx="137">
                  <c:v>25.92334</c:v>
                </c:pt>
                <c:pt idx="138">
                  <c:v>26.05452</c:v>
                </c:pt>
                <c:pt idx="139">
                  <c:v>26.185829999999999</c:v>
                </c:pt>
                <c:pt idx="140">
                  <c:v>26.320309999999999</c:v>
                </c:pt>
                <c:pt idx="141">
                  <c:v>26.45336</c:v>
                </c:pt>
                <c:pt idx="142">
                  <c:v>26.586790000000001</c:v>
                </c:pt>
                <c:pt idx="143">
                  <c:v>26.719899999999999</c:v>
                </c:pt>
                <c:pt idx="144">
                  <c:v>26.853819999999999</c:v>
                </c:pt>
                <c:pt idx="145">
                  <c:v>26.986499999999999</c:v>
                </c:pt>
                <c:pt idx="146">
                  <c:v>27.121220000000001</c:v>
                </c:pt>
                <c:pt idx="147">
                  <c:v>27.255179999999999</c:v>
                </c:pt>
                <c:pt idx="148">
                  <c:v>27.389220000000002</c:v>
                </c:pt>
                <c:pt idx="149">
                  <c:v>27.52272</c:v>
                </c:pt>
                <c:pt idx="150">
                  <c:v>27.65579</c:v>
                </c:pt>
                <c:pt idx="151">
                  <c:v>27.78838</c:v>
                </c:pt>
                <c:pt idx="152">
                  <c:v>27.921939999999999</c:v>
                </c:pt>
                <c:pt idx="153">
                  <c:v>28.055299999999999</c:v>
                </c:pt>
                <c:pt idx="154">
                  <c:v>28.18927</c:v>
                </c:pt>
                <c:pt idx="155">
                  <c:v>28.32255</c:v>
                </c:pt>
                <c:pt idx="156">
                  <c:v>28.457350000000002</c:v>
                </c:pt>
                <c:pt idx="157">
                  <c:v>28.5899</c:v>
                </c:pt>
                <c:pt idx="158">
                  <c:v>28.7224</c:v>
                </c:pt>
                <c:pt idx="159">
                  <c:v>28.856829999999999</c:v>
                </c:pt>
                <c:pt idx="160">
                  <c:v>28.989519999999999</c:v>
                </c:pt>
                <c:pt idx="161">
                  <c:v>29.122039999999998</c:v>
                </c:pt>
                <c:pt idx="162">
                  <c:v>29.2563</c:v>
                </c:pt>
                <c:pt idx="163">
                  <c:v>29.391159999999999</c:v>
                </c:pt>
                <c:pt idx="164">
                  <c:v>29.52478</c:v>
                </c:pt>
                <c:pt idx="165">
                  <c:v>29.65634</c:v>
                </c:pt>
                <c:pt idx="166">
                  <c:v>29.788869999999999</c:v>
                </c:pt>
                <c:pt idx="167">
                  <c:v>29.915369999999999</c:v>
                </c:pt>
                <c:pt idx="168">
                  <c:v>30.04833</c:v>
                </c:pt>
                <c:pt idx="169">
                  <c:v>30.181640000000002</c:v>
                </c:pt>
                <c:pt idx="170">
                  <c:v>30.313939999999999</c:v>
                </c:pt>
                <c:pt idx="171">
                  <c:v>30.447590000000002</c:v>
                </c:pt>
                <c:pt idx="172">
                  <c:v>30.580939999999998</c:v>
                </c:pt>
                <c:pt idx="173">
                  <c:v>30.714320000000001</c:v>
                </c:pt>
                <c:pt idx="174">
                  <c:v>30.847059999999999</c:v>
                </c:pt>
                <c:pt idx="175">
                  <c:v>30.981780000000001</c:v>
                </c:pt>
                <c:pt idx="176">
                  <c:v>31.115020000000001</c:v>
                </c:pt>
                <c:pt idx="177">
                  <c:v>31.248529999999999</c:v>
                </c:pt>
                <c:pt idx="178">
                  <c:v>31.382840000000002</c:v>
                </c:pt>
                <c:pt idx="179">
                  <c:v>31.515640000000001</c:v>
                </c:pt>
                <c:pt idx="180">
                  <c:v>31.64884</c:v>
                </c:pt>
                <c:pt idx="181">
                  <c:v>31.78172</c:v>
                </c:pt>
                <c:pt idx="182">
                  <c:v>31.917359999999999</c:v>
                </c:pt>
                <c:pt idx="183">
                  <c:v>32.048540000000003</c:v>
                </c:pt>
                <c:pt idx="184">
                  <c:v>32.181980000000003</c:v>
                </c:pt>
                <c:pt idx="185">
                  <c:v>32.316429999999997</c:v>
                </c:pt>
                <c:pt idx="186">
                  <c:v>32.44961</c:v>
                </c:pt>
                <c:pt idx="187">
                  <c:v>32.582369999999997</c:v>
                </c:pt>
                <c:pt idx="188">
                  <c:v>32.716009999999997</c:v>
                </c:pt>
                <c:pt idx="189">
                  <c:v>32.849240000000002</c:v>
                </c:pt>
                <c:pt idx="190">
                  <c:v>32.982439999999997</c:v>
                </c:pt>
                <c:pt idx="191">
                  <c:v>33.114980000000003</c:v>
                </c:pt>
                <c:pt idx="192">
                  <c:v>33.248730000000002</c:v>
                </c:pt>
                <c:pt idx="193">
                  <c:v>33.382390000000001</c:v>
                </c:pt>
                <c:pt idx="194">
                  <c:v>33.51567</c:v>
                </c:pt>
                <c:pt idx="195">
                  <c:v>33.646599999999999</c:v>
                </c:pt>
                <c:pt idx="196">
                  <c:v>33.777650000000001</c:v>
                </c:pt>
                <c:pt idx="197">
                  <c:v>33.91169</c:v>
                </c:pt>
                <c:pt idx="198">
                  <c:v>34.044379999999997</c:v>
                </c:pt>
                <c:pt idx="199">
                  <c:v>34.179299999999998</c:v>
                </c:pt>
                <c:pt idx="200">
                  <c:v>34.313870000000001</c:v>
                </c:pt>
                <c:pt idx="201">
                  <c:v>34.447580000000002</c:v>
                </c:pt>
                <c:pt idx="202">
                  <c:v>34.580329999999996</c:v>
                </c:pt>
                <c:pt idx="203">
                  <c:v>34.71358</c:v>
                </c:pt>
                <c:pt idx="204">
                  <c:v>34.846820000000001</c:v>
                </c:pt>
                <c:pt idx="205">
                  <c:v>34.978879999999997</c:v>
                </c:pt>
                <c:pt idx="206">
                  <c:v>35.113500000000002</c:v>
                </c:pt>
                <c:pt idx="207">
                  <c:v>35.247390000000003</c:v>
                </c:pt>
                <c:pt idx="208">
                  <c:v>35.379800000000003</c:v>
                </c:pt>
                <c:pt idx="209">
                  <c:v>35.513480000000001</c:v>
                </c:pt>
                <c:pt idx="210">
                  <c:v>35.647779999999997</c:v>
                </c:pt>
                <c:pt idx="211">
                  <c:v>35.780880000000003</c:v>
                </c:pt>
                <c:pt idx="212">
                  <c:v>35.915129999999998</c:v>
                </c:pt>
                <c:pt idx="213">
                  <c:v>36.048169999999999</c:v>
                </c:pt>
                <c:pt idx="214">
                  <c:v>36.181229999999999</c:v>
                </c:pt>
                <c:pt idx="215">
                  <c:v>36.314830000000001</c:v>
                </c:pt>
                <c:pt idx="216">
                  <c:v>36.449300000000001</c:v>
                </c:pt>
                <c:pt idx="217">
                  <c:v>36.582990000000002</c:v>
                </c:pt>
                <c:pt idx="218">
                  <c:v>36.715519999999998</c:v>
                </c:pt>
                <c:pt idx="219">
                  <c:v>36.84966</c:v>
                </c:pt>
                <c:pt idx="220">
                  <c:v>36.982860000000002</c:v>
                </c:pt>
                <c:pt idx="221">
                  <c:v>37.116770000000002</c:v>
                </c:pt>
                <c:pt idx="222">
                  <c:v>37.250010000000003</c:v>
                </c:pt>
                <c:pt idx="223">
                  <c:v>37.383299999999998</c:v>
                </c:pt>
                <c:pt idx="224">
                  <c:v>37.510719999999999</c:v>
                </c:pt>
                <c:pt idx="225">
                  <c:v>37.642420000000001</c:v>
                </c:pt>
                <c:pt idx="226">
                  <c:v>37.775410000000001</c:v>
                </c:pt>
                <c:pt idx="227">
                  <c:v>37.910130000000002</c:v>
                </c:pt>
                <c:pt idx="228">
                  <c:v>38.043340000000001</c:v>
                </c:pt>
                <c:pt idx="229">
                  <c:v>38.17633</c:v>
                </c:pt>
                <c:pt idx="230">
                  <c:v>38.310580000000002</c:v>
                </c:pt>
                <c:pt idx="231">
                  <c:v>38.4435</c:v>
                </c:pt>
                <c:pt idx="232">
                  <c:v>38.576999999999998</c:v>
                </c:pt>
                <c:pt idx="233">
                  <c:v>38.708979999999997</c:v>
                </c:pt>
                <c:pt idx="234">
                  <c:v>38.841929999999998</c:v>
                </c:pt>
                <c:pt idx="235">
                  <c:v>38.975290000000001</c:v>
                </c:pt>
                <c:pt idx="236">
                  <c:v>39.10951</c:v>
                </c:pt>
                <c:pt idx="237">
                  <c:v>39.242600000000003</c:v>
                </c:pt>
                <c:pt idx="238">
                  <c:v>39.377070000000003</c:v>
                </c:pt>
                <c:pt idx="239">
                  <c:v>39.509659999999997</c:v>
                </c:pt>
                <c:pt idx="240">
                  <c:v>39.642530000000001</c:v>
                </c:pt>
                <c:pt idx="241">
                  <c:v>39.776719999999997</c:v>
                </c:pt>
                <c:pt idx="242">
                  <c:v>39.911279999999998</c:v>
                </c:pt>
                <c:pt idx="243">
                  <c:v>40.044359999999998</c:v>
                </c:pt>
                <c:pt idx="244">
                  <c:v>40.17709</c:v>
                </c:pt>
                <c:pt idx="245">
                  <c:v>40.310130000000001</c:v>
                </c:pt>
                <c:pt idx="246">
                  <c:v>40.443199999999997</c:v>
                </c:pt>
                <c:pt idx="247">
                  <c:v>40.578429999999997</c:v>
                </c:pt>
                <c:pt idx="248">
                  <c:v>40.710810000000002</c:v>
                </c:pt>
                <c:pt idx="249">
                  <c:v>40.843899999999998</c:v>
                </c:pt>
                <c:pt idx="250">
                  <c:v>40.977400000000003</c:v>
                </c:pt>
                <c:pt idx="251">
                  <c:v>41.110999999999997</c:v>
                </c:pt>
                <c:pt idx="252">
                  <c:v>41.241930000000004</c:v>
                </c:pt>
                <c:pt idx="253">
                  <c:v>41.372929999999997</c:v>
                </c:pt>
                <c:pt idx="254">
                  <c:v>41.50712</c:v>
                </c:pt>
                <c:pt idx="255">
                  <c:v>41.642200000000003</c:v>
                </c:pt>
                <c:pt idx="256">
                  <c:v>41.774389999999997</c:v>
                </c:pt>
                <c:pt idx="257">
                  <c:v>41.908000000000001</c:v>
                </c:pt>
                <c:pt idx="258">
                  <c:v>42.042079999999999</c:v>
                </c:pt>
                <c:pt idx="259">
                  <c:v>42.173920000000003</c:v>
                </c:pt>
                <c:pt idx="260">
                  <c:v>42.306950000000001</c:v>
                </c:pt>
                <c:pt idx="261">
                  <c:v>42.44191</c:v>
                </c:pt>
                <c:pt idx="262">
                  <c:v>42.575130000000001</c:v>
                </c:pt>
                <c:pt idx="263">
                  <c:v>42.708179999999999</c:v>
                </c:pt>
                <c:pt idx="264">
                  <c:v>42.840719999999997</c:v>
                </c:pt>
                <c:pt idx="265">
                  <c:v>42.974229999999999</c:v>
                </c:pt>
                <c:pt idx="266">
                  <c:v>43.108269999999997</c:v>
                </c:pt>
                <c:pt idx="267">
                  <c:v>43.241439999999997</c:v>
                </c:pt>
                <c:pt idx="268">
                  <c:v>43.376240000000003</c:v>
                </c:pt>
                <c:pt idx="269">
                  <c:v>43.510350000000003</c:v>
                </c:pt>
                <c:pt idx="270">
                  <c:v>43.641970000000001</c:v>
                </c:pt>
                <c:pt idx="271">
                  <c:v>43.77581</c:v>
                </c:pt>
                <c:pt idx="272">
                  <c:v>43.909050000000001</c:v>
                </c:pt>
                <c:pt idx="273">
                  <c:v>44.042479999999998</c:v>
                </c:pt>
                <c:pt idx="274">
                  <c:v>44.17548</c:v>
                </c:pt>
                <c:pt idx="275">
                  <c:v>44.310279999999999</c:v>
                </c:pt>
                <c:pt idx="276">
                  <c:v>44.443040000000003</c:v>
                </c:pt>
                <c:pt idx="277">
                  <c:v>44.575319999999998</c:v>
                </c:pt>
                <c:pt idx="278">
                  <c:v>44.710059999999999</c:v>
                </c:pt>
                <c:pt idx="279">
                  <c:v>44.843089999999997</c:v>
                </c:pt>
                <c:pt idx="280">
                  <c:v>44.975499999999997</c:v>
                </c:pt>
                <c:pt idx="281">
                  <c:v>45.107779999999998</c:v>
                </c:pt>
                <c:pt idx="282">
                  <c:v>45.23762</c:v>
                </c:pt>
                <c:pt idx="283">
                  <c:v>45.371380000000002</c:v>
                </c:pt>
                <c:pt idx="284">
                  <c:v>45.505220000000001</c:v>
                </c:pt>
                <c:pt idx="285">
                  <c:v>45.638910000000003</c:v>
                </c:pt>
                <c:pt idx="286">
                  <c:v>45.77084</c:v>
                </c:pt>
                <c:pt idx="287">
                  <c:v>45.903359999999999</c:v>
                </c:pt>
                <c:pt idx="288">
                  <c:v>46.038670000000003</c:v>
                </c:pt>
                <c:pt idx="289">
                  <c:v>46.170560000000002</c:v>
                </c:pt>
                <c:pt idx="290">
                  <c:v>46.304250000000003</c:v>
                </c:pt>
                <c:pt idx="291">
                  <c:v>46.438029999999998</c:v>
                </c:pt>
                <c:pt idx="292">
                  <c:v>46.572139999999997</c:v>
                </c:pt>
                <c:pt idx="293">
                  <c:v>46.706130000000002</c:v>
                </c:pt>
                <c:pt idx="294">
                  <c:v>46.839500000000001</c:v>
                </c:pt>
                <c:pt idx="295">
                  <c:v>46.97184</c:v>
                </c:pt>
                <c:pt idx="296">
                  <c:v>47.105699999999999</c:v>
                </c:pt>
                <c:pt idx="297">
                  <c:v>47.239620000000002</c:v>
                </c:pt>
                <c:pt idx="298">
                  <c:v>47.372729999999997</c:v>
                </c:pt>
                <c:pt idx="299">
                  <c:v>47.50723</c:v>
                </c:pt>
                <c:pt idx="300">
                  <c:v>47.63908</c:v>
                </c:pt>
                <c:pt idx="301">
                  <c:v>47.772930000000002</c:v>
                </c:pt>
                <c:pt idx="302">
                  <c:v>47.90605</c:v>
                </c:pt>
                <c:pt idx="303">
                  <c:v>48.038809999999998</c:v>
                </c:pt>
                <c:pt idx="304">
                  <c:v>48.17304</c:v>
                </c:pt>
                <c:pt idx="305">
                  <c:v>48.305799999999998</c:v>
                </c:pt>
                <c:pt idx="306">
                  <c:v>48.439909999999998</c:v>
                </c:pt>
                <c:pt idx="307">
                  <c:v>48.572789999999998</c:v>
                </c:pt>
                <c:pt idx="308">
                  <c:v>48.707450000000001</c:v>
                </c:pt>
                <c:pt idx="309">
                  <c:v>48.84102</c:v>
                </c:pt>
                <c:pt idx="310">
                  <c:v>48.97343</c:v>
                </c:pt>
                <c:pt idx="311">
                  <c:v>49.104700000000001</c:v>
                </c:pt>
                <c:pt idx="312">
                  <c:v>49.236800000000002</c:v>
                </c:pt>
                <c:pt idx="313">
                  <c:v>49.370629999999998</c:v>
                </c:pt>
                <c:pt idx="314">
                  <c:v>49.503660000000004</c:v>
                </c:pt>
                <c:pt idx="315">
                  <c:v>49.636029999999998</c:v>
                </c:pt>
                <c:pt idx="316">
                  <c:v>49.7712</c:v>
                </c:pt>
                <c:pt idx="317">
                  <c:v>49.904710000000001</c:v>
                </c:pt>
                <c:pt idx="318">
                  <c:v>50.036909999999999</c:v>
                </c:pt>
                <c:pt idx="319">
                  <c:v>50.170780000000001</c:v>
                </c:pt>
                <c:pt idx="320">
                  <c:v>50.305239999999998</c:v>
                </c:pt>
                <c:pt idx="321">
                  <c:v>50.437220000000003</c:v>
                </c:pt>
                <c:pt idx="322">
                  <c:v>50.570990000000002</c:v>
                </c:pt>
                <c:pt idx="323">
                  <c:v>50.70429</c:v>
                </c:pt>
                <c:pt idx="324">
                  <c:v>50.838230000000003</c:v>
                </c:pt>
                <c:pt idx="325">
                  <c:v>50.97137</c:v>
                </c:pt>
                <c:pt idx="326">
                  <c:v>51.105339999999998</c:v>
                </c:pt>
                <c:pt idx="327">
                  <c:v>51.238079999999997</c:v>
                </c:pt>
                <c:pt idx="328">
                  <c:v>51.371079999999999</c:v>
                </c:pt>
                <c:pt idx="329">
                  <c:v>51.504219999999997</c:v>
                </c:pt>
                <c:pt idx="330">
                  <c:v>51.637140000000002</c:v>
                </c:pt>
                <c:pt idx="331">
                  <c:v>51.770310000000002</c:v>
                </c:pt>
                <c:pt idx="332">
                  <c:v>51.90372</c:v>
                </c:pt>
                <c:pt idx="333">
                  <c:v>52.03745</c:v>
                </c:pt>
                <c:pt idx="334">
                  <c:v>52.17154</c:v>
                </c:pt>
                <c:pt idx="335">
                  <c:v>52.304499999999997</c:v>
                </c:pt>
                <c:pt idx="336">
                  <c:v>52.438809999999997</c:v>
                </c:pt>
                <c:pt idx="337">
                  <c:v>52.572380000000003</c:v>
                </c:pt>
                <c:pt idx="338">
                  <c:v>52.705219999999997</c:v>
                </c:pt>
                <c:pt idx="339">
                  <c:v>52.835790000000003</c:v>
                </c:pt>
                <c:pt idx="340">
                  <c:v>52.96631</c:v>
                </c:pt>
                <c:pt idx="341">
                  <c:v>53.09881</c:v>
                </c:pt>
                <c:pt idx="342">
                  <c:v>53.231670000000001</c:v>
                </c:pt>
                <c:pt idx="343">
                  <c:v>53.36739</c:v>
                </c:pt>
                <c:pt idx="344">
                  <c:v>53.49944</c:v>
                </c:pt>
                <c:pt idx="345">
                  <c:v>53.633949999999999</c:v>
                </c:pt>
                <c:pt idx="346">
                  <c:v>53.766570000000002</c:v>
                </c:pt>
                <c:pt idx="347">
                  <c:v>53.898260000000001</c:v>
                </c:pt>
                <c:pt idx="348">
                  <c:v>54.031019999999998</c:v>
                </c:pt>
                <c:pt idx="349">
                  <c:v>54.165559999999999</c:v>
                </c:pt>
                <c:pt idx="350">
                  <c:v>54.299169999999997</c:v>
                </c:pt>
                <c:pt idx="351">
                  <c:v>54.431710000000002</c:v>
                </c:pt>
                <c:pt idx="352">
                  <c:v>54.564869999999999</c:v>
                </c:pt>
                <c:pt idx="353">
                  <c:v>54.698399999999999</c:v>
                </c:pt>
                <c:pt idx="354">
                  <c:v>54.831940000000003</c:v>
                </c:pt>
                <c:pt idx="355">
                  <c:v>54.96611</c:v>
                </c:pt>
                <c:pt idx="356">
                  <c:v>55.099600000000002</c:v>
                </c:pt>
                <c:pt idx="357">
                  <c:v>55.232300000000002</c:v>
                </c:pt>
                <c:pt idx="358">
                  <c:v>55.365310000000001</c:v>
                </c:pt>
                <c:pt idx="359">
                  <c:v>55.498309999999996</c:v>
                </c:pt>
                <c:pt idx="360">
                  <c:v>55.631030000000003</c:v>
                </c:pt>
                <c:pt idx="361">
                  <c:v>55.765039999999999</c:v>
                </c:pt>
                <c:pt idx="362">
                  <c:v>55.898919999999997</c:v>
                </c:pt>
                <c:pt idx="363">
                  <c:v>56.031750000000002</c:v>
                </c:pt>
                <c:pt idx="364">
                  <c:v>56.165999999999997</c:v>
                </c:pt>
                <c:pt idx="365">
                  <c:v>56.299120000000002</c:v>
                </c:pt>
                <c:pt idx="366">
                  <c:v>56.431809999999999</c:v>
                </c:pt>
                <c:pt idx="367">
                  <c:v>56.566450000000003</c:v>
                </c:pt>
                <c:pt idx="368">
                  <c:v>56.697690000000001</c:v>
                </c:pt>
                <c:pt idx="369">
                  <c:v>56.830930000000002</c:v>
                </c:pt>
                <c:pt idx="370">
                  <c:v>56.963659999999997</c:v>
                </c:pt>
                <c:pt idx="371">
                  <c:v>57.0974</c:v>
                </c:pt>
                <c:pt idx="372">
                  <c:v>57.230730000000001</c:v>
                </c:pt>
                <c:pt idx="373">
                  <c:v>57.364260000000002</c:v>
                </c:pt>
                <c:pt idx="374">
                  <c:v>57.49774</c:v>
                </c:pt>
                <c:pt idx="375">
                  <c:v>57.630189999999999</c:v>
                </c:pt>
                <c:pt idx="376">
                  <c:v>57.762779999999999</c:v>
                </c:pt>
                <c:pt idx="377">
                  <c:v>57.89564</c:v>
                </c:pt>
                <c:pt idx="378">
                  <c:v>58.029670000000003</c:v>
                </c:pt>
                <c:pt idx="379">
                  <c:v>58.16234</c:v>
                </c:pt>
                <c:pt idx="380">
                  <c:v>58.294339999999998</c:v>
                </c:pt>
                <c:pt idx="381">
                  <c:v>58.428959999999996</c:v>
                </c:pt>
                <c:pt idx="382">
                  <c:v>58.561669999999999</c:v>
                </c:pt>
                <c:pt idx="383">
                  <c:v>58.695700000000002</c:v>
                </c:pt>
                <c:pt idx="384">
                  <c:v>58.830869999999997</c:v>
                </c:pt>
                <c:pt idx="385">
                  <c:v>58.963230000000003</c:v>
                </c:pt>
                <c:pt idx="386">
                  <c:v>59.095849999999999</c:v>
                </c:pt>
                <c:pt idx="387">
                  <c:v>59.229750000000003</c:v>
                </c:pt>
                <c:pt idx="388">
                  <c:v>59.362540000000003</c:v>
                </c:pt>
                <c:pt idx="389">
                  <c:v>59.496220000000001</c:v>
                </c:pt>
                <c:pt idx="390">
                  <c:v>59.628959999999999</c:v>
                </c:pt>
                <c:pt idx="391">
                  <c:v>59.762250000000002</c:v>
                </c:pt>
              </c:numCache>
            </c:numRef>
          </c:xVal>
          <c:yVal>
            <c:numRef>
              <c:f>Sheet1!$I$2:$I$394</c:f>
              <c:numCache>
                <c:formatCode>General</c:formatCode>
                <c:ptCount val="393"/>
                <c:pt idx="14" formatCode="0.00E+00">
                  <c:v>-2.0886999999999998E-3</c:v>
                </c:pt>
                <c:pt idx="15" formatCode="0.00E+00">
                  <c:v>-2.92524E-3</c:v>
                </c:pt>
                <c:pt idx="16" formatCode="0.00E+00">
                  <c:v>-9.1290099999999993E-4</c:v>
                </c:pt>
                <c:pt idx="17" formatCode="0.00E+00">
                  <c:v>9.8629800000000004E-4</c:v>
                </c:pt>
                <c:pt idx="18" formatCode="0.00E+00">
                  <c:v>3.7014399999999999E-4</c:v>
                </c:pt>
                <c:pt idx="19" formatCode="0.00E+00">
                  <c:v>-1.21181E-3</c:v>
                </c:pt>
                <c:pt idx="20" formatCode="0.00E+00">
                  <c:v>-2.8915199999999999E-4</c:v>
                </c:pt>
                <c:pt idx="21" formatCode="0.00E+00">
                  <c:v>4.8197099999999998E-4</c:v>
                </c:pt>
                <c:pt idx="22" formatCode="0.00E+00">
                  <c:v>9.4749999999999999E-4</c:v>
                </c:pt>
                <c:pt idx="23" formatCode="0.00E+00">
                  <c:v>2.5342899999999998E-3</c:v>
                </c:pt>
                <c:pt idx="24" formatCode="0.00E+00">
                  <c:v>1.4181E-3</c:v>
                </c:pt>
                <c:pt idx="25" formatCode="0.00E+00">
                  <c:v>-9.8594599999999991E-4</c:v>
                </c:pt>
                <c:pt idx="26" formatCode="0.00E+00">
                  <c:v>8.5601600000000003E-4</c:v>
                </c:pt>
                <c:pt idx="27" formatCode="0.00E+00">
                  <c:v>1.61469E-4</c:v>
                </c:pt>
                <c:pt idx="28" formatCode="0.00E+00">
                  <c:v>-8.0495900000000006E-4</c:v>
                </c:pt>
                <c:pt idx="29" formatCode="0.00E+00">
                  <c:v>-1.80708E-3</c:v>
                </c:pt>
                <c:pt idx="30" formatCode="0.00E+00">
                  <c:v>9.9141700000000003E-6</c:v>
                </c:pt>
                <c:pt idx="31" formatCode="0.00E+00">
                  <c:v>-1.19263E-4</c:v>
                </c:pt>
                <c:pt idx="32" formatCode="0.00E+00">
                  <c:v>1.6949599999999999E-3</c:v>
                </c:pt>
                <c:pt idx="33" formatCode="0.00E+00">
                  <c:v>1.5738900000000001E-3</c:v>
                </c:pt>
                <c:pt idx="34" formatCode="0.00E+00">
                  <c:v>1.89147E-5</c:v>
                </c:pt>
                <c:pt idx="35" formatCode="0.00E+00">
                  <c:v>-1.0250599999999999E-3</c:v>
                </c:pt>
                <c:pt idx="36" formatCode="0.00E+00">
                  <c:v>-6.064419999999999E-4</c:v>
                </c:pt>
                <c:pt idx="37" formatCode="0.00E+00">
                  <c:v>-1.06616E-3</c:v>
                </c:pt>
                <c:pt idx="38" formatCode="0.00E+00">
                  <c:v>2.2935799999999999E-3</c:v>
                </c:pt>
                <c:pt idx="39" formatCode="0.00E+00">
                  <c:v>2.6265999999999998E-3</c:v>
                </c:pt>
                <c:pt idx="40" formatCode="0.00E+00">
                  <c:v>-8.0904700000000002E-4</c:v>
                </c:pt>
                <c:pt idx="41" formatCode="0.00E+00">
                  <c:v>-7.7482700000000007E-4</c:v>
                </c:pt>
                <c:pt idx="42" formatCode="0.00E+00">
                  <c:v>-4.4990899999999996E-4</c:v>
                </c:pt>
                <c:pt idx="43" formatCode="0.00E+00">
                  <c:v>-2.9921500000000003E-4</c:v>
                </c:pt>
                <c:pt idx="44" formatCode="0.00E+00">
                  <c:v>-8.7838299999999994E-4</c:v>
                </c:pt>
                <c:pt idx="45" formatCode="0.00E+00">
                  <c:v>-6.1549099999999991E-4</c:v>
                </c:pt>
                <c:pt idx="46" formatCode="0.00E+00">
                  <c:v>-1.5976799999999999E-4</c:v>
                </c:pt>
                <c:pt idx="47" formatCode="0.00E+00">
                  <c:v>-8.1934300000000005E-4</c:v>
                </c:pt>
                <c:pt idx="48" formatCode="0.00E+00">
                  <c:v>1.2254599999999998E-3</c:v>
                </c:pt>
                <c:pt idx="49" formatCode="0.00E+00">
                  <c:v>1.4943599999999999E-3</c:v>
                </c:pt>
                <c:pt idx="50" formatCode="0.00E+00">
                  <c:v>6.3485699999999996E-4</c:v>
                </c:pt>
                <c:pt idx="51" formatCode="0.00E+00">
                  <c:v>-1.26301E-4</c:v>
                </c:pt>
                <c:pt idx="52" formatCode="0.00E+00">
                  <c:v>1.05601E-3</c:v>
                </c:pt>
                <c:pt idx="53" formatCode="0.00E+00">
                  <c:v>-3.1255500000000001E-4</c:v>
                </c:pt>
                <c:pt idx="54" formatCode="0.00E+00">
                  <c:v>-1.0446800000000001E-3</c:v>
                </c:pt>
                <c:pt idx="55" formatCode="0.00E+00">
                  <c:v>6.9310500000000007E-4</c:v>
                </c:pt>
                <c:pt idx="56" formatCode="0.00E+00">
                  <c:v>6.8222399999999994E-4</c:v>
                </c:pt>
                <c:pt idx="57" formatCode="0.00E+00">
                  <c:v>-7.05714E-5</c:v>
                </c:pt>
                <c:pt idx="58" formatCode="0.00E+00">
                  <c:v>1.03732E-3</c:v>
                </c:pt>
                <c:pt idx="59" formatCode="0.00E+00">
                  <c:v>1.86488E-3</c:v>
                </c:pt>
                <c:pt idx="60" formatCode="0.00E+00">
                  <c:v>5.6181200000000008E-4</c:v>
                </c:pt>
                <c:pt idx="61" formatCode="0.00E+00">
                  <c:v>8.2195800000000002E-4</c:v>
                </c:pt>
                <c:pt idx="62" formatCode="0.00E+00">
                  <c:v>-6.9713800000000003E-4</c:v>
                </c:pt>
                <c:pt idx="63" formatCode="0.00E+00">
                  <c:v>-1.89076E-3</c:v>
                </c:pt>
                <c:pt idx="64" formatCode="0.00E+00">
                  <c:v>2.3235900000000002E-4</c:v>
                </c:pt>
                <c:pt idx="65" formatCode="0.00E+00">
                  <c:v>2.2039200000000003E-3</c:v>
                </c:pt>
                <c:pt idx="66" formatCode="0.00E+00">
                  <c:v>-5.0520600000000001E-4</c:v>
                </c:pt>
                <c:pt idx="67" formatCode="0.00E+00">
                  <c:v>-2.1885400000000001E-3</c:v>
                </c:pt>
                <c:pt idx="68" formatCode="0.00E+00">
                  <c:v>1.2947E-3</c:v>
                </c:pt>
                <c:pt idx="69" formatCode="0.00E+00">
                  <c:v>8.8626000000000004E-4</c:v>
                </c:pt>
                <c:pt idx="70" formatCode="0.00E+00">
                  <c:v>-4.6739199999999996E-4</c:v>
                </c:pt>
                <c:pt idx="71" formatCode="0.00E+00">
                  <c:v>7.4591400000000006E-5</c:v>
                </c:pt>
                <c:pt idx="72" formatCode="0.00E+00">
                  <c:v>-1.3188900000000001E-3</c:v>
                </c:pt>
                <c:pt idx="73" formatCode="0.00E+00">
                  <c:v>-3.4667299999999999E-3</c:v>
                </c:pt>
                <c:pt idx="74" formatCode="0.00E+00">
                  <c:v>-1.4130900000000001E-3</c:v>
                </c:pt>
                <c:pt idx="75" formatCode="0.00E+00">
                  <c:v>3.5553799999999997E-4</c:v>
                </c:pt>
                <c:pt idx="76" formatCode="0.00E+00">
                  <c:v>1.4405500000000001E-3</c:v>
                </c:pt>
                <c:pt idx="77" formatCode="0.00E+00">
                  <c:v>2.5493099999999999E-3</c:v>
                </c:pt>
                <c:pt idx="78" formatCode="0.00E+00">
                  <c:v>3.4720599999999999E-3</c:v>
                </c:pt>
                <c:pt idx="79" formatCode="0.00E+00">
                  <c:v>4.6316700000000001E-3</c:v>
                </c:pt>
                <c:pt idx="80" formatCode="0.00E+00">
                  <c:v>4.9298300000000005E-3</c:v>
                </c:pt>
                <c:pt idx="81" formatCode="0.00E+00">
                  <c:v>6.4110699999999996E-3</c:v>
                </c:pt>
                <c:pt idx="82" formatCode="0.00E+00">
                  <c:v>8.0564499999999997E-3</c:v>
                </c:pt>
                <c:pt idx="83" formatCode="0.00E+00">
                  <c:v>5.5175600000000003E-3</c:v>
                </c:pt>
                <c:pt idx="84" formatCode="0.00E+00">
                  <c:v>7.0565799999999998E-3</c:v>
                </c:pt>
                <c:pt idx="85" formatCode="0.00E+00">
                  <c:v>9.8857500000000004E-3</c:v>
                </c:pt>
                <c:pt idx="86" formatCode="0.00E+00">
                  <c:v>1.00713E-2</c:v>
                </c:pt>
                <c:pt idx="87" formatCode="0.00E+00">
                  <c:v>9.1789999999999997E-3</c:v>
                </c:pt>
                <c:pt idx="88" formatCode="0.00E+00">
                  <c:v>1.28962E-2</c:v>
                </c:pt>
                <c:pt idx="89" formatCode="0.00E+00">
                  <c:v>1.14877E-2</c:v>
                </c:pt>
                <c:pt idx="90" formatCode="0.00E+00">
                  <c:v>1.08428E-2</c:v>
                </c:pt>
                <c:pt idx="91" formatCode="0.00E+00">
                  <c:v>1.47739E-2</c:v>
                </c:pt>
                <c:pt idx="92" formatCode="0.00E+00">
                  <c:v>1.3971200000000001E-2</c:v>
                </c:pt>
                <c:pt idx="93" formatCode="0.00E+00">
                  <c:v>1.2497099999999999E-2</c:v>
                </c:pt>
                <c:pt idx="94" formatCode="0.00E+00">
                  <c:v>1.34278E-2</c:v>
                </c:pt>
                <c:pt idx="95" formatCode="0.00E+00">
                  <c:v>1.50101E-2</c:v>
                </c:pt>
                <c:pt idx="96" formatCode="0.00E+00">
                  <c:v>1.6242799999999998E-2</c:v>
                </c:pt>
                <c:pt idx="97" formatCode="0.00E+00">
                  <c:v>1.5425099999999999E-2</c:v>
                </c:pt>
                <c:pt idx="98" formatCode="0.00E+00">
                  <c:v>1.36647E-2</c:v>
                </c:pt>
                <c:pt idx="99" formatCode="0.00E+00">
                  <c:v>1.2454999999999999E-2</c:v>
                </c:pt>
                <c:pt idx="100" formatCode="0.00E+00">
                  <c:v>1.34967E-2</c:v>
                </c:pt>
                <c:pt idx="101" formatCode="0.00E+00">
                  <c:v>1.2955E-2</c:v>
                </c:pt>
                <c:pt idx="102" formatCode="0.00E+00">
                  <c:v>1.4536299999999999E-2</c:v>
                </c:pt>
                <c:pt idx="103" formatCode="0.00E+00">
                  <c:v>1.4834E-2</c:v>
                </c:pt>
                <c:pt idx="104" formatCode="0.00E+00">
                  <c:v>1.4445600000000001E-2</c:v>
                </c:pt>
                <c:pt idx="105" formatCode="0.00E+00">
                  <c:v>1.32278E-2</c:v>
                </c:pt>
                <c:pt idx="106" formatCode="0.00E+00">
                  <c:v>1.5137299999999999E-2</c:v>
                </c:pt>
                <c:pt idx="107" formatCode="0.00E+00">
                  <c:v>1.3311499999999999E-2</c:v>
                </c:pt>
                <c:pt idx="108" formatCode="0.00E+00">
                  <c:v>1.17366E-2</c:v>
                </c:pt>
                <c:pt idx="109" formatCode="0.00E+00">
                  <c:v>9.6979900000000001E-3</c:v>
                </c:pt>
                <c:pt idx="110" formatCode="0.00E+00">
                  <c:v>5.6904599999999996E-3</c:v>
                </c:pt>
                <c:pt idx="111" formatCode="0.00E+00">
                  <c:v>4.5606000000000006E-3</c:v>
                </c:pt>
                <c:pt idx="112" formatCode="0.00E+00">
                  <c:v>6.35551E-3</c:v>
                </c:pt>
                <c:pt idx="113" formatCode="0.00E+00">
                  <c:v>6.4376400000000005E-3</c:v>
                </c:pt>
                <c:pt idx="114" formatCode="0.00E+00">
                  <c:v>7.3282700000000004E-3</c:v>
                </c:pt>
                <c:pt idx="115" formatCode="0.00E+00">
                  <c:v>5.0710799999999995E-3</c:v>
                </c:pt>
                <c:pt idx="116" formatCode="0.00E+00">
                  <c:v>4.21442E-3</c:v>
                </c:pt>
                <c:pt idx="117" formatCode="0.00E+00">
                  <c:v>4.1941900000000004E-3</c:v>
                </c:pt>
                <c:pt idx="118" formatCode="0.00E+00">
                  <c:v>3.74537E-3</c:v>
                </c:pt>
                <c:pt idx="119" formatCode="0.00E+00">
                  <c:v>5.6504400000000005E-3</c:v>
                </c:pt>
                <c:pt idx="120" formatCode="0.00E+00">
                  <c:v>5.5185700000000004E-3</c:v>
                </c:pt>
                <c:pt idx="121" formatCode="0.00E+00">
                  <c:v>4.1667500000000003E-3</c:v>
                </c:pt>
                <c:pt idx="122" formatCode="0.00E+00">
                  <c:v>4.4958899999999998E-3</c:v>
                </c:pt>
                <c:pt idx="123" formatCode="0.00E+00">
                  <c:v>4.1795699999999996E-3</c:v>
                </c:pt>
                <c:pt idx="124" formatCode="0.00E+00">
                  <c:v>5.3376000000000005E-3</c:v>
                </c:pt>
                <c:pt idx="125" formatCode="0.00E+00">
                  <c:v>8.7189399999999997E-3</c:v>
                </c:pt>
                <c:pt idx="126" formatCode="0.00E+00">
                  <c:v>7.8007600000000003E-3</c:v>
                </c:pt>
                <c:pt idx="127" formatCode="0.00E+00">
                  <c:v>7.6882600000000006E-3</c:v>
                </c:pt>
                <c:pt idx="128" formatCode="0.00E+00">
                  <c:v>8.9274899999999997E-3</c:v>
                </c:pt>
                <c:pt idx="129" formatCode="0.00E+00">
                  <c:v>1.1354400000000001E-2</c:v>
                </c:pt>
                <c:pt idx="130" formatCode="0.00E+00">
                  <c:v>8.9003499999999996E-3</c:v>
                </c:pt>
                <c:pt idx="131" formatCode="0.00E+00">
                  <c:v>9.8489800000000002E-3</c:v>
                </c:pt>
                <c:pt idx="132" formatCode="0.00E+00">
                  <c:v>1.40167E-2</c:v>
                </c:pt>
                <c:pt idx="133" formatCode="0.00E+00">
                  <c:v>1.15309E-2</c:v>
                </c:pt>
                <c:pt idx="134" formatCode="0.00E+00">
                  <c:v>1.1779700000000001E-2</c:v>
                </c:pt>
                <c:pt idx="135" formatCode="0.00E+00">
                  <c:v>1.46293E-2</c:v>
                </c:pt>
                <c:pt idx="136" formatCode="0.00E+00">
                  <c:v>1.6581499999999999E-2</c:v>
                </c:pt>
                <c:pt idx="137" formatCode="0.00E+00">
                  <c:v>1.65592E-2</c:v>
                </c:pt>
                <c:pt idx="138" formatCode="0.00E+00">
                  <c:v>1.7297699999999999E-2</c:v>
                </c:pt>
                <c:pt idx="139" formatCode="0.00E+00">
                  <c:v>1.8890500000000001E-2</c:v>
                </c:pt>
                <c:pt idx="140" formatCode="0.00E+00">
                  <c:v>1.9093500000000003E-2</c:v>
                </c:pt>
                <c:pt idx="141" formatCode="0.00E+00">
                  <c:v>1.9124000000000002E-2</c:v>
                </c:pt>
                <c:pt idx="142" formatCode="0.00E+00">
                  <c:v>1.76854E-2</c:v>
                </c:pt>
                <c:pt idx="143" formatCode="0.00E+00">
                  <c:v>1.7245099999999999E-2</c:v>
                </c:pt>
                <c:pt idx="144" formatCode="0.00E+00">
                  <c:v>1.7966099999999999E-2</c:v>
                </c:pt>
                <c:pt idx="145" formatCode="0.00E+00">
                  <c:v>1.8002600000000001E-2</c:v>
                </c:pt>
                <c:pt idx="146" formatCode="0.00E+00">
                  <c:v>1.6017E-2</c:v>
                </c:pt>
                <c:pt idx="147" formatCode="0.00E+00">
                  <c:v>1.6951500000000001E-2</c:v>
                </c:pt>
                <c:pt idx="148" formatCode="0.00E+00">
                  <c:v>1.7516199999999999E-2</c:v>
                </c:pt>
                <c:pt idx="149" formatCode="0.00E+00">
                  <c:v>1.5691500000000001E-2</c:v>
                </c:pt>
                <c:pt idx="150" formatCode="0.00E+00">
                  <c:v>1.6032299999999999E-2</c:v>
                </c:pt>
                <c:pt idx="151" formatCode="0.00E+00">
                  <c:v>1.80325E-2</c:v>
                </c:pt>
                <c:pt idx="152" formatCode="0.00E+00">
                  <c:v>1.9484599999999998E-2</c:v>
                </c:pt>
                <c:pt idx="153" formatCode="0.00E+00">
                  <c:v>2.1815000000000001E-2</c:v>
                </c:pt>
                <c:pt idx="154" formatCode="0.00E+00">
                  <c:v>2.3566399999999998E-2</c:v>
                </c:pt>
                <c:pt idx="155" formatCode="0.00E+00">
                  <c:v>2.2334900000000001E-2</c:v>
                </c:pt>
                <c:pt idx="156" formatCode="0.00E+00">
                  <c:v>2.47852E-2</c:v>
                </c:pt>
                <c:pt idx="157" formatCode="0.00E+00">
                  <c:v>2.6520600000000002E-2</c:v>
                </c:pt>
                <c:pt idx="158" formatCode="0.00E+00">
                  <c:v>2.8259299999999998E-2</c:v>
                </c:pt>
                <c:pt idx="159" formatCode="0.00E+00">
                  <c:v>2.9096500000000001E-2</c:v>
                </c:pt>
                <c:pt idx="160" formatCode="0.00E+00">
                  <c:v>3.3201000000000001E-2</c:v>
                </c:pt>
                <c:pt idx="161" formatCode="0.00E+00">
                  <c:v>3.7642700000000001E-2</c:v>
                </c:pt>
                <c:pt idx="162" formatCode="0.00E+00">
                  <c:v>4.3225700000000006E-2</c:v>
                </c:pt>
                <c:pt idx="163" formatCode="0.00E+00">
                  <c:v>4.3157799999999996E-2</c:v>
                </c:pt>
                <c:pt idx="164" formatCode="0.00E+00">
                  <c:v>4.3056699999999996E-2</c:v>
                </c:pt>
                <c:pt idx="165" formatCode="0.00E+00">
                  <c:v>4.1667999999999997E-2</c:v>
                </c:pt>
                <c:pt idx="166" formatCode="0.00E+00">
                  <c:v>3.96508E-2</c:v>
                </c:pt>
                <c:pt idx="167" formatCode="0.00E+00">
                  <c:v>3.8213500000000004E-2</c:v>
                </c:pt>
                <c:pt idx="168" formatCode="0.00E+00">
                  <c:v>4.2696099999999994E-2</c:v>
                </c:pt>
                <c:pt idx="169" formatCode="0.00E+00">
                  <c:v>4.48461E-2</c:v>
                </c:pt>
                <c:pt idx="170" formatCode="0.00E+00">
                  <c:v>4.6125800000000002E-2</c:v>
                </c:pt>
                <c:pt idx="171" formatCode="0.00E+00">
                  <c:v>4.5977400000000002E-2</c:v>
                </c:pt>
                <c:pt idx="172" formatCode="0.00E+00">
                  <c:v>4.71349E-2</c:v>
                </c:pt>
                <c:pt idx="173" formatCode="0.00E+00">
                  <c:v>4.9950700000000001E-2</c:v>
                </c:pt>
                <c:pt idx="174" formatCode="0.00E+00">
                  <c:v>5.0695000000000004E-2</c:v>
                </c:pt>
                <c:pt idx="175" formatCode="0.00E+00">
                  <c:v>5.0005500000000001E-2</c:v>
                </c:pt>
                <c:pt idx="176" formatCode="0.00E+00">
                  <c:v>5.0066100000000002E-2</c:v>
                </c:pt>
                <c:pt idx="177" formatCode="0.00E+00">
                  <c:v>5.1544600000000003E-2</c:v>
                </c:pt>
                <c:pt idx="178" formatCode="0.00E+00">
                  <c:v>5.2769799999999999E-2</c:v>
                </c:pt>
                <c:pt idx="179" formatCode="0.00E+00">
                  <c:v>5.4356099999999997E-2</c:v>
                </c:pt>
                <c:pt idx="180" formatCode="0.00E+00">
                  <c:v>5.4821399999999999E-2</c:v>
                </c:pt>
                <c:pt idx="181" formatCode="0.00E+00">
                  <c:v>5.4388699999999998E-2</c:v>
                </c:pt>
                <c:pt idx="182" formatCode="0.00E+00">
                  <c:v>5.5047400000000003E-2</c:v>
                </c:pt>
                <c:pt idx="183" formatCode="0.00E+00">
                  <c:v>5.4923400000000004E-2</c:v>
                </c:pt>
                <c:pt idx="184" formatCode="0.00E+00">
                  <c:v>5.4940000000000003E-2</c:v>
                </c:pt>
                <c:pt idx="185" formatCode="0.00E+00">
                  <c:v>5.6462199999999997E-2</c:v>
                </c:pt>
                <c:pt idx="186" formatCode="0.00E+00">
                  <c:v>5.7190200000000004E-2</c:v>
                </c:pt>
                <c:pt idx="187" formatCode="0.00E+00">
                  <c:v>5.73305E-2</c:v>
                </c:pt>
                <c:pt idx="188" formatCode="0.00E+00">
                  <c:v>5.8037300000000007E-2</c:v>
                </c:pt>
                <c:pt idx="189" formatCode="0.00E+00">
                  <c:v>5.7496699999999998E-2</c:v>
                </c:pt>
                <c:pt idx="190" formatCode="0.00E+00">
                  <c:v>5.7405999999999999E-2</c:v>
                </c:pt>
                <c:pt idx="191" formatCode="0.00E+00">
                  <c:v>5.8652299999999997E-2</c:v>
                </c:pt>
                <c:pt idx="192" formatCode="0.00E+00">
                  <c:v>6.0854699999999998E-2</c:v>
                </c:pt>
                <c:pt idx="193" formatCode="0.00E+00">
                  <c:v>6.5217800000000006E-2</c:v>
                </c:pt>
                <c:pt idx="194" formatCode="0.00E+00">
                  <c:v>6.6529000000000005E-2</c:v>
                </c:pt>
                <c:pt idx="195" formatCode="0.00E+00">
                  <c:v>6.6956600000000005E-2</c:v>
                </c:pt>
                <c:pt idx="196" formatCode="0.00E+00">
                  <c:v>6.7271399999999995E-2</c:v>
                </c:pt>
                <c:pt idx="197" formatCode="0.00E+00">
                  <c:v>6.7727999999999997E-2</c:v>
                </c:pt>
                <c:pt idx="198" formatCode="0.00E+00">
                  <c:v>6.6846900000000001E-2</c:v>
                </c:pt>
                <c:pt idx="199" formatCode="0.00E+00">
                  <c:v>6.9272200000000006E-2</c:v>
                </c:pt>
                <c:pt idx="200" formatCode="0.00E+00">
                  <c:v>6.9592100000000004E-2</c:v>
                </c:pt>
                <c:pt idx="201" formatCode="0.00E+00">
                  <c:v>7.1763800000000003E-2</c:v>
                </c:pt>
                <c:pt idx="202" formatCode="0.00E+00">
                  <c:v>7.5006099999999992E-2</c:v>
                </c:pt>
                <c:pt idx="203" formatCode="0.00E+00">
                  <c:v>7.8589199999999998E-2</c:v>
                </c:pt>
                <c:pt idx="204" formatCode="0.00E+00">
                  <c:v>8.0132399999999993E-2</c:v>
                </c:pt>
                <c:pt idx="205" formatCode="0.00E+00">
                  <c:v>8.0765500000000004E-2</c:v>
                </c:pt>
                <c:pt idx="206" formatCode="0.00E+00">
                  <c:v>8.15863E-2</c:v>
                </c:pt>
                <c:pt idx="207" formatCode="0.00E+00">
                  <c:v>8.085450000000001E-2</c:v>
                </c:pt>
                <c:pt idx="208" formatCode="0.00E+00">
                  <c:v>8.3665699999999996E-2</c:v>
                </c:pt>
                <c:pt idx="209" formatCode="0.00E+00">
                  <c:v>8.3984799999999998E-2</c:v>
                </c:pt>
                <c:pt idx="210" formatCode="0.00E+00">
                  <c:v>8.5286500000000001E-2</c:v>
                </c:pt>
                <c:pt idx="211" formatCode="0.00E+00">
                  <c:v>8.6784300000000009E-2</c:v>
                </c:pt>
                <c:pt idx="212" formatCode="0.00E+00">
                  <c:v>8.8570899999999994E-2</c:v>
                </c:pt>
                <c:pt idx="213" formatCode="0.00E+00">
                  <c:v>8.937210000000001E-2</c:v>
                </c:pt>
                <c:pt idx="214" formatCode="0.00E+00">
                  <c:v>9.0071600000000002E-2</c:v>
                </c:pt>
                <c:pt idx="215" formatCode="0.00E+00">
                  <c:v>8.9888599999999999E-2</c:v>
                </c:pt>
                <c:pt idx="216" formatCode="0.00E+00">
                  <c:v>9.36443E-2</c:v>
                </c:pt>
                <c:pt idx="217" formatCode="0.00E+00">
                  <c:v>9.7045100000000009E-2</c:v>
                </c:pt>
                <c:pt idx="218" formatCode="0.00E+00">
                  <c:v>9.9063200000000004E-2</c:v>
                </c:pt>
                <c:pt idx="219" formatCode="0.00E+00">
                  <c:v>9.9239100000000011E-2</c:v>
                </c:pt>
                <c:pt idx="220" formatCode="0.00E+00">
                  <c:v>9.9943800000000013E-2</c:v>
                </c:pt>
                <c:pt idx="221" formatCode="0.00E+00">
                  <c:v>9.9897700000000006E-2</c:v>
                </c:pt>
                <c:pt idx="222" formatCode="0.00E+00">
                  <c:v>0.10254199999999999</c:v>
                </c:pt>
                <c:pt idx="223" formatCode="0.00E+00">
                  <c:v>0.10517699999999999</c:v>
                </c:pt>
                <c:pt idx="224" formatCode="0.00E+00">
                  <c:v>0.11042</c:v>
                </c:pt>
                <c:pt idx="225" formatCode="0.00E+00">
                  <c:v>0.11175800000000001</c:v>
                </c:pt>
                <c:pt idx="226" formatCode="0.00E+00">
                  <c:v>0.112756</c:v>
                </c:pt>
                <c:pt idx="227" formatCode="0.00E+00">
                  <c:v>0.116177</c:v>
                </c:pt>
                <c:pt idx="228" formatCode="0.00E+00">
                  <c:v>0.12003399999999999</c:v>
                </c:pt>
                <c:pt idx="229" formatCode="0.00E+00">
                  <c:v>0.12501999999999999</c:v>
                </c:pt>
                <c:pt idx="230" formatCode="0.00E+00">
                  <c:v>0.127112</c:v>
                </c:pt>
                <c:pt idx="231" formatCode="0.00E+00">
                  <c:v>0.127774</c:v>
                </c:pt>
                <c:pt idx="232" formatCode="0.00E+00">
                  <c:v>0.133932</c:v>
                </c:pt>
                <c:pt idx="233" formatCode="0.00E+00">
                  <c:v>0.13520599999999999</c:v>
                </c:pt>
                <c:pt idx="234" formatCode="0.00E+00">
                  <c:v>0.13817599999999999</c:v>
                </c:pt>
                <c:pt idx="235" formatCode="0.00E+00">
                  <c:v>0.138351</c:v>
                </c:pt>
                <c:pt idx="236" formatCode="0.00E+00">
                  <c:v>0.13825699999999999</c:v>
                </c:pt>
                <c:pt idx="237" formatCode="0.00E+00">
                  <c:v>0.13993700000000001</c:v>
                </c:pt>
                <c:pt idx="238" formatCode="0.00E+00">
                  <c:v>0.14216899999999999</c:v>
                </c:pt>
                <c:pt idx="239" formatCode="0.00E+00">
                  <c:v>0.144959</c:v>
                </c:pt>
                <c:pt idx="240" formatCode="0.00E+00">
                  <c:v>0.149391</c:v>
                </c:pt>
                <c:pt idx="241" formatCode="0.00E+00">
                  <c:v>0.154475</c:v>
                </c:pt>
                <c:pt idx="242" formatCode="0.00E+00">
                  <c:v>0.157805</c:v>
                </c:pt>
                <c:pt idx="243" formatCode="0.00E+00">
                  <c:v>0.16486100000000001</c:v>
                </c:pt>
                <c:pt idx="244" formatCode="0.00E+00">
                  <c:v>0.16846399999999997</c:v>
                </c:pt>
                <c:pt idx="245" formatCode="0.00E+00">
                  <c:v>0.17285499999999998</c:v>
                </c:pt>
                <c:pt idx="246" formatCode="0.00E+00">
                  <c:v>0.17735800000000002</c:v>
                </c:pt>
                <c:pt idx="247" formatCode="0.00E+00">
                  <c:v>0.17935000000000001</c:v>
                </c:pt>
                <c:pt idx="248" formatCode="0.00E+00">
                  <c:v>0.18174399999999999</c:v>
                </c:pt>
                <c:pt idx="249" formatCode="0.00E+00">
                  <c:v>0.187199</c:v>
                </c:pt>
                <c:pt idx="250" formatCode="0.00E+00">
                  <c:v>0.19295599999999999</c:v>
                </c:pt>
                <c:pt idx="251" formatCode="0.00E+00">
                  <c:v>0.19606299999999999</c:v>
                </c:pt>
                <c:pt idx="252" formatCode="0.00E+00">
                  <c:v>0.19563900000000001</c:v>
                </c:pt>
                <c:pt idx="253" formatCode="0.00E+00">
                  <c:v>0.19398600000000002</c:v>
                </c:pt>
                <c:pt idx="254" formatCode="0.00E+00">
                  <c:v>0.19973799999999997</c:v>
                </c:pt>
                <c:pt idx="255" formatCode="0.00E+00">
                  <c:v>0.203321</c:v>
                </c:pt>
                <c:pt idx="256" formatCode="0.00E+00">
                  <c:v>0.20669199999999999</c:v>
                </c:pt>
                <c:pt idx="257" formatCode="0.00E+00">
                  <c:v>0.21241399999999999</c:v>
                </c:pt>
                <c:pt idx="258" formatCode="0.00E+00">
                  <c:v>0.21796299999999999</c:v>
                </c:pt>
                <c:pt idx="259" formatCode="0.00E+00">
                  <c:v>0.22521799999999997</c:v>
                </c:pt>
                <c:pt idx="260" formatCode="0.00E+00">
                  <c:v>0.23435700000000001</c:v>
                </c:pt>
                <c:pt idx="261" formatCode="0.00E+00">
                  <c:v>0.238958</c:v>
                </c:pt>
                <c:pt idx="262" formatCode="0.00E+00">
                  <c:v>0.239707</c:v>
                </c:pt>
                <c:pt idx="263" formatCode="0.00E+00">
                  <c:v>0.24335000000000001</c:v>
                </c:pt>
                <c:pt idx="264" formatCode="0.00E+00">
                  <c:v>0.24438399999999999</c:v>
                </c:pt>
                <c:pt idx="265" formatCode="0.00E+00">
                  <c:v>0.24543499999999999</c:v>
                </c:pt>
                <c:pt idx="266" formatCode="0.00E+00">
                  <c:v>0.24742199999999998</c:v>
                </c:pt>
                <c:pt idx="267" formatCode="0.00E+00">
                  <c:v>0.246285</c:v>
                </c:pt>
                <c:pt idx="268" formatCode="0.00E+00">
                  <c:v>0.24654199999999998</c:v>
                </c:pt>
                <c:pt idx="269" formatCode="0.00E+00">
                  <c:v>0.24629300000000001</c:v>
                </c:pt>
                <c:pt idx="270" formatCode="0.00E+00">
                  <c:v>0.24690199999999998</c:v>
                </c:pt>
                <c:pt idx="271" formatCode="0.00E+00">
                  <c:v>0.250218</c:v>
                </c:pt>
                <c:pt idx="272" formatCode="0.00E+00">
                  <c:v>0.251697</c:v>
                </c:pt>
                <c:pt idx="273" formatCode="0.00E+00">
                  <c:v>0.250801</c:v>
                </c:pt>
                <c:pt idx="274" formatCode="0.00E+00">
                  <c:v>0.249025</c:v>
                </c:pt>
                <c:pt idx="275" formatCode="0.00E+00">
                  <c:v>0.248998</c:v>
                </c:pt>
                <c:pt idx="276" formatCode="0.00E+00">
                  <c:v>0.24897</c:v>
                </c:pt>
                <c:pt idx="277" formatCode="0.00E+00">
                  <c:v>0.24930699999999997</c:v>
                </c:pt>
                <c:pt idx="278" formatCode="0.00E+00">
                  <c:v>0.24754599999999999</c:v>
                </c:pt>
                <c:pt idx="279" formatCode="0.00E+00">
                  <c:v>0.24510400000000002</c:v>
                </c:pt>
                <c:pt idx="280" formatCode="0.00E+00">
                  <c:v>0.241206</c:v>
                </c:pt>
                <c:pt idx="281" formatCode="0.00E+00">
                  <c:v>0.23780400000000002</c:v>
                </c:pt>
                <c:pt idx="282" formatCode="0.00E+00">
                  <c:v>0.23933199999999999</c:v>
                </c:pt>
                <c:pt idx="283" formatCode="0.00E+00">
                  <c:v>0.24306899999999998</c:v>
                </c:pt>
                <c:pt idx="284" formatCode="0.00E+00">
                  <c:v>0.23919900000000002</c:v>
                </c:pt>
                <c:pt idx="285" formatCode="0.00E+00">
                  <c:v>0.24093599999999998</c:v>
                </c:pt>
                <c:pt idx="286" formatCode="0.00E+00">
                  <c:v>0.245619</c:v>
                </c:pt>
                <c:pt idx="287" formatCode="0.00E+00">
                  <c:v>0.244921</c:v>
                </c:pt>
                <c:pt idx="288" formatCode="0.00E+00">
                  <c:v>0.247307</c:v>
                </c:pt>
                <c:pt idx="289" formatCode="0.00E+00">
                  <c:v>0.245201</c:v>
                </c:pt>
                <c:pt idx="290" formatCode="0.00E+00">
                  <c:v>0.24427399999999999</c:v>
                </c:pt>
                <c:pt idx="291" formatCode="0.00E+00">
                  <c:v>0.24589200000000003</c:v>
                </c:pt>
                <c:pt idx="292" formatCode="0.00E+00">
                  <c:v>0.24498199999999998</c:v>
                </c:pt>
                <c:pt idx="293" formatCode="0.00E+00">
                  <c:v>0.24468999999999999</c:v>
                </c:pt>
                <c:pt idx="294" formatCode="0.00E+00">
                  <c:v>0.247087</c:v>
                </c:pt>
                <c:pt idx="295" formatCode="0.00E+00">
                  <c:v>0.24774200000000002</c:v>
                </c:pt>
                <c:pt idx="296" formatCode="0.00E+00">
                  <c:v>0.248805</c:v>
                </c:pt>
                <c:pt idx="297" formatCode="0.00E+00">
                  <c:v>0.25161099999999997</c:v>
                </c:pt>
                <c:pt idx="298" formatCode="0.00E+00">
                  <c:v>0.25324400000000002</c:v>
                </c:pt>
                <c:pt idx="299" formatCode="0.00E+00">
                  <c:v>0.25772500000000004</c:v>
                </c:pt>
                <c:pt idx="300" formatCode="0.00E+00">
                  <c:v>0.257656</c:v>
                </c:pt>
                <c:pt idx="301" formatCode="0.00E+00">
                  <c:v>0.25961899999999999</c:v>
                </c:pt>
                <c:pt idx="302" formatCode="0.00E+00">
                  <c:v>0.26015300000000002</c:v>
                </c:pt>
                <c:pt idx="303" formatCode="0.00E+00">
                  <c:v>0.26015300000000002</c:v>
                </c:pt>
                <c:pt idx="304" formatCode="0.00E+00">
                  <c:v>0.258822</c:v>
                </c:pt>
                <c:pt idx="305" formatCode="0.00E+00">
                  <c:v>0.26140599999999997</c:v>
                </c:pt>
                <c:pt idx="306" formatCode="0.00E+00">
                  <c:v>0.26557799999999998</c:v>
                </c:pt>
                <c:pt idx="307" formatCode="0.00E+00">
                  <c:v>0.26636199999999999</c:v>
                </c:pt>
                <c:pt idx="308" formatCode="0.00E+00">
                  <c:v>0.264376</c:v>
                </c:pt>
                <c:pt idx="309" formatCode="0.00E+00">
                  <c:v>0.26270399999999999</c:v>
                </c:pt>
                <c:pt idx="310" formatCode="0.00E+00">
                  <c:v>0.26377200000000001</c:v>
                </c:pt>
                <c:pt idx="311" formatCode="0.00E+00">
                  <c:v>0.26459900000000003</c:v>
                </c:pt>
                <c:pt idx="312" formatCode="0.00E+00">
                  <c:v>0.258187</c:v>
                </c:pt>
                <c:pt idx="313" formatCode="0.00E+00">
                  <c:v>0.24768499999999999</c:v>
                </c:pt>
                <c:pt idx="314" formatCode="0.00E+00">
                  <c:v>0.23728100000000002</c:v>
                </c:pt>
                <c:pt idx="315" formatCode="0.00E+00">
                  <c:v>0.22547400000000001</c:v>
                </c:pt>
                <c:pt idx="316" formatCode="0.00E+00">
                  <c:v>0.20905599999999999</c:v>
                </c:pt>
                <c:pt idx="317" formatCode="0.00E+00">
                  <c:v>0.19609299999999999</c:v>
                </c:pt>
                <c:pt idx="318" formatCode="0.00E+00">
                  <c:v>0.18108400000000002</c:v>
                </c:pt>
                <c:pt idx="319" formatCode="0.00E+00">
                  <c:v>0.162302</c:v>
                </c:pt>
                <c:pt idx="320" formatCode="0.00E+00">
                  <c:v>0.145257</c:v>
                </c:pt>
                <c:pt idx="321" formatCode="0.00E+00">
                  <c:v>0.126915</c:v>
                </c:pt>
                <c:pt idx="322" formatCode="0.00E+00">
                  <c:v>0.110278</c:v>
                </c:pt>
                <c:pt idx="323" formatCode="0.00E+00">
                  <c:v>9.6387500000000001E-2</c:v>
                </c:pt>
                <c:pt idx="324" formatCode="0.00E+00">
                  <c:v>8.2053100000000004E-2</c:v>
                </c:pt>
                <c:pt idx="325" formatCode="0.00E+00">
                  <c:v>7.1849200000000002E-2</c:v>
                </c:pt>
                <c:pt idx="326" formatCode="0.00E+00">
                  <c:v>6.3294500000000004E-2</c:v>
                </c:pt>
                <c:pt idx="327" formatCode="0.00E+00">
                  <c:v>5.4232300000000004E-2</c:v>
                </c:pt>
                <c:pt idx="328" formatCode="0.00E+00">
                  <c:v>4.66933E-2</c:v>
                </c:pt>
                <c:pt idx="329" formatCode="0.00E+00">
                  <c:v>3.8769400000000002E-2</c:v>
                </c:pt>
                <c:pt idx="330" formatCode="0.00E+00">
                  <c:v>3.28525E-2</c:v>
                </c:pt>
                <c:pt idx="331" formatCode="0.00E+00">
                  <c:v>2.9017000000000001E-2</c:v>
                </c:pt>
                <c:pt idx="332" formatCode="0.00E+00">
                  <c:v>2.7665800000000001E-2</c:v>
                </c:pt>
                <c:pt idx="333" formatCode="0.00E+00">
                  <c:v>2.3888299999999998E-2</c:v>
                </c:pt>
                <c:pt idx="334" formatCode="0.00E+00">
                  <c:v>1.6304099999999998E-2</c:v>
                </c:pt>
                <c:pt idx="335" formatCode="0.00E+00">
                  <c:v>1.1932099999999999E-2</c:v>
                </c:pt>
                <c:pt idx="336" formatCode="0.00E+00">
                  <c:v>1.09178E-2</c:v>
                </c:pt>
                <c:pt idx="337" formatCode="0.00E+00">
                  <c:v>1.0236199999999999E-2</c:v>
                </c:pt>
                <c:pt idx="338" formatCode="0.00E+00">
                  <c:v>6.9762800000000005E-3</c:v>
                </c:pt>
                <c:pt idx="339" formatCode="0.00E+00">
                  <c:v>6.6385000000000003E-3</c:v>
                </c:pt>
                <c:pt idx="340" formatCode="0.00E+00">
                  <c:v>7.3823099999999996E-3</c:v>
                </c:pt>
                <c:pt idx="341" formatCode="0.00E+00">
                  <c:v>6.5397700000000003E-3</c:v>
                </c:pt>
                <c:pt idx="342" formatCode="0.00E+00">
                  <c:v>6.09452E-3</c:v>
                </c:pt>
                <c:pt idx="343" formatCode="0.00E+00">
                  <c:v>3.15599E-3</c:v>
                </c:pt>
                <c:pt idx="344" formatCode="0.00E+00">
                  <c:v>6.63767E-4</c:v>
                </c:pt>
                <c:pt idx="345" formatCode="0.00E+00">
                  <c:v>1.4436500000000001E-3</c:v>
                </c:pt>
                <c:pt idx="346" formatCode="0.00E+00">
                  <c:v>1.9608799999999999E-3</c:v>
                </c:pt>
                <c:pt idx="347" formatCode="0.00E+00">
                  <c:v>2.6881800000000001E-3</c:v>
                </c:pt>
                <c:pt idx="348" formatCode="0.00E+00">
                  <c:v>4.4407399999999994E-3</c:v>
                </c:pt>
                <c:pt idx="349" formatCode="0.00E+00">
                  <c:v>2.45583E-3</c:v>
                </c:pt>
                <c:pt idx="350" formatCode="0.00E+00">
                  <c:v>1.90137E-4</c:v>
                </c:pt>
                <c:pt idx="351" formatCode="0.00E+00">
                  <c:v>7.0705699999999998E-4</c:v>
                </c:pt>
                <c:pt idx="352" formatCode="0.00E+00">
                  <c:v>-2.1528999999999997E-3</c:v>
                </c:pt>
                <c:pt idx="353" formatCode="0.00E+00">
                  <c:v>-8.4473000000000003E-4</c:v>
                </c:pt>
                <c:pt idx="354" formatCode="0.00E+00">
                  <c:v>4.56136E-4</c:v>
                </c:pt>
                <c:pt idx="355" formatCode="0.00E+00">
                  <c:v>2.0333699999999999E-4</c:v>
                </c:pt>
                <c:pt idx="356" formatCode="0.00E+00">
                  <c:v>-2.1886099999999997E-3</c:v>
                </c:pt>
                <c:pt idx="357" formatCode="0.00E+00">
                  <c:v>-2.9706400000000001E-3</c:v>
                </c:pt>
                <c:pt idx="358" formatCode="0.00E+00">
                  <c:v>-2.46152E-3</c:v>
                </c:pt>
                <c:pt idx="359" formatCode="0.00E+00">
                  <c:v>-3.0701999999999999E-3</c:v>
                </c:pt>
                <c:pt idx="360" formatCode="0.00E+00">
                  <c:v>-2.7310099999999999E-3</c:v>
                </c:pt>
                <c:pt idx="361" formatCode="0.00E+00">
                  <c:v>-1.24043E-3</c:v>
                </c:pt>
                <c:pt idx="362" formatCode="0.00E+00">
                  <c:v>2.2415E-4</c:v>
                </c:pt>
                <c:pt idx="363" formatCode="0.00E+00">
                  <c:v>-1.13345E-3</c:v>
                </c:pt>
                <c:pt idx="364" formatCode="0.00E+00">
                  <c:v>-1.6044800000000002E-4</c:v>
                </c:pt>
                <c:pt idx="365" formatCode="0.00E+00">
                  <c:v>2.9042999999999999E-3</c:v>
                </c:pt>
                <c:pt idx="366" formatCode="0.00E+00">
                  <c:v>2.9836399999999996E-3</c:v>
                </c:pt>
                <c:pt idx="367" formatCode="0.00E+00">
                  <c:v>-1.5488099999999999E-3</c:v>
                </c:pt>
                <c:pt idx="368" formatCode="0.00E+00">
                  <c:v>1.2660799999999999E-3</c:v>
                </c:pt>
                <c:pt idx="369" formatCode="0.00E+00">
                  <c:v>9.7392399999999993E-4</c:v>
                </c:pt>
                <c:pt idx="370" formatCode="0.00E+00">
                  <c:v>-2.39225E-4</c:v>
                </c:pt>
                <c:pt idx="371" formatCode="0.00E+00">
                  <c:v>-2.9772899999999996E-3</c:v>
                </c:pt>
                <c:pt idx="372" formatCode="0.00E+00">
                  <c:v>3.2153299999999999E-4</c:v>
                </c:pt>
                <c:pt idx="373" formatCode="0.00E+00">
                  <c:v>3.0545199999999998E-3</c:v>
                </c:pt>
                <c:pt idx="374" formatCode="0.00E+00">
                  <c:v>-5.6918099999999998E-4</c:v>
                </c:pt>
                <c:pt idx="375" formatCode="0.00E+00">
                  <c:v>1.9209299999999999E-3</c:v>
                </c:pt>
                <c:pt idx="376" formatCode="0.00E+00">
                  <c:v>1.3656200000000001E-3</c:v>
                </c:pt>
                <c:pt idx="377" formatCode="0.00E+00">
                  <c:v>-9.6326399999999992E-4</c:v>
                </c:pt>
                <c:pt idx="378" formatCode="0.00E+00">
                  <c:v>-1.4241199999999999E-3</c:v>
                </c:pt>
                <c:pt idx="379" formatCode="0.00E+00">
                  <c:v>-6.6326900000000008E-4</c:v>
                </c:pt>
                <c:pt idx="380" formatCode="0.00E+00">
                  <c:v>-1.7407500000000001E-3</c:v>
                </c:pt>
                <c:pt idx="381" formatCode="0.00E+00">
                  <c:v>-2.6965299999999999E-3</c:v>
                </c:pt>
                <c:pt idx="382" formatCode="0.00E+00">
                  <c:v>2.3380599999999999E-3</c:v>
                </c:pt>
                <c:pt idx="383" formatCode="0.00E+00">
                  <c:v>3.2103800000000005E-4</c:v>
                </c:pt>
                <c:pt idx="384" formatCode="0.00E+00">
                  <c:v>-2.5807500000000003E-4</c:v>
                </c:pt>
                <c:pt idx="385" formatCode="0.00E+00">
                  <c:v>1.6343500000000001E-3</c:v>
                </c:pt>
                <c:pt idx="386" formatCode="0.00E+00">
                  <c:v>5.8683599999999998E-4</c:v>
                </c:pt>
                <c:pt idx="387" formatCode="0.00E+00">
                  <c:v>4.3275699999999998E-4</c:v>
                </c:pt>
                <c:pt idx="388" formatCode="0.00E+00">
                  <c:v>-9.28385E-4</c:v>
                </c:pt>
                <c:pt idx="389" formatCode="0.00E+00">
                  <c:v>1.3924E-3</c:v>
                </c:pt>
                <c:pt idx="390" formatCode="0.00E+00">
                  <c:v>-1.8507999999999999E-3</c:v>
                </c:pt>
                <c:pt idx="391" formatCode="0.00E+00">
                  <c:v>1.9058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329792"/>
        <c:axId val="154648960"/>
      </c:scatterChart>
      <c:valAx>
        <c:axId val="65329792"/>
        <c:scaling>
          <c:orientation val="minMax"/>
          <c:max val="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emperature (°C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4648960"/>
        <c:crosses val="autoZero"/>
        <c:crossBetween val="midCat"/>
      </c:valAx>
      <c:valAx>
        <c:axId val="15464896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p (kcal/mol/°C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5329792"/>
        <c:crosses val="autoZero"/>
        <c:crossBetween val="midCat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138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710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600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98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781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306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693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53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532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211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16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09394-E7DB-43A4-B379-984B7E687ADD}" type="datetimeFigureOut">
              <a:rPr lang="en-US" smtClean="0"/>
              <a:t>10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C1DDB-87E2-478E-A79B-57013D5A4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62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381000"/>
            <a:ext cx="853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smtClean="0"/>
              <a:t>Supplementary Figure 1: Differential scanning calorimetry scans of microfluidized or sonicated GLA-AF.</a:t>
            </a:r>
            <a:endParaRPr lang="en-US" sz="1400" dirty="0"/>
          </a:p>
        </p:txBody>
      </p:sp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1266825" y="1014413"/>
          <a:ext cx="6610349" cy="48291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83122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2</TotalTime>
  <Words>24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Fox</dc:creator>
  <cp:lastModifiedBy>Chris Fox</cp:lastModifiedBy>
  <cp:revision>8</cp:revision>
  <dcterms:created xsi:type="dcterms:W3CDTF">2013-07-30T22:49:58Z</dcterms:created>
  <dcterms:modified xsi:type="dcterms:W3CDTF">2013-10-04T18:53:45Z</dcterms:modified>
</cp:coreProperties>
</file>